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Ex1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42"/>
    <p:restoredTop sz="94693"/>
  </p:normalViewPr>
  <p:slideViewPr>
    <p:cSldViewPr snapToGrid="0">
      <p:cViewPr varScale="1">
        <p:scale>
          <a:sx n="115" d="100"/>
          <a:sy n="115" d="100"/>
        </p:scale>
        <p:origin x="72" y="29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18--\&#40644;&#33449;-&#21322;&#26525;&#33714;\hq_hic.fasta.pas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D:\2018--\&#40644;&#33449;-&#21322;&#26525;&#33714;\hq_hic.fasta.pas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K$1</c:f>
              <c:strCache>
                <c:ptCount val="1"/>
                <c:pt idx="0">
                  <c:v>S. baicalensi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3!$J$2:$J$25</c:f>
              <c:numCache>
                <c:formatCode>General</c:formatCode>
                <c:ptCount val="24"/>
                <c:pt idx="0">
                  <c:v>240000</c:v>
                </c:pt>
                <c:pt idx="1">
                  <c:v>480000</c:v>
                </c:pt>
                <c:pt idx="2">
                  <c:v>720000</c:v>
                </c:pt>
                <c:pt idx="3">
                  <c:v>960000</c:v>
                </c:pt>
                <c:pt idx="4">
                  <c:v>1200000</c:v>
                </c:pt>
                <c:pt idx="5">
                  <c:v>1440000</c:v>
                </c:pt>
                <c:pt idx="6">
                  <c:v>1680000</c:v>
                </c:pt>
                <c:pt idx="7">
                  <c:v>1920000</c:v>
                </c:pt>
                <c:pt idx="8">
                  <c:v>2160000</c:v>
                </c:pt>
                <c:pt idx="9">
                  <c:v>2400000</c:v>
                </c:pt>
                <c:pt idx="10">
                  <c:v>2640000</c:v>
                </c:pt>
                <c:pt idx="11">
                  <c:v>2880000</c:v>
                </c:pt>
                <c:pt idx="12">
                  <c:v>3120000</c:v>
                </c:pt>
                <c:pt idx="13">
                  <c:v>3360000</c:v>
                </c:pt>
                <c:pt idx="14">
                  <c:v>3600000</c:v>
                </c:pt>
                <c:pt idx="15">
                  <c:v>3840000</c:v>
                </c:pt>
                <c:pt idx="16">
                  <c:v>4080000</c:v>
                </c:pt>
                <c:pt idx="17">
                  <c:v>4320000</c:v>
                </c:pt>
                <c:pt idx="18">
                  <c:v>4560000</c:v>
                </c:pt>
                <c:pt idx="19">
                  <c:v>4800000</c:v>
                </c:pt>
                <c:pt idx="20">
                  <c:v>5040000</c:v>
                </c:pt>
                <c:pt idx="21">
                  <c:v>5280000</c:v>
                </c:pt>
                <c:pt idx="22">
                  <c:v>5520000</c:v>
                </c:pt>
                <c:pt idx="23">
                  <c:v>6960000</c:v>
                </c:pt>
              </c:numCache>
            </c:numRef>
          </c:cat>
          <c:val>
            <c:numRef>
              <c:f>Sheet3!$K$2:$K$25</c:f>
              <c:numCache>
                <c:formatCode>General</c:formatCode>
                <c:ptCount val="24"/>
                <c:pt idx="0">
                  <c:v>96</c:v>
                </c:pt>
                <c:pt idx="1">
                  <c:v>98</c:v>
                </c:pt>
                <c:pt idx="2">
                  <c:v>130</c:v>
                </c:pt>
                <c:pt idx="3">
                  <c:v>122</c:v>
                </c:pt>
                <c:pt idx="4">
                  <c:v>128</c:v>
                </c:pt>
                <c:pt idx="5">
                  <c:v>125</c:v>
                </c:pt>
                <c:pt idx="6">
                  <c:v>118</c:v>
                </c:pt>
                <c:pt idx="7">
                  <c:v>91</c:v>
                </c:pt>
                <c:pt idx="8">
                  <c:v>75</c:v>
                </c:pt>
                <c:pt idx="9">
                  <c:v>54</c:v>
                </c:pt>
                <c:pt idx="10">
                  <c:v>50</c:v>
                </c:pt>
                <c:pt idx="11">
                  <c:v>42</c:v>
                </c:pt>
                <c:pt idx="12">
                  <c:v>27</c:v>
                </c:pt>
                <c:pt idx="13">
                  <c:v>23</c:v>
                </c:pt>
                <c:pt idx="14">
                  <c:v>13</c:v>
                </c:pt>
                <c:pt idx="15">
                  <c:v>10</c:v>
                </c:pt>
                <c:pt idx="16">
                  <c:v>8</c:v>
                </c:pt>
                <c:pt idx="17">
                  <c:v>9</c:v>
                </c:pt>
                <c:pt idx="18">
                  <c:v>2</c:v>
                </c:pt>
                <c:pt idx="19">
                  <c:v>1</c:v>
                </c:pt>
                <c:pt idx="20">
                  <c:v>1</c:v>
                </c:pt>
                <c:pt idx="21">
                  <c:v>0</c:v>
                </c:pt>
                <c:pt idx="22">
                  <c:v>1</c:v>
                </c:pt>
                <c:pt idx="2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46-49B5-AC99-E08B09CAB923}"/>
            </c:ext>
          </c:extLst>
        </c:ser>
        <c:ser>
          <c:idx val="1"/>
          <c:order val="1"/>
          <c:tx>
            <c:strRef>
              <c:f>Sheet3!$L$1</c:f>
              <c:strCache>
                <c:ptCount val="1"/>
                <c:pt idx="0">
                  <c:v>S. barbat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3!$J$2:$J$25</c:f>
              <c:numCache>
                <c:formatCode>General</c:formatCode>
                <c:ptCount val="24"/>
                <c:pt idx="0">
                  <c:v>240000</c:v>
                </c:pt>
                <c:pt idx="1">
                  <c:v>480000</c:v>
                </c:pt>
                <c:pt idx="2">
                  <c:v>720000</c:v>
                </c:pt>
                <c:pt idx="3">
                  <c:v>960000</c:v>
                </c:pt>
                <c:pt idx="4">
                  <c:v>1200000</c:v>
                </c:pt>
                <c:pt idx="5">
                  <c:v>1440000</c:v>
                </c:pt>
                <c:pt idx="6">
                  <c:v>1680000</c:v>
                </c:pt>
                <c:pt idx="7">
                  <c:v>1920000</c:v>
                </c:pt>
                <c:pt idx="8">
                  <c:v>2160000</c:v>
                </c:pt>
                <c:pt idx="9">
                  <c:v>2400000</c:v>
                </c:pt>
                <c:pt idx="10">
                  <c:v>2640000</c:v>
                </c:pt>
                <c:pt idx="11">
                  <c:v>2880000</c:v>
                </c:pt>
                <c:pt idx="12">
                  <c:v>3120000</c:v>
                </c:pt>
                <c:pt idx="13">
                  <c:v>3360000</c:v>
                </c:pt>
                <c:pt idx="14">
                  <c:v>3600000</c:v>
                </c:pt>
                <c:pt idx="15">
                  <c:v>3840000</c:v>
                </c:pt>
                <c:pt idx="16">
                  <c:v>4080000</c:v>
                </c:pt>
                <c:pt idx="17">
                  <c:v>4320000</c:v>
                </c:pt>
                <c:pt idx="18">
                  <c:v>4560000</c:v>
                </c:pt>
                <c:pt idx="19">
                  <c:v>4800000</c:v>
                </c:pt>
                <c:pt idx="20">
                  <c:v>5040000</c:v>
                </c:pt>
                <c:pt idx="21">
                  <c:v>5280000</c:v>
                </c:pt>
                <c:pt idx="22">
                  <c:v>5520000</c:v>
                </c:pt>
                <c:pt idx="23">
                  <c:v>6960000</c:v>
                </c:pt>
              </c:numCache>
            </c:numRef>
          </c:cat>
          <c:val>
            <c:numRef>
              <c:f>Sheet3!$L$2:$L$25</c:f>
              <c:numCache>
                <c:formatCode>General</c:formatCode>
                <c:ptCount val="24"/>
                <c:pt idx="0">
                  <c:v>230</c:v>
                </c:pt>
                <c:pt idx="1">
                  <c:v>312</c:v>
                </c:pt>
                <c:pt idx="2">
                  <c:v>319</c:v>
                </c:pt>
                <c:pt idx="3">
                  <c:v>225</c:v>
                </c:pt>
                <c:pt idx="4">
                  <c:v>160</c:v>
                </c:pt>
                <c:pt idx="5">
                  <c:v>108</c:v>
                </c:pt>
                <c:pt idx="6">
                  <c:v>96</c:v>
                </c:pt>
                <c:pt idx="7">
                  <c:v>58</c:v>
                </c:pt>
                <c:pt idx="8">
                  <c:v>46</c:v>
                </c:pt>
                <c:pt idx="9">
                  <c:v>24</c:v>
                </c:pt>
                <c:pt idx="10">
                  <c:v>20</c:v>
                </c:pt>
                <c:pt idx="11">
                  <c:v>20</c:v>
                </c:pt>
                <c:pt idx="12">
                  <c:v>10</c:v>
                </c:pt>
                <c:pt idx="13">
                  <c:v>11</c:v>
                </c:pt>
                <c:pt idx="14">
                  <c:v>8</c:v>
                </c:pt>
                <c:pt idx="15">
                  <c:v>2</c:v>
                </c:pt>
                <c:pt idx="16">
                  <c:v>4</c:v>
                </c:pt>
                <c:pt idx="17">
                  <c:v>0</c:v>
                </c:pt>
                <c:pt idx="18">
                  <c:v>1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E46-49B5-AC99-E08B09CAB9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3909768"/>
        <c:axId val="783912392"/>
      </c:barChart>
      <c:catAx>
        <c:axId val="783909768"/>
        <c:scaling>
          <c:orientation val="minMax"/>
        </c:scaling>
        <c:delete val="1"/>
        <c:axPos val="b"/>
        <c:numFmt formatCode="#,##0_);\(#,##0\)" sourceLinked="0"/>
        <c:majorTickMark val="out"/>
        <c:minorTickMark val="none"/>
        <c:tickLblPos val="nextTo"/>
        <c:crossAx val="783912392"/>
        <c:crosses val="autoZero"/>
        <c:auto val="1"/>
        <c:lblAlgn val="ctr"/>
        <c:lblOffset val="200"/>
        <c:tickMarkSkip val="1"/>
        <c:noMultiLvlLbl val="0"/>
      </c:catAx>
      <c:valAx>
        <c:axId val="783912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39097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508045966996508"/>
          <c:y val="6.0234643345103672E-2"/>
          <c:w val="0.28410340335863676"/>
          <c:h val="9.22005242703295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1000" b="0" i="1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altLang="zh-CN" sz="1000" b="0" i="0" u="none" strike="noStrike" kern="1200" baseline="0">
          <a:solidFill>
            <a:schemeClr val="tx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hq_hic.fasta.pass!$P$1:$P$1686</cx:f>
        <cx:lvl ptCount="1686" formatCode="G/通用格式">
          <cx:pt idx="0">3238651</cx:pt>
          <cx:pt idx="1">1330204</cx:pt>
          <cx:pt idx="2">1110728</cx:pt>
          <cx:pt idx="3">262731</cx:pt>
          <cx:pt idx="4">880217</cx:pt>
          <cx:pt idx="5">1603361</cx:pt>
          <cx:pt idx="6">974349</cx:pt>
          <cx:pt idx="7">3306290</cx:pt>
          <cx:pt idx="8">1934601</cx:pt>
          <cx:pt idx="9">1273470</cx:pt>
          <cx:pt idx="10">659403</cx:pt>
          <cx:pt idx="11">508298</cx:pt>
          <cx:pt idx="12">2521274</cx:pt>
          <cx:pt idx="13">585125</cx:pt>
          <cx:pt idx="14">1427839</cx:pt>
          <cx:pt idx="15">1237716</cx:pt>
          <cx:pt idx="16">443000</cx:pt>
          <cx:pt idx="17">1567196</cx:pt>
          <cx:pt idx="18">866738</cx:pt>
          <cx:pt idx="19">407870</cx:pt>
          <cx:pt idx="20">892909</cx:pt>
          <cx:pt idx="21">0</cx:pt>
          <cx:pt idx="22">1836468</cx:pt>
          <cx:pt idx="23">887752</cx:pt>
          <cx:pt idx="24">1722741</cx:pt>
          <cx:pt idx="25">1798373</cx:pt>
          <cx:pt idx="26">1311280</cx:pt>
          <cx:pt idx="27">981908</cx:pt>
          <cx:pt idx="28">2701487</cx:pt>
          <cx:pt idx="29">2745871</cx:pt>
          <cx:pt idx="30">1529860</cx:pt>
          <cx:pt idx="31">2249306</cx:pt>
          <cx:pt idx="32">1544870</cx:pt>
          <cx:pt idx="33">1707231</cx:pt>
          <cx:pt idx="34">1335844</cx:pt>
          <cx:pt idx="35">142660</cx:pt>
          <cx:pt idx="36">3153145</cx:pt>
          <cx:pt idx="37">2045039</cx:pt>
          <cx:pt idx="38">2947937</cx:pt>
          <cx:pt idx="39">2303412</cx:pt>
          <cx:pt idx="40">1535539</cx:pt>
          <cx:pt idx="41">701539</cx:pt>
          <cx:pt idx="42">2118624</cx:pt>
          <cx:pt idx="43">2215646</cx:pt>
          <cx:pt idx="44">313233</cx:pt>
          <cx:pt idx="45">695234</cx:pt>
          <cx:pt idx="46">1447244</cx:pt>
          <cx:pt idx="47">1030497</cx:pt>
          <cx:pt idx="48">2183269</cx:pt>
          <cx:pt idx="49">698386</cx:pt>
          <cx:pt idx="50">0</cx:pt>
          <cx:pt idx="51">0</cx:pt>
          <cx:pt idx="52">528269</cx:pt>
          <cx:pt idx="53">380966</cx:pt>
          <cx:pt idx="54">1540813</cx:pt>
          <cx:pt idx="55">1650565</cx:pt>
          <cx:pt idx="56">1823355</cx:pt>
          <cx:pt idx="57">2181195</cx:pt>
          <cx:pt idx="58">789158</cx:pt>
          <cx:pt idx="59">1427839</cx:pt>
          <cx:pt idx="60">1551363</cx:pt>
          <cx:pt idx="61">2594824</cx:pt>
          <cx:pt idx="62">1036078</cx:pt>
          <cx:pt idx="63">1197997</cx:pt>
          <cx:pt idx="64">973155</cx:pt>
          <cx:pt idx="65">1215242</cx:pt>
          <cx:pt idx="66">1902538</cx:pt>
          <cx:pt idx="67">2229355</cx:pt>
          <cx:pt idx="68">1314098</cx:pt>
          <cx:pt idx="69">2548991</cx:pt>
          <cx:pt idx="70">1463829</cx:pt>
          <cx:pt idx="71">1277088</cx:pt>
          <cx:pt idx="72">1056418</cx:pt>
          <cx:pt idx="73">2447494</cx:pt>
          <cx:pt idx="74">721250</cx:pt>
          <cx:pt idx="75">2215646</cx:pt>
          <cx:pt idx="76">285640</cx:pt>
          <cx:pt idx="77">339295</cx:pt>
          <cx:pt idx="78">1499459</cx:pt>
          <cx:pt idx="79">2837814</cx:pt>
          <cx:pt idx="80">1271460</cx:pt>
          <cx:pt idx="81">2725573</cx:pt>
          <cx:pt idx="82">1902538</cx:pt>
          <cx:pt idx="83">437923</cx:pt>
          <cx:pt idx="84">3544934</cx:pt>
          <cx:pt idx="85">4543162</cx:pt>
          <cx:pt idx="86">4278746</cx:pt>
          <cx:pt idx="87">2190322</cx:pt>
          <cx:pt idx="88">840987</cx:pt>
          <cx:pt idx="89">1192385</cx:pt>
          <cx:pt idx="90">2769147</cx:pt>
          <cx:pt idx="91">1067192</cx:pt>
          <cx:pt idx="92">2557815</cx:pt>
          <cx:pt idx="93">2701910</cx:pt>
          <cx:pt idx="94">2559917</cx:pt>
          <cx:pt idx="95">285252</cx:pt>
          <cx:pt idx="96">204957</cx:pt>
          <cx:pt idx="97">2129388</cx:pt>
          <cx:pt idx="98">526311</cx:pt>
          <cx:pt idx="99">1939948</cx:pt>
          <cx:pt idx="100">709027</cx:pt>
          <cx:pt idx="101">658222</cx:pt>
          <cx:pt idx="102">830297</cx:pt>
          <cx:pt idx="103">1202007</cx:pt>
          <cx:pt idx="104">4272948</cx:pt>
          <cx:pt idx="105">1376560</cx:pt>
          <cx:pt idx="106">6921654</cx:pt>
          <cx:pt idx="107">476999</cx:pt>
          <cx:pt idx="108">1620850</cx:pt>
          <cx:pt idx="109">2764913</cx:pt>
          <cx:pt idx="110">1047243</cx:pt>
          <cx:pt idx="111">2737834</cx:pt>
          <cx:pt idx="112">966393</cx:pt>
          <cx:pt idx="113">491080</cx:pt>
          <cx:pt idx="114">484821</cx:pt>
          <cx:pt idx="115">2401894</cx:pt>
          <cx:pt idx="116">2134772</cx:pt>
          <cx:pt idx="117">984694</cx:pt>
          <cx:pt idx="118">1334232</cx:pt>
          <cx:pt idx="119">1568009</cx:pt>
          <cx:pt idx="120">1295587</cx:pt>
          <cx:pt idx="121">2439540</cx:pt>
          <cx:pt idx="122">1623291</cx:pt>
          <cx:pt idx="123">1153929</cx:pt>
          <cx:pt idx="124">2758564</cx:pt>
          <cx:pt idx="125">396560</cx:pt>
          <cx:pt idx="126">363823</cx:pt>
          <cx:pt idx="127">574137</cx:pt>
          <cx:pt idx="128">1292771</cx:pt>
          <cx:pt idx="129">2476816</cx:pt>
          <cx:pt idx="130">2083048</cx:pt>
          <cx:pt idx="131">1299610</cx:pt>
          <cx:pt idx="132">264672</cx:pt>
          <cx:pt idx="133">1037673</cx:pt>
          <cx:pt idx="134">216968</cx:pt>
          <cx:pt idx="135">793112</cx:pt>
          <cx:pt idx="136">1727233</cx:pt>
          <cx:pt idx="137">1095942</cx:pt>
          <cx:pt idx="138">4239961</cx:pt>
          <cx:pt idx="139">713364</cx:pt>
          <cx:pt idx="140">1895554</cx:pt>
          <cx:pt idx="141">202633</cx:pt>
          <cx:pt idx="142">3328728</cx:pt>
          <cx:pt idx="143">1399967</cx:pt>
          <cx:pt idx="144">1884466</cx:pt>
          <cx:pt idx="145">1151928</cx:pt>
          <cx:pt idx="146">142660</cx:pt>
          <cx:pt idx="147">1159134</cx:pt>
          <cx:pt idx="148">1730500</cx:pt>
          <cx:pt idx="149">1054423</cx:pt>
          <cx:pt idx="150">2162119</cx:pt>
          <cx:pt idx="151">2155487</cx:pt>
          <cx:pt idx="152">1613528</cx:pt>
          <cx:pt idx="153">2958589</cx:pt>
          <cx:pt idx="154">3295940</cx:pt>
          <cx:pt idx="155">2070235</cx:pt>
          <cx:pt idx="156">495383</cx:pt>
          <cx:pt idx="157">1166742</cx:pt>
          <cx:pt idx="158">1129921</cx:pt>
          <cx:pt idx="159">842571</cx:pt>
          <cx:pt idx="160">682629</cx:pt>
          <cx:pt idx="161">2382672</cx:pt>
          <cx:pt idx="162">394610</cx:pt>
          <cx:pt idx="163">1326177</cx:pt>
          <cx:pt idx="164">2812786</cx:pt>
          <cx:pt idx="165">879821</cx:pt>
          <cx:pt idx="166">1033287</cx:pt>
          <cx:pt idx="167">812490</cx:pt>
          <cx:pt idx="168">1572476</cx:pt>
          <cx:pt idx="169">613792</cx:pt>
          <cx:pt idx="170">157351</cx:pt>
          <cx:pt idx="171">1076772</cx:pt>
          <cx:pt idx="172">1976583</cx:pt>
          <cx:pt idx="173">0</cx:pt>
          <cx:pt idx="174">1559482</cx:pt>
          <cx:pt idx="175">1573695</cx:pt>
          <cx:pt idx="176">575315</cx:pt>
          <cx:pt idx="177">1224471</cx:pt>
          <cx:pt idx="178">1442796</cx:pt>
          <cx:pt idx="179">329957</cx:pt>
          <cx:pt idx="180">3029845</cx:pt>
          <cx:pt idx="181">635015</cx:pt>
          <cx:pt idx="182">799042</cx:pt>
          <cx:pt idx="183">528269</cx:pt>
          <cx:pt idx="184">168568</cx:pt>
          <cx:pt idx="185">317121</cx:pt>
          <cx:pt idx="186">1587508</cx:pt>
          <cx:pt idx="187">543943</cx:pt>
          <cx:pt idx="188">1949823</cx:pt>
          <cx:pt idx="189">1576538</cx:pt>
          <cx:pt idx="190">1291967</cx:pt>
          <cx:pt idx="191">1736626</cx:pt>
          <cx:pt idx="192">945719</cx:pt>
          <cx:pt idx="193">155418</cx:pt>
          <cx:pt idx="194">1974936</cx:pt>
          <cx:pt idx="195">1159134</cx:pt>
          <cx:pt idx="196">491080</cx:pt>
          <cx:pt idx="197">1729275</cx:pt>
          <cx:pt idx="198">5070663</cx:pt>
          <cx:pt idx="199">3995079</cx:pt>
          <cx:pt idx="200">1911988</cx:pt>
          <cx:pt idx="201">1987707</cx:pt>
          <cx:pt idx="202">2765337</cx:pt>
          <cx:pt idx="203">2478492</cx:pt>
          <cx:pt idx="204">1837288</cx:pt>
          <cx:pt idx="205">3761898</cx:pt>
          <cx:pt idx="206">781254</cx:pt>
          <cx:pt idx="207">486776</cx:pt>
          <cx:pt idx="208">1364460</cx:pt>
          <cx:pt idx="209">1166342</cx:pt>
          <cx:pt idx="210">769796</cx:pt>
          <cx:pt idx="211">812490</cx:pt>
          <cx:pt idx="212">3578442</cx:pt>
          <cx:pt idx="213">1099938</cx:pt>
          <cx:pt idx="214">1405620</cx:pt>
          <cx:pt idx="215">2216892</cx:pt>
          <cx:pt idx="216">1494598</cx:pt>
          <cx:pt idx="217">1583038</cx:pt>
          <cx:pt idx="218">1543653</cx:pt>
          <cx:pt idx="219">1733359</cx:pt>
          <cx:pt idx="220">869909</cx:pt>
          <cx:pt idx="221">1548117</cx:pt>
          <cx:pt idx="222">2056189</cx:pt>
          <cx:pt idx="223">1189579</cx:pt>
          <cx:pt idx="224">1620036</cx:pt>
          <cx:pt idx="225">545118</cx:pt>
          <cx:pt idx="226">865945</cx:pt>
          <cx:pt idx="227">1549334</cx:pt>
          <cx:pt idx="228">2106622</cx:pt>
          <cx:pt idx="229">1564760</cx:pt>
          <cx:pt idx="230">2276763</cx:pt>
          <cx:pt idx="231">1544464</cx:pt>
          <cx:pt idx="232">0</cx:pt>
          <cx:pt idx="233">1512426</cx:pt>
          <cx:pt idx="234">430504</cx:pt>
          <cx:pt idx="235">1475971</cx:pt>
          <cx:pt idx="236">3309309</cx:pt>
          <cx:pt idx="237">1744388</cx:pt>
          <cx:pt idx="238">994645</cx:pt>
          <cx:pt idx="239">645633</cx:pt>
          <cx:pt idx="240">2754333</cx:pt>
          <cx:pt idx="241">2049994</cx:pt>
          <cx:pt idx="242">843363</cx:pt>
          <cx:pt idx="243">143819</cx:pt>
          <cx:pt idx="244">1518507</cx:pt>
          <cx:pt idx="245">501644</cx:pt>
          <cx:pt idx="246">2456287</cx:pt>
          <cx:pt idx="247">1381401</cx:pt>
          <cx:pt idx="248">919501</cx:pt>
          <cx:pt idx="249">500470</cx:pt>
          <cx:pt idx="250">0</cx:pt>
          <cx:pt idx="251">1838108</cx:pt>
          <cx:pt idx="252">1738260</cx:pt>
          <cx:pt idx="253">1952703</cx:pt>
          <cx:pt idx="254">1377367</cx:pt>
          <cx:pt idx="255">1356396</cx:pt>
          <cx:pt idx="256">1283521</cx:pt>
          <cx:pt idx="257">143819</cx:pt>
          <cx:pt idx="258">1587508</cx:pt>
          <cx:pt idx="259">1331413</cx:pt>
          <cx:pt idx="260">1441583</cx:pt>
          <cx:pt idx="261">1370106</cx:pt>
          <cx:pt idx="262">1591979</cx:pt>
          <cx:pt idx="263">877441</cx:pt>
          <cx:pt idx="264">2160461</cx:pt>
          <cx:pt idx="265">3165161</cx:pt>
          <cx:pt idx="266">1482448</cx:pt>
          <cx:pt idx="267">2983744</cx:pt>
          <cx:pt idx="268">2583043</cx:pt>
          <cx:pt idx="269">2541009</cx:pt>
          <cx:pt idx="270">4388252</cx:pt>
          <cx:pt idx="271">2672780</cx:pt>
          <cx:pt idx="272">1163939</cx:pt>
          <cx:pt idx="273">1689281</cx:pt>
          <cx:pt idx="274">1107930</cx:pt>
          <cx:pt idx="275">930621</cx:pt>
          <cx:pt idx="276">1895554</cx:pt>
          <cx:pt idx="277">3130415</cx:pt>
          <cx:pt idx="278">839403</cx:pt>
          <cx:pt idx="279">1409255</cx:pt>
          <cx:pt idx="280">1761963</cx:pt>
          <cx:pt idx="281">1071583</cx:pt>
          <cx:pt idx="282">1323358</cx:pt>
          <cx:pt idx="283">1036477</cx:pt>
          <cx:pt idx="284">1401178</cx:pt>
          <cx:pt idx="285">3070459</cx:pt>
          <cx:pt idx="286">2077674</cx:pt>
          <cx:pt idx="287">2140156</cx:pt>
          <cx:pt idx="288">395000</cx:pt>
          <cx:pt idx="289">1961347</cx:pt>
          <cx:pt idx="290">1617596</cx:pt>
          <cx:pt idx="291">2421966</cx:pt>
          <cx:pt idx="292">870702</cx:pt>
          <cx:pt idx="293">1831140</cx:pt>
          <cx:pt idx="294">1171549</cx:pt>
          <cx:pt idx="295">1668898</cx:pt>
          <cx:pt idx="296">953669</cx:pt>
          <cx:pt idx="297">1222464</cx:pt>
          <cx:pt idx="298">1666860</cx:pt>
          <cx:pt idx="299">1512426</cx:pt>
          <cx:pt idx="300">1073578</cx:pt>
          <cx:pt idx="301">1923087</cx:pt>
          <cx:pt idx="302">1979879</cx:pt>
          <cx:pt idx="303">711787</cx:pt>
          <cx:pt idx="304">1074377</cx:pt>
          <cx:pt idx="305">2360541</cx:pt>
          <cx:pt idx="306">1347528</cx:pt>
          <cx:pt idx="307">1566384</cx:pt>
          <cx:pt idx="308">167795</cx:pt>
          <cx:pt idx="309">2685441</cx:pt>
          <cx:pt idx="310">2146370</cx:pt>
          <cx:pt idx="311">661764</cx:pt>
          <cx:pt idx="312">1574507</cx:pt>
          <cx:pt idx="313">1729683</cx:pt>
          <cx:pt idx="314">1436327</cx:pt>
          <cx:pt idx="315">1189579</cx:pt>
          <cx:pt idx="316">1333427</cx:pt>
          <cx:pt idx="317">2381419</cx:pt>
          <cx:pt idx="318">2786510</cx:pt>
          <cx:pt idx="319">3102563</cx:pt>
          <cx:pt idx="320">349805</cx:pt>
          <cx:pt idx="321">940156</cx:pt>
          <cx:pt idx="322">3874293</cx:pt>
          <cx:pt idx="323">1754196</cx:pt>
          <cx:pt idx="324">3994637</cx:pt>
          <cx:pt idx="325">1976171</cx:pt>
          <cx:pt idx="326">759133</cx:pt>
          <cx:pt idx="327">1730091</cx:pt>
          <cx:pt idx="328">1301622</cx:pt>
          <cx:pt idx="329">435580</cx:pt>
          <cx:pt idx="330">1931722</cx:pt>
          <cx:pt idx="331">2081394</cx:pt>
          <cx:pt idx="332">1232498</cx:pt>
          <cx:pt idx="333">2486876</cx:pt>
          <cx:pt idx="334">319455</cx:pt>
          <cx:pt idx="335">2882408</cx:pt>
          <cx:pt idx="336">1944062</cx:pt>
          <cx:pt idx="337">3748317</cx:pt>
          <cx:pt idx="338">2290501</cx:pt>
          <cx:pt idx="339">327623</cx:pt>
          <cx:pt idx="340">1775867</cx:pt>
          <cx:pt idx="341">499296</cx:pt>
          <cx:pt idx="342">238289</cx:pt>
          <cx:pt idx="343">1995949</cx:pt>
          <cx:pt idx="344">1120323</cx:pt>
          <cx:pt idx="345">2434518</cx:pt>
          <cx:pt idx="346">143819</cx:pt>
          <cx:pt idx="347">327234</cx:pt>
          <cx:pt idx="348">1374543</cx:pt>
          <cx:pt idx="349">2853095</cx:pt>
          <cx:pt idx="350">161992</cx:pt>
          <cx:pt idx="351">3083296</cx:pt>
          <cx:pt idx="352">1768097</cx:pt>
          <cx:pt idx="353">1069587</cx:pt>
          <cx:pt idx="618">827131</cx:pt>
          <cx:pt idx="619">807347</cx:pt>
          <cx:pt idx="620">1103134</cx:pt>
          <cx:pt idx="621">823173</cx:pt>
          <cx:pt idx="622">572960</cx:pt>
          <cx:pt idx="623">1566790</cx:pt>
          <cx:pt idx="624">1137121</cx:pt>
          <cx:pt idx="625">2182439</cx:pt>
          <cx:pt idx="626">1825813</cx:pt>
          <cx:pt idx="627">317510</cx:pt>
          <cx:pt idx="628">950091</cx:pt>
          <cx:pt idx="629">3668714</cx:pt>
          <cx:pt idx="630">138022</cx:pt>
          <cx:pt idx="631">981510</cx:pt>
          <cx:pt idx="632">1746023</cx:pt>
          <cx:pt idx="633">1769323</cx:pt>
          <cx:pt idx="634">2381419</cx:pt>
          <cx:pt idx="635">447296</cx:pt>
          <cx:pt idx="636">627153</cx:pt>
          <cx:pt idx="637">1561918</cx:pt>
          <cx:pt idx="638">0</cx:pt>
          <cx:pt idx="639">3330886</cx:pt>
          <cx:pt idx="640">1936657</cx:pt>
          <cx:pt idx="641">1405620</cx:pt>
          <cx:pt idx="642">1293978</cx:pt>
          <cx:pt idx="643">768216</cx:pt>
          <cx:pt idx="644">1635500</cx:pt>
          <cx:pt idx="645">858812</cx:pt>
          <cx:pt idx="646">2078088</cx:pt>
          <cx:pt idx="647">1232899</cx:pt>
          <cx:pt idx="648">2329252</cx:pt>
          <cx:pt idx="649">3102135</cx:pt>
          <cx:pt idx="650">0</cx:pt>
          <cx:pt idx="651">1660749</cx:pt>
          <cx:pt idx="652">1958877</cx:pt>
          <cx:pt idx="653">1835239</cx:pt>
          <cx:pt idx="654">1263422</cx:pt>
          <cx:pt idx="655">2793712</cx:pt>
          <cx:pt idx="656">1529455</cx:pt>
          <cx:pt idx="657">2402730</cx:pt>
          <cx:pt idx="658">1370912</cx:pt>
          <cx:pt idx="659">3269220</cx:pt>
          <cx:pt idx="660">2207341</cx:pt>
          <cx:pt idx="661">1372929</cx:pt>
          <cx:pt idx="662">650353</cx:pt>
          <cx:pt idx="663">1716618</cx:pt>
          <cx:pt idx="664">1184770</cx:pt>
          <cx:pt idx="665">2301329</cx:pt>
          <cx:pt idx="666">772166</cx:pt>
          <cx:pt idx="667">1277892</cx:pt>
          <cx:pt idx="668">1429051</cx:pt>
          <cx:pt idx="669">3897177</cx:pt>
          <cx:pt idx="670">1478805</cx:pt>
          <cx:pt idx="671">2331754</cx:pt>
          <cx:pt idx="672">296130</cx:pt>
          <cx:pt idx="673">2468435</cx:pt>
          <cx:pt idx="674">567076</cx:pt>
          <cx:pt idx="675">858812</cx:pt>
          <cx:pt idx="676">552566</cx:pt>
          <cx:pt idx="677">2224784</cx:pt>
          <cx:pt idx="678">1086356</cx:pt>
          <cx:pt idx="679">594154</cx:pt>
          <cx:pt idx="680">1701110</cx:pt>
          <cx:pt idx="681">168568</cx:pt>
          <cx:pt idx="682">1049238</cx:pt>
          <cx:pt idx="683">851681</cx:pt>
          <cx:pt idx="684">1334232</cx:pt>
          <cx:pt idx="685">2426149</cx:pt>
          <cx:pt idx="686">1770141</cx:pt>
          <cx:pt idx="687">576492</cx:pt>
          <cx:pt idx="688">2261367</cx:pt>
          <cx:pt idx="689">2825085</cx:pt>
          <cx:pt idx="690">141114</cx:pt>
          <cx:pt idx="691">3366306</cx:pt>
          <cx:pt idx="692">1475566</cx:pt>
          <cx:pt idx="693">1667268</cx:pt>
          <cx:pt idx="694">4081792</cx:pt>
          <cx:pt idx="695">745315</cx:pt>
          <cx:pt idx="696">562762</cx:pt>
          <cx:pt idx="697">1329399</cx:pt>
          <cx:pt idx="698">2464664</cx:pt>
          <cx:pt idx="699">1455333</cx:pt>
          <cx:pt idx="700">712181</cx:pt>
          <cx:pt idx="701">1997598</cx:pt>
          <cx:pt idx="702">136090</cx:pt>
          <cx:pt idx="703">2022752</cx:pt>
          <cx:pt idx="704">1969582</cx:pt>
          <cx:pt idx="705">368498</cx:pt>
          <cx:pt idx="706">903225</cx:pt>
          <cx:pt idx="707">2270104</cx:pt>
          <cx:pt idx="708">1150327</cx:pt>
          <cx:pt idx="709">2355950</cx:pt>
          <cx:pt idx="710">1061206</cx:pt>
          <cx:pt idx="711">3140277</cx:pt>
          <cx:pt idx="712">1268245</cx:pt>
          <cx:pt idx="713">220456</cx:pt>
          <cx:pt idx="714">1635500</cx:pt>
          <cx:pt idx="715">1054423</cx:pt>
          <cx:pt idx="716">3422550</cx:pt>
          <cx:pt idx="717">1949000</cx:pt>
          <cx:pt idx="718">1538784</cx:pt>
          <cx:pt idx="719">403579</cx:pt>
          <cx:pt idx="720">1838108</cx:pt>
          <cx:pt idx="721">786787</cx:pt>
          <cx:pt idx="722">2450843</cx:pt>
          <cx:pt idx="723">597688</cx:pt>
          <cx:pt idx="724">1413294</cx:pt>
          <cx:pt idx="725">444953</cx:pt>
          <cx:pt idx="726">588658</cx:pt>
          <cx:pt idx="727">2438284</cx:pt>
          <cx:pt idx="728">1265030</cx:pt>
          <cx:pt idx="729">1007387</cx:pt>
          <cx:pt idx="730">3086721</cx:pt>
          <cx:pt idx="731">1025316</cx:pt>
          <cx:pt idx="732">845343</cx:pt>
          <cx:pt idx="733">2463827</cx:pt>
          <cx:pt idx="734">997830</cx:pt>
          <cx:pt idx="735">510256</cx:pt>
          <cx:pt idx="736">2167923</cx:pt>
          <cx:pt idx="737">2046277</cx:pt>
          <cx:pt idx="738">858416</cx:pt>
          <cx:pt idx="739">1303232</cx:pt>
          <cx:pt idx="740">502036</cx:pt>
          <cx:pt idx="741">1323761</cx:pt>
          <cx:pt idx="742">1193588</cx:pt>
          <cx:pt idx="743">559624</cx:pt>
          <cx:pt idx="744">1542841</cx:pt>
          <cx:pt idx="745">595725</cx:pt>
          <cx:pt idx="746">896876</cx:pt>
          <cx:pt idx="747">2453356</cx:pt>
          <cx:pt idx="748">1857791</cx:pt>
          <cx:pt idx="749">1159134</cx:pt>
          <cx:pt idx="750">3404367</cx:pt>
          <cx:pt idx="751">1585883</cx:pt>
          <cx:pt idx="752">1262619</cx:pt>
          <cx:pt idx="753">1321345</cx:pt>
          <cx:pt idx="754">1141923</cx:pt>
          <cx:pt idx="755">1809018</cx:pt>
          <cx:pt idx="756">2994409</cx:pt>
          <cx:pt idx="757">2813210</cx:pt>
          <cx:pt idx="758">1679495</cx:pt>
          <cx:pt idx="759">3356799</cx:pt>
          <cx:pt idx="760">2264279</cx:pt>
          <cx:pt idx="761">1941182</cx:pt>
          <cx:pt idx="762">2976493</cx:pt>
          <cx:pt idx="763">1382208</cx:pt>
          <cx:pt idx="764">1038470</cx:pt>
          <cx:pt idx="765">627546</cx:pt>
          <cx:pt idx="766">707845</cx:pt>
          <cx:pt idx="767">1627767</cx:pt>
          <cx:pt idx="768">505558</cx:pt>
          <cx:pt idx="769">775327</cx:pt>
          <cx:pt idx="770">528661</cx:pt>
          <cx:pt idx="771">1189579</cx:pt>
          <cx:pt idx="772">2121935</cx:pt>
          <cx:pt idx="773">1042857</cx:pt>
          <cx:pt idx="774">1189579</cx:pt>
          <cx:pt idx="775">1178359</cx:pt>
          <cx:pt idx="776">1068389</cx:pt>
          <cx:pt idx="777">122181</cx:pt>
          <cx:pt idx="778">679872</cx:pt>
          <cx:pt idx="779">1872972</cx:pt>
          <cx:pt idx="780">218130</cx:pt>
          <cx:pt idx="781">1692544</cx:pt>
          <cx:pt idx="782">1208423</cx:pt>
          <cx:pt idx="783">1467876</cx:pt>
          <cx:pt idx="784">335015</cx:pt>
          <cx:pt idx="785">692476</cx:pt>
          <cx:pt idx="786">1895965</cx:pt>
          <cx:pt idx="787">335404</cx:pt>
          <cx:pt idx="788">1618816</cx:pt>
          <cx:pt idx="789">1149526</cx:pt>
          <cx:pt idx="790">853662</cx:pt>
          <cx:pt idx="791">2010378</cx:pt>
          <cx:pt idx="792">1822126</cx:pt>
          <cx:pt idx="793">786787</cx:pt>
          <cx:pt idx="794">2865412</cx:pt>
          <cx:pt idx="795">1651787</cx:pt>
          <cx:pt idx="796">484821</cx:pt>
          <cx:pt idx="797">1299208</cx:pt>
          <cx:pt idx="798">394610</cx:pt>
          <cx:pt idx="799">2530090</cx:pt>
          <cx:pt idx="800">861190</cx:pt>
          <cx:pt idx="801">1095143</cx:pt>
          <cx:pt idx="802">735056</cx:pt>
          <cx:pt idx="803">3496700</cx:pt>
          <cx:pt idx="804">908782</cx:pt>
          <cx:pt idx="805">1589946</cx:pt>
          <cx:pt idx="806">1697439</cx:pt>
          <cx:pt idx="807">0</cx:pt>
          <cx:pt idx="808">1921031</cx:pt>
          <cx:pt idx="809">663338</cx:pt>
          <cx:pt idx="810">2340095</cx:pt>
          <cx:pt idx="811">1375753</cx:pt>
          <cx:pt idx="812">2855643</cx:pt>
          <cx:pt idx="813">270107</cx:pt>
          <cx:pt idx="814">2297997</cx:pt>
          <cx:pt idx="815">751631</cx:pt>
          <cx:pt idx="816">1508779</cx:pt>
          <cx:pt idx="817">832276</cx:pt>
          <cx:pt idx="818">2032243</cx:pt>
          <cx:pt idx="819">147299</cx:pt>
          <cx:pt idx="820">105578</cx:pt>
          <cx:pt idx="821">658616</cx:pt>
          <cx:pt idx="822">1619223</cx:pt>
          <cx:pt idx="823">916721</cx:pt>
          <cx:pt idx="824">2808547</cx:pt>
          <cx:pt idx="825">1177558</cx:pt>
          <cx:pt idx="826">148845</cx:pt>
          <cx:pt idx="827">2847576</cx:pt>
          <cx:pt idx="828">502036</cx:pt>
          <cx:pt idx="829">1304439</cx:pt>
          <cx:pt idx="830">1702334</cx:pt>
          <cx:pt idx="831">506341</cx:pt>
          <cx:pt idx="832">1847538</cx:pt>
          <cx:pt idx="833">2876033</cx:pt>
          <cx:pt idx="834">1518507</cx:pt>
          <cx:pt idx="835">999423</cx:pt>
          <cx:pt idx="836">1456142</cx:pt>
          <cx:pt idx="837">2037608</cx:pt>
          <cx:pt idx="838">0</cx:pt>
          <cx:pt idx="839">1427435</cx:pt>
          <cx:pt idx="840">812490</cx:pt>
          <cx:pt idx="841">464489</cx:pt>
          <cx:pt idx="842">1491763</cx:pt>
          <cx:pt idx="843">1652194</cx:pt>
          <cx:pt idx="844">129521</cx:pt>
          <cx:pt idx="845">306235</cx:pt>
          <cx:pt idx="846">1622071</cx:pt>
          <cx:pt idx="847">629118</cx:pt>
          <cx:pt idx="848">1316513</cx:pt>
          <cx:pt idx="849">870702</cx:pt>
          <cx:pt idx="850">1037274</cx:pt>
          <cx:pt idx="851">1659934</cx:pt>
          <cx:pt idx="852">623223</cx:pt>
          <cx:pt idx="853">3913912</cx:pt>
          <cx:pt idx="854">2392700</cx:pt>
          <cx:pt idx="855">3289904</cx:pt>
          <cx:pt idx="856">1117124</cx:pt>
          <cx:pt idx="857">1146324</cx:pt>
          <cx:pt idx="858">398119</cx:pt>
          <cx:pt idx="859">535321</cx:pt>
          <cx:pt idx="860">1259003</cx:pt>
          <cx:pt idx="861">1142723</cx:pt>
          <cx:pt idx="862">1965876</cx:pt>
          <cx:pt idx="863">448468</cx:pt>
          <cx:pt idx="864">668848</cx:pt>
          <cx:pt idx="865">1889394</cx:pt>
          <cx:pt idx="866">1322150</cx:pt>
          <cx:pt idx="867">1275480</cx:pt>
          <cx:pt idx="868">2528831</cx:pt>
          <cx:pt idx="869">623223</cx:pt>
          <cx:pt idx="870">1721108</cx:pt>
          <cx:pt idx="871">277484</cx:pt>
          <cx:pt idx="872">1181564</cx:pt>
          <cx:pt idx="873">3481508</cx:pt>
          <cx:pt idx="874">932210</cx:pt>
          <cx:pt idx="875">1210830</cx:pt>
          <cx:pt idx="876">1225675</cx:pt>
          <cx:pt idx="877">1618409</cx:pt>
          <cx:pt idx="878">409040</cx:pt>
          <cx:pt idx="879">3204676</cx:pt>
          <cx:pt idx="880">1703150</cx:pt>
          <cx:pt idx="881">592191</cx:pt>
          <cx:pt idx="882">651140</cx:pt>
          <cx:pt idx="883">1934189</cx:pt>
          <cx:pt idx="884">1324969</cx:pt>
          <cx:pt idx="885">604757</cx:pt>
          <cx:pt idx="886">1873383</cx:pt>
          <cx:pt idx="887">1329399</cx:pt>
          <cx:pt idx="888">4143890</cx:pt>
          <cx:pt idx="889">786787</cx:pt>
          <cx:pt idx="890">1529049</cx:pt>
          <cx:pt idx="891">1079966</cx:pt>
          <cx:pt idx="892">2169997</cx:pt>
          <cx:pt idx="893">1210028</cx:pt>
          <cx:pt idx="894">1672566</cx:pt>
          <cx:pt idx="895">1500269</cx:pt>
          <cx:pt idx="896">831485</cx:pt>
          <cx:pt idx="897">1422990</cx:pt>
          <cx:pt idx="898">854850</cx:pt>
          <cx:pt idx="899">1291967</cx:pt>
          <cx:pt idx="900">1612714</cx:pt>
          <cx:pt idx="901">1158734</cx:pt>
          <cx:pt idx="902">2606188</cx:pt>
          <cx:pt idx="903">2478911</cx:pt>
          <cx:pt idx="904">4066731</cx:pt>
          <cx:pt idx="905">942937</cx:pt>
          <cx:pt idx="906">930621</cx:pt>
          <cx:pt idx="907">2887084</cx:pt>
          <cx:pt idx="908">347858</cx:pt>
          <cx:pt idx="909">1886109</cx:pt>
          <cx:pt idx="910">1710903</cx:pt>
          <cx:pt idx="911">1175154</cx:pt>
          <cx:pt idx="912">298850</cx:pt>
          <cx:pt idx="913">156965</cx:pt>
          <cx:pt idx="914">1133921</cx:pt>
          <cx:pt idx="915">2804308</cx:pt>
          <cx:pt idx="916">930621</cx:pt>
          <cx:pt idx="917">1836468</cx:pt>
          <cx:pt idx="918">983898</cx:pt>
          <cx:pt idx="919">1658712</cx:pt>
          <cx:pt idx="920">1198799</cx:pt>
          <cx:pt idx="921">1906646</cx:pt>
          <cx:pt idx="922">973951</cx:pt>
          <cx:pt idx="923">3355071</cx:pt>
          <cx:pt idx="924">71627</cx:pt>
          <cx:pt idx="925">1571664</cx:pt>
          <cx:pt idx="926">1095942</cx:pt>
          <cx:pt idx="927">2160461</cx:pt>
          <cx:pt idx="928">1694175</cx:pt>
          <cx:pt idx="929">644453</cx:pt>
          <cx:pt idx="930">1415314</cx:pt>
          <cx:pt idx="931">1289554</cx:pt>
          <cx:pt idx="932">1764825</cx:pt>
          <cx:pt idx="933">613792</cx:pt>
          <cx:pt idx="934">791926</cx:pt>
          <cx:pt idx="935">1141522</cx:pt>
          <cx:pt idx="936">342020</cx:pt>
          <cx:pt idx="937">2211493</cx:pt>
          <cx:pt idx="938">2529251</cx:pt>
          <cx:pt idx="939">2484361</cx:pt>
          <cx:pt idx="940">1270656</cx:pt>
          <cx:pt idx="941">1911988</cx:pt>
          <cx:pt idx="942">1993888</cx:pt>
          <cx:pt idx="943">487559</cx:pt>
          <cx:pt idx="944">935785</cx:pt>
          <cx:pt idx="945">776512</cx:pt>
          <cx:pt idx="946">2942400</cx:pt>
          <cx:pt idx="947">352919</cx:pt>
          <cx:pt idx="948">1007387</cx:pt>
          <cx:pt idx="949">251478</cx:pt>
          <cx:pt idx="950">400069</cx:pt>
          <cx:pt idx="951">3633356</cx:pt>
          <cx:pt idx="952">569430</cx:pt>
          <cx:pt idx="953">1209226</cx:pt>
          <cx:pt idx="954">1007387</cx:pt>
          <cx:pt idx="955">1007786</cx:pt>
          <cx:pt idx="956">0</cx:pt>
          <cx:pt idx="957">284087</cx:pt>
          <cx:pt idx="958">1545276</cx:pt>
          <cx:pt idx="959">1388665</cx:pt>
          <cx:pt idx="960">436751</cx:pt>
          <cx:pt idx="961">1062403</cx:pt>
          <cx:pt idx="962">1962582</cx:pt>
          <cx:pt idx="963">0</cx:pt>
          <cx:pt idx="964">1097940</cx:pt>
          <cx:pt idx="965">661764</cx:pt>
          <cx:pt idx="966">0</cx:pt>
          <cx:pt idx="967">1871741</cx:pt>
          <cx:pt idx="968">128362</cx:pt>
          <cx:pt idx="969">1510400</cx:pt>
          <cx:pt idx="970">2809819</cx:pt>
          <cx:pt idx="971">569822</cx:pt>
          <cx:pt idx="972">2317163</cx:pt>
          <cx:pt idx="973">1216446</cx:pt>
          <cx:pt idx="974">489124</cx:pt>
          <cx:pt idx="975">2547310</cx:pt>
          <cx:pt idx="976">522786</cx:pt>
          <cx:pt idx="977">977929</cx:pt>
          <cx:pt idx="978">2704866</cx:pt>
          <cx:pt idx="979">1343096</cx:pt>
          <cx:pt idx="980">1605394</cx:pt>
          <cx:pt idx="981">0</cx:pt>
          <cx:pt idx="982">2444145</cx:pt>
          <cx:pt idx="983">2849274</cx:pt>
          <cx:pt idx="984">1249763</cx:pt>
          <cx:pt idx="985">2419456</cx:pt>
          <cx:pt idx="986">1614341</cx:pt>
          <cx:pt idx="987">1433497</cx:pt>
          <cx:pt idx="988">833068</cx:pt>
          <cx:pt idx="989">2005430</cx:pt>
          <cx:pt idx="990">385254</cx:pt>
          <cx:pt idx="991">462535</cx:pt>
          <cx:pt idx="992">1939948</cx:pt>
          <cx:pt idx="993">1424606</cx:pt>
          <cx:pt idx="994">330735</cx:pt>
          <cx:pt idx="995">1800420</cx:pt>
          <cx:pt idx="996">1560700</cx:pt>
          <cx:pt idx="997">3770224</cx:pt>
          <cx:pt idx="998">2403148</cx:pt>
          <cx:pt idx="999">1153929</cx:pt>
          <cx:pt idx="1000">2882833</cx:pt>
          <cx:pt idx="1001">1412486</cx:pt>
          <cx:pt idx="1002">922677</cx:pt>
          <cx:pt idx="1003">2254712</cx:pt>
          <cx:pt idx="1004">1316916</cx:pt>
          <cx:pt idx="1005">653894</cx:pt>
          <cx:pt idx="1006">645633</cx:pt>
          <cx:pt idx="1007">1093146</cx:pt>
          <cx:pt idx="1008">685386</cx:pt>
          <cx:pt idx="1009">764266</cx:pt>
          <cx:pt idx="1010">1851639</cx:pt>
          <cx:pt idx="1011">266613</cx:pt>
          <cx:pt idx="1012">142660</cx:pt>
          <cx:pt idx="1013">1073578</cx:pt>
          <cx:pt idx="1014">1080366</cx:pt>
          <cx:pt idx="1015">289525</cx:pt>
          <cx:pt idx="1016">1321345</cx:pt>
          <cx:pt idx="1017">1251370</cx:pt>
          <cx:pt idx="1018">948899</cx:pt>
          <cx:pt idx="1019">524744</cx:pt>
          <cx:pt idx="1020">1241330</cx:pt>
          <cx:pt idx="1021">972757</cx:pt>
          <cx:pt idx="1022">2589774</cx:pt>
          <cx:pt idx="1023">214643</cx:pt>
          <cx:pt idx="1024">2745448</cx:pt>
          <cx:pt idx="1025">684598</cx:pt>
          <cx:pt idx="1026">2355950</cx:pt>
          <cx:pt idx="1027">3037109</cx:pt>
          <cx:pt idx="1028">815655</cx:pt>
          <cx:pt idx="1029">2509944</cx:pt>
          <cx:pt idx="1030">704692</cx:pt>
          <cx:pt idx="1031">877045</cx:pt>
          <cx:pt idx="1032">707845</cx:pt>
          <cx:pt idx="1033">503993</cx:pt>
          <cx:pt idx="1034">543943</cx:pt>
          <cx:pt idx="1035">942937</cx:pt>
          <cx:pt idx="1036">0</cx:pt>
          <cx:pt idx="1037">1849998</cx:pt>
          <cx:pt idx="1038">972757</cx:pt>
          <cx:pt idx="1039">398899</cx:pt>
          <cx:pt idx="1040">130294</cx:pt>
          <cx:pt idx="1041">1232096</cx:pt>
          <cx:pt idx="1042">784020</cx:pt>
          <cx:pt idx="1043">1030497</cx:pt>
          <cx:pt idx="1044">819611</cx:pt>
          <cx:pt idx="1045">2330086</cx:pt>
          <cx:pt idx="1046">1554205</cx:pt>
          <cx:pt idx="1047">231310</cx:pt>
          <cx:pt idx="1048">953669</cx:pt>
          <cx:pt idx="1049">2061145</cx:pt>
          <cx:pt idx="1050">413722</cx:pt>
          <cx:pt idx="1051">0</cx:pt>
          <cx:pt idx="1052">4087996</cx:pt>
          <cx:pt idx="1053">3626813</cx:pt>
          <cx:pt idx="1054">480910</cx:pt>
          <cx:pt idx="1055">1954350</cx:pt>
          <cx:pt idx="1056">277484</cx:pt>
          <cx:pt idx="1057">324900</cx:pt>
          <cx:pt idx="1058">1288347</cx:pt>
          <cx:pt idx="1059">372393</cx:pt>
          <cx:pt idx="1060">953669</cx:pt>
          <cx:pt idx="1061">3077733</cx:pt>
          <cx:pt idx="1062">640127</cx:pt>
          <cx:pt idx="1063">156965</cx:pt>
          <cx:pt idx="1064">656648</cx:pt>
          <cx:pt idx="1065">2723459</cx:pt>
          <cx:pt idx="1066">977929</cx:pt>
          <cx:pt idx="1067">2320497</cx:pt>
          <cx:pt idx="1068">1518507</cx:pt>
          <cx:pt idx="1069">652320</cx:pt>
          <cx:pt idx="1070">176307</cx:pt>
          <cx:pt idx="1071">594939</cx:pt>
          <cx:pt idx="1072">0</cx:pt>
          <cx:pt idx="1073">2546890</cx:pt>
          <cx:pt idx="1074">157351</cx:pt>
          <cx:pt idx="1075">0</cx:pt>
          <cx:pt idx="1076">1227681</cx:pt>
          <cx:pt idx="1077">406310</cx:pt>
          <cx:pt idx="1078">821194</cx:pt>
          <cx:pt idx="1079">961621</cx:pt>
          <cx:pt idx="1080">506733</cx:pt>
          <cx:pt idx="1081">1719475</cx:pt>
          <cx:pt idx="1082">1385840</cx:pt>
          <cx:pt idx="1083">1400371</cx:pt>
          <cx:pt idx="1084">1839338</cx:pt>
          <cx:pt idx="1085">528269</cx:pt>
          <cx:pt idx="1086">0</cx:pt>
          <cx:pt idx="1087">531795</cx:pt>
          <cx:pt idx="1088">443000</cx:pt>
          <cx:pt idx="1089">510647</cx:pt>
          <cx:pt idx="1090">648387</cx:pt>
          <cx:pt idx="1091">2079328</cx:pt>
          <cx:pt idx="1092">1640792</cx:pt>
          <cx:pt idx="1093">487559</cx:pt>
          <cx:pt idx="1094">1024917</cx:pt>
          <cx:pt idx="1095">1058812</cx:pt>
          <cx:pt idx="1096">137636</cx:pt>
          <cx:pt idx="1097">1261413</cx:pt>
          <cx:pt idx="1098">2437029</cx:pt>
          <cx:pt idx="1099">641700</cx:pt>
          <cx:pt idx="1100">2742910</cx:pt>
          <cx:pt idx="1101">1939948</cx:pt>
          <cx:pt idx="1102">1932956</cx:pt>
          <cx:pt idx="1103">2145542</cx:pt>
          <cx:pt idx="1104">3966821</cx:pt>
          <cx:pt idx="1105">873477</cx:pt>
          <cx:pt idx="1106">685780</cx:pt>
          <cx:pt idx="1107">2777615</cx:pt>
          <cx:pt idx="1108">4252883</cx:pt>
          <cx:pt idx="1109">3279129</cx:pt>
          <cx:pt idx="1110">318288</cx:pt>
          <cx:pt idx="1111">322177</cx:pt>
          <cx:pt idx="1112">2017390</cx:pt>
          <cx:pt idx="1113">2913877</cx:pt>
          <cx:pt idx="1114">0</cx:pt>
          <cx:pt idx="1115">1739077</cx:pt>
          <cx:pt idx="1116">575707</cx:pt>
          <cx:pt idx="1117">1965876</cx:pt>
          <cx:pt idx="1118">2711626</cx:pt>
          <cx:pt idx="1119">612220</cx:pt>
          <cx:pt idx="1120">349805</cx:pt>
          <cx:pt idx="1121">1772186</cx:pt>
          <cx:pt idx="1122">755184</cx:pt>
          <cx:pt idx="1123">508690</cx:pt>
          <cx:pt idx="1124">160832</cx:pt>
          <cx:pt idx="1125">1105932</cx:pt>
          <cx:pt idx="1126">0</cx:pt>
          <cx:pt idx="1127">673966</cx:pt>
          <cx:pt idx="1128">1796736</cx:pt>
          <cx:pt idx="1129">1109529</cx:pt>
          <cx:pt idx="1130">508690</cx:pt>
          <cx:pt idx="1131">1479614</cx:pt>
          <cx:pt idx="1132">156191</cx:pt>
          <cx:pt idx="1133">831089</cx:pt>
          <cx:pt idx="1134">412161</cx:pt>
          <cx:pt idx="1135">3230046</cx:pt>
          <cx:pt idx="1136">2488134</cx:pt>
          <cx:pt idx="1137">754000</cx:pt>
          <cx:pt idx="1138">270883</cx:pt>
          <cx:pt idx="1139">345523</cx:pt>
          <cx:pt idx="1140">625188</cx:pt>
          <cx:pt idx="1141">339295</cx:pt>
          <cx:pt idx="1142">556879</cx:pt>
          <cx:pt idx="1143">1498649</cx:pt>
          <cx:pt idx="1144">148072</cx:pt>
          <cx:pt idx="1145">1543653</cx:pt>
          <cx:pt idx="1146">434408</cx:pt>
          <cx:pt idx="1147">298850</cx:pt>
          <cx:pt idx="1148">0</cx:pt>
          <cx:pt idx="1149">2098762</cx:pt>
          <cx:pt idx="1150">528269</cx:pt>
          <cx:pt idx="1151">136090</cx:pt>
          <cx:pt idx="1152">0</cx:pt>
          <cx:pt idx="1153">469180</cx:pt>
          <cx:pt idx="1154">1561512</cx:pt>
          <cx:pt idx="1155">510647</cx:pt>
          <cx:pt idx="1156">1930077</cx:pt>
          <cx:pt idx="1157">1069587</cx:pt>
          <cx:pt idx="1158">1334232</cx:pt>
          <cx:pt idx="1159">705480</cx:pt>
          <cx:pt idx="1160">874666</cx:pt>
          <cx:pt idx="1161">899654</cx:pt>
          <cx:pt idx="1162">98244</cx:pt>
          <cx:pt idx="1163">380966</cx:pt>
          <cx:pt idx="1164">3058483</cx:pt>
          <cx:pt idx="1165">836236</cx:pt>
          <cx:pt idx="1166">1078369</cx:pt>
          <cx:pt idx="1167">746499</cx:pt>
          <cx:pt idx="1168">1744388</cx:pt>
          <cx:pt idx="1169">2278428</cx:pt>
          <cx:pt idx="1170">0</cx:pt>
          <cx:pt idx="1171">1213638</cx:pt>
          <cx:pt idx="1172">576492</cx:pt>
          <cx:pt idx="1173">858416</cx:pt>
          <cx:pt idx="1174">769796</cx:pt>
          <cx:pt idx="1175">1210429</cx:pt>
          <cx:pt idx="1176">261955</cx:pt>
          <cx:pt idx="1177">264672</cx:pt>
          <cx:pt idx="1178">1716209</cx:pt>
          <cx:pt idx="1179">1883645</cx:pt>
          <cx:pt idx="1180">3406098</cx:pt>
          <cx:pt idx="1181">669636</cx:pt>
          <cx:pt idx="1182">1905414</cx:pt>
          <cx:pt idx="1183">1617189</cx:pt>
          <cx:pt idx="1184">2685441</cx:pt>
          <cx:pt idx="1185">995441</cx:pt>
          <cx:pt idx="1186">1738260</cx:pt>
          <cx:pt idx="1187">1899251</cx:pt>
          <cx:pt idx="1188">853265</cx:pt>
          <cx:pt idx="1189">774932</cx:pt>
          <cx:pt idx="1190">4104398</cx:pt>
          <cx:pt idx="1191">1476780</cx:pt>
          <cx:pt idx="1192">567076</cx:pt>
          <cx:pt idx="1193">1137921</cx:pt>
          <cx:pt idx="1194">853265</cx:pt>
          <cx:pt idx="1195">1248157</cx:pt>
          <cx:pt idx="1196">404749</cx:pt>
          <cx:pt idx="1197">0</cx:pt>
          <cx:pt idx="1198">1476780</cx:pt>
          <cx:pt idx="1199">1895554</cx:pt>
          <cx:pt idx="1200">1687650</cx:pt>
          <cx:pt idx="1201">2271769</cx:pt>
          <cx:pt idx="1202">1058812</cx:pt>
          <cx:pt idx="1203">1885288</cx:pt>
          <cx:pt idx="1204">2394789</cx:pt>
          <cx:pt idx="1205">3753135</cx:pt>
          <cx:pt idx="1206">0</cx:pt>
          <cx:pt idx="1207">308179</cx:pt>
          <cx:pt idx="1208">1570445</cx:pt>
          <cx:pt idx="1209">1010574</cx:pt>
          <cx:pt idx="1210">1778322</cx:pt>
          <cx:pt idx="1211">1661971</cx:pt>
          <cx:pt idx="1212">2070648</cx:pt>
          <cx:pt idx="1213">2359706</cx:pt>
          <cx:pt idx="1214">523961</cx:pt>
          <cx:pt idx="1215">0</cx:pt>
          <cx:pt idx="1216">1261413</cx:pt>
          <cx:pt idx="1217">2011203</cx:pt>
          <cx:pt idx="1218">1575319</cx:pt>
          <cx:pt idx="1219">779673</cx:pt>
          <cx:pt idx="1220">1222464</cx:pt>
          <cx:pt idx="1221">2613767</cx:pt>
          <cx:pt idx="1222">1264628</cx:pt>
          <cx:pt idx="1223">1447648</cx:pt>
          <cx:pt idx="1224">1446031</cx:pt>
          <cx:pt idx="1225">1149526</cx:pt>
          <cx:pt idx="1226">545902</cx:pt>
          <cx:pt idx="1227">683811</cx:pt>
          <cx:pt idx="1228">2791594</cx:pt>
          <cx:pt idx="1229">846928</cx:pt>
          <cx:pt idx="1230">2070648</cx:pt>
          <cx:pt idx="1231">810512</cx:pt>
          <cx:pt idx="1232">1394719</cx:pt>
          <cx:pt idx="1233">268166</cx:pt>
          <cx:pt idx="1234">1449266</cx:pt>
          <cx:pt idx="1235">2712894</cx:pt>
          <cx:pt idx="1236">3484979</cx:pt>
          <cx:pt idx="1237">3699741</cx:pt>
          <cx:pt idx="1238">633836</cx:pt>
          <cx:pt idx="1239">907194</cx:pt>
          <cx:pt idx="1240">2163777</cx:pt>
          <cx:pt idx="1241">1010574</cx:pt>
          <cx:pt idx="1242">1644864</cx:pt>
          <cx:pt idx="1243">1306853</cx:pt>
          <cx:pt idx="1244">1876666</cx:pt>
          <cx:pt idx="1245">848512</cx:pt>
          <cx:pt idx="1246">1295185</cx:pt>
          <cx:pt idx="1247">750842</cx:pt>
          <cx:pt idx="1248">455501</cx:pt>
          <cx:pt idx="1249">342020</cx:pt>
          <cx:pt idx="1250">2429078</cx:pt>
          <cx:pt idx="1251">333458</cx:pt>
          <cx:pt idx="1252">1699478</cx:pt>
          <cx:pt idx="1253">971564</cx:pt>
          <cx:pt idx="1254">2113657</cx:pt>
          <cx:pt idx="1255">871495</cx:pt>
          <cx:pt idx="1256">1723558</cx:pt>
          <cx:pt idx="1257">2561598</cx:pt>
          <cx:pt idx="1258">1617189</cx:pt>
          <cx:pt idx="1259">372393</cx:pt>
          <cx:pt idx="1260">631870</cx:pt>
          <cx:pt idx="1261">834652</cx:pt>
          <cx:pt idx="1262">347080</cx:pt>
          <cx:pt idx="1263">493036</cx:pt>
          <cx:pt idx="1264">695234</cx:pt>
          <cx:pt idx="1265">3383601</cx:pt>
          <cx:pt idx="1266">2341346</cx:pt>
          <cx:pt idx="1267">1731316</cx:pt>
          <cx:pt idx="1268">659403</cx:pt>
          <cx:pt idx="1269">600044</cx:pt>
          <cx:pt idx="1270">653894</cx:pt>
          <cx:pt idx="1271">1268245</cx:pt>
          <cx:pt idx="1272">1500269</cx:pt>
          <cx:pt idx="1273">726377</cx:pt>
          <cx:pt idx="1274">0</cx:pt>
          <cx:pt idx="1275">322177</cx:pt>
          <cx:pt idx="1276">1412890</cx:pt>
          <cx:pt idx="1277">3570170</cx:pt>
          <cx:pt idx="1278">430114</cx:pt>
          <cx:pt idx="1279">1689689</cx:pt>
          <cx:pt idx="1280">1953115</cx:pt>
          <cx:pt idx="1281">1323761</cx:pt>
          <cx:pt idx="1282">2127732</cx:pt>
          <cx:pt idx="1283">2386432</cx:pt>
          <cx:pt idx="1284">3405233</cx:pt>
          <cx:pt idx="1285">710998</cx:pt>
          <cx:pt idx="1286">3490188</cx:pt>
          <cx:pt idx="1287">1618409</cx:pt>
          <cx:pt idx="1288">2530510</cx:pt>
          <cx:pt idx="1289">957247</cx:pt>
          <cx:pt idx="1290">1318526</cx:pt>
          <cx:pt idx="1291">764266</cx:pt>
          <cx:pt idx="1292">1348738</cx:pt>
          <cx:pt idx="1293">977929</cx:pt>
          <cx:pt idx="1294">1268245</cx:pt>
          <cx:pt idx="1295">1167944</cx:pt>
          <cx:pt idx="1296">2259288</cx:pt>
          <cx:pt idx="1297">187144</cx:pt>
          <cx:pt idx="1298">1433497</cx:pt>
          <cx:pt idx="1299">896083</cx:pt>
          <cx:pt idx="1300">1111527</cx:pt>
          <cx:pt idx="1301">163540</cx:pt>
          <cx:pt idx="1302">250702</cx:pt>
          <cx:pt idx="1303">250702</cx:pt>
          <cx:pt idx="1304">2235172</cx:pt>
          <cx:pt idx="1305">0</cx:pt>
          <cx:pt idx="1306">143819</cx:pt>
          <cx:pt idx="1307">1992239</cx:pt>
          <cx:pt idx="1308">1109529</cx:pt>
          <cx:pt idx="1309">215805</cx:pt>
          <cx:pt idx="1310">929032</cx:pt>
          <cx:pt idx="1311">1643642</cx:pt>
          <cx:pt idx="1312">1962171</cx:pt>
          <cx:pt idx="1313">2016152</cx:pt>
          <cx:pt idx="1314">2362628</cx:pt>
          <cx:pt idx="1315">4059204</cx:pt>
          <cx:pt idx="1316">321010</cx:pt>
          <cx:pt idx="1317">2993982</cx:pt>
          <cx:pt idx="1318">1427031</cx:pt>
          <cx:pt idx="1319">2669826</cx:pt>
          <cx:pt idx="1320">1222063</cx:pt>
          <cx:pt idx="1321">407870</cx:pt>
          <cx:pt idx="1322">1047243</cx:pt>
          <cx:pt idx="1323">2829752</cx:pt>
          <cx:pt idx="1324">2968819</cx:pt>
          <cx:pt idx="1325">832672</cx:pt>
          <cx:pt idx="1326">1081564</cx:pt>
          <cx:pt idx="1327">1450479</cx:pt>
          <cx:pt idx="1328">1158333</cx:pt>
          <cx:pt idx="1329">2456287</cx:pt>
          <cx:pt idx="1330">340852</cx:pt>
          <cx:pt idx="1331">917118</cx:pt>
          <cx:pt idx="1332">679085</cx:pt>
          <cx:pt idx="1333">1710087</cx:pt>
          <cx:pt idx="1334">822381</cx:pt>
          <cx:pt idx="1335">2364715</cx:pt>
          <cx:pt idx="1336">951681</cx:pt>
          <cx:pt idx="1337">155031</cx:pt>
          <cx:pt idx="1338">1006193</cx:pt>
          <cx:pt idx="1339">1622884</cx:pt>
          <cx:pt idx="1340">0</cx:pt>
          <cx:pt idx="1341">162766</cx:pt>
          <cx:pt idx="1342">1297196</cx:pt>
          <cx:pt idx="1343">514954</cx:pt>
          <cx:pt idx="1344">1501485</cx:pt>
          <cx:pt idx="1345">2928774</cx:pt>
          <cx:pt idx="1346">3262759</cx:pt>
          <cx:pt idx="1347">2719655</cx:pt>
          <cx:pt idx="1348">1016549</cx:pt>
          <cx:pt idx="1349">1607427</cx:pt>
          <cx:pt idx="1350">440266</cx:pt>
          <cx:pt idx="1351">1705598</cx:pt>
          <cx:pt idx="1352">3707613</cx:pt>
          <cx:pt idx="1353">435580</cx:pt>
          <cx:pt idx="1354">2022752</cx:pt>
          <cx:pt idx="1355">764266</cx:pt>
          <cx:pt idx="1356">2127732</cx:pt>
          <cx:pt idx="1357">3223594</cx:pt>
          <cx:pt idx="1358">1552581</cx:pt>
          <cx:pt idx="1359">1840568</cx:pt>
          <cx:pt idx="1360">97472</cx:pt>
          <cx:pt idx="1361">1383015</cx:pt>
          <cx:pt idx="1362">2363046</cx:pt>
          <cx:pt idx="1363">1163939</cx:pt>
          <cx:pt idx="1364">695234</cx:pt>
          <cx:pt idx="1365">891322</cx:pt>
          <cx:pt idx="1366">1951057</cx:pt>
          <cx:pt idx="1367">1386243</cx:pt>
          <cx:pt idx="1368">1677050</cx:pt>
          <cx:pt idx="1369">616935</cx:pt>
          <cx:pt idx="1370">0</cx:pt>
          <cx:pt idx="1371">4194109</cx:pt>
          <cx:pt idx="1372">250702</cx:pt>
          <cx:pt idx="1373">2509944</cx:pt>
          <cx:pt idx="1374">1636721</cx:pt>
          <cx:pt idx="1375">1337858</cx:pt>
          <cx:pt idx="1376">1016549</cx:pt>
          <cx:pt idx="1377">3687064</cx:pt>
          <cx:pt idx="1378">1725191</cx:pt>
          <cx:pt idx="1379">852077</cx:pt>
          <cx:pt idx="1380">0</cx:pt>
          <cx:pt idx="1381">2752640</cx:pt>
          <cx:pt idx="1382">3003371</cx:pt>
          <cx:pt idx="1383">1450884</cx:pt>
          <cx:pt idx="1384">3320959</cx:pt>
          <cx:pt idx="1385">1212033</cx:pt>
          <cx:pt idx="1386">1368896</cx:pt>
          <cx:pt idx="1387">1195993</cx:pt>
          <cx:pt idx="1388">337739</cx:pt>
          <cx:pt idx="1389">1480019</cx:pt>
          <cx:pt idx="1390">220456</cx:pt>
          <cx:pt idx="1391">1676642</cx:pt>
          <cx:pt idx="1392">1433497</cx:pt>
          <cx:pt idx="1393">401239</cx:pt>
          <cx:pt idx="1394">437923</cx:pt>
          <cx:pt idx="1395">5432874</cx:pt>
          <cx:pt idx="1396">202633</cx:pt>
          <cx:pt idx="1397">2189077</cx:pt>
          <cx:pt idx="1398">1566790</cx:pt>
          <cx:pt idx="1399">1286738</cx:pt>
          <cx:pt idx="1400">1003405</cx:pt>
          <cx:pt idx="1401">2456287</cx:pt>
          <cx:pt idx="1402">994645</cx:pt>
          <cx:pt idx="1403">2836965</cx:pt>
          <cx:pt idx="1404">945719</cx:pt>
          <cx:pt idx="1405">2081394</cx:pt>
          <cx:pt idx="1406">1295989</cx:pt>
          <cx:pt idx="1407">1850818</cx:pt>
          <cx:pt idx="1408">114458</cx:pt>
          <cx:pt idx="1409">953669</cx:pt>
          <cx:pt idx="1410">1964229</cx:pt>
          <cx:pt idx="1411">1820896</cx:pt>
          <cx:pt idx="1412">2881558</cx:pt>
          <cx:pt idx="1413">3320959</cx:pt>
          <cx:pt idx="1414">1809018</cx:pt>
          <cx:pt idx="1415">1568009</cx:pt>
          <cx:pt idx="1416">673966</cx:pt>
          <cx:pt idx="1417">1060009</cx:pt>
          <cx:pt idx="1418">447687</cx:pt>
          <cx:pt idx="1419">341630</cx:pt>
          <cx:pt idx="1420">1180362</cx:pt>
          <cx:pt idx="1421">2461732</cx:pt>
          <cx:pt idx="1422">701933</cx:pt>
          <cx:pt idx="1423">991062</cx:pt>
          <cx:pt idx="1424">161992</cx:pt>
          <cx:pt idx="1425">0</cx:pt>
          <cx:pt idx="1426">1070784</cx:pt>
          <cx:pt idx="1427">4563879</cx:pt>
          <cx:pt idx="1428">0</cx:pt>
          <cx:pt idx="1429">653894</cx:pt>
          <cx:pt idx="1430">980715</cx:pt>
          <cx:pt idx="1431">1504321</cx:pt>
          <cx:pt idx="1432">1197196</cx:pt>
          <cx:pt idx="1433">227820</cx:pt>
          <cx:pt idx="1434">0</cx:pt>
          <cx:pt idx="1435">1965053</cx:pt>
          <cx:pt idx="1436">488341</cx:pt>
          <cx:pt idx="1437">1004998</cx:pt>
          <cx:pt idx="1438">2213985</cx:pt>
          <cx:pt idx="1439">900051</cx:pt>
          <cx:pt idx="1440">283698</cx:pt>
          <cx:pt idx="1441">969575</cx:pt>
          <cx:pt idx="1442">0</cx:pt>
          <cx:pt idx="1443">143433</cx:pt>
          <cx:pt idx="1444">3204247</cx:pt>
          <cx:pt idx="1445">656648</cx:pt>
          <cx:pt idx="1446">309345</cx:pt>
          <cx:pt idx="1447">1811885</cx:pt>
          <cx:pt idx="1448">1944062</cx:pt>
          <cx:pt idx="1449">852077</cx:pt>
          <cx:pt idx="1450">3276113</cx:pt>
          <cx:pt idx="1451">491080</cx:pt>
          <cx:pt idx="1452">2496940</cx:pt>
          <cx:pt idx="1453">2505748</cx:pt>
          <cx:pt idx="1454">1213638</cx:pt>
          <cx:pt idx="1455">2384343</cx:pt>
          <cx:pt idx="1456">1770550</cx:pt>
          <cx:pt idx="1457">728349</cx:pt>
          <cx:pt idx="1458">2565802</cx:pt>
          <cx:pt idx="1459">2902817</cx:pt>
          <cx:pt idx="1460">744526</cx:pt>
          <cx:pt idx="1461">788368</cx:pt>
          <cx:pt idx="1462">1803286</cx:pt>
          <cx:pt idx="1463">556879</cx:pt>
          <cx:pt idx="1464">1357605</cx:pt>
          <cx:pt idx="1465">1073578</cx:pt>
          <cx:pt idx="1466">162766</cx:pt>
          <cx:pt idx="1467">2743333</cx:pt>
          <cx:pt idx="1468">0</cx:pt>
          <cx:pt idx="1469">1532700</cx:pt>
          <cx:pt idx="1470">0</cx:pt>
          <cx:pt idx="1471">657042</cx:pt>
          <cx:pt idx="1472">1666860</cx:pt>
          <cx:pt idx="1473">1871741</cx:pt>
          <cx:pt idx="1474">2948363</cx:pt>
          <cx:pt idx="1475">885372</cx:pt>
          <cx:pt idx="1476">1478400</cx:pt>
          <cx:pt idx="1477">2972230</cx:pt>
          <cx:pt idx="1478">820007</cx:pt>
          <cx:pt idx="1479">943335</cx:pt>
          <cx:pt idx="1480">790344</cx:pt>
          <cx:pt idx="1481">0</cx:pt>
          <cx:pt idx="1482">1328593</cx:pt>
          <cx:pt idx="1483">160832</cx:pt>
          <cx:pt idx="1484">178629</cx:pt>
          <cx:pt idx="1485">826735</cx:pt>
          <cx:pt idx="1486">958440</cx:pt>
          <cx:pt idx="1487">246046</cx:pt>
          <cx:pt idx="1488">2118210</cx:pt>
        </cx:lvl>
      </cx:numDim>
    </cx:data>
    <cx:data id="1">
      <cx:numDim type="val">
        <cx:f>hq_hic.fasta.pass!$Q$1:$Q$1686</cx:f>
        <cx:lvl ptCount="1686" formatCode="G/通用格式">
          <cx:pt idx="0">395000</cx:pt>
          <cx:pt idx="1">212318</cx:pt>
          <cx:pt idx="2">0</cx:pt>
          <cx:pt idx="3">183660</cx:pt>
          <cx:pt idx="4">489124</cx:pt>
          <cx:pt idx="5">2435355</cx:pt>
          <cx:pt idx="6">328401</cx:pt>
          <cx:pt idx="7">672391</cx:pt>
          <cx:pt idx="8">1197997</cx:pt>
          <cx:pt idx="9">602400</cx:pt>
          <cx:pt idx="10">424259</cx:pt>
          <cx:pt idx="11">391491</cx:pt>
          <cx:pt idx="12">843759</cx:pt>
          <cx:pt idx="13">671604</cx:pt>
          <cx:pt idx="14">433628</cx:pt>
          <cx:pt idx="15">481301</cx:pt>
          <cx:pt idx="16">603579</cx:pt>
          <cx:pt idx="17">1103934</cx:pt>
          <cx:pt idx="18">2430752</cx:pt>
          <cx:pt idx="19">510647</cx:pt>
          <cx:pt idx="20">816842</cx:pt>
          <cx:pt idx="21">953669</cx:pt>
          <cx:pt idx="22">654681</cx:pt>
          <cx:pt idx="23">489124</cx:pt>
          <cx:pt idx="24">578846</cx:pt>
          <cx:pt idx="25">465662</cx:pt>
          <cx:pt idx="26">1398352</cx:pt>
          <cx:pt idx="27">722827</cx:pt>
          <cx:pt idx="28">393050</cx:pt>
          <cx:pt idx="29">1407236</cx:pt>
          <cx:pt idx="30">2138913</cx:pt>
          <cx:pt idx="31">273601</cx:pt>
          <cx:pt idx="32">2803036</cx:pt>
          <cx:pt idx="33">1000219</cx:pt>
          <cx:pt idx="34">0</cx:pt>
          <cx:pt idx="35">390711</cx:pt>
          <cx:pt idx="36">749263</cx:pt>
          <cx:pt idx="37">512213</cx:pt>
          <cx:pt idx="38">752026</cx:pt>
          <cx:pt idx="39">690507</cx:pt>
          <cx:pt idx="40">433237</cx:pt>
          <cx:pt idx="41">519261</cx:pt>
          <cx:pt idx="42">1604988</cx:pt>
          <cx:pt idx="43">697992</cx:pt>
          <cx:pt idx="44">902035</cx:pt>
          <cx:pt idx="45">920692</cx:pt>
          <cx:pt idx="46">402019</cx:pt>
          <cx:pt idx="47">724405</cx:pt>
          <cx:pt idx="48">431675</cx:pt>
          <cx:pt idx="49">953271</cx:pt>
          <cx:pt idx="50">1606207</cx:pt>
          <cx:pt idx="51">879027</cx:pt>
          <cx:pt idx="52">1345513</cx:pt>
          <cx:pt idx="53">1555828</cx:pt>
          <cx:pt idx="54">1407236</cx:pt>
          <cx:pt idx="55">482865</cx:pt>
          <cx:pt idx="56">525919</cx:pt>
          <cx:pt idx="57">248374</cx:pt>
          <cx:pt idx="58">1905003</cx:pt>
          <cx:pt idx="59">90527</cx:pt>
          <cx:pt idx="60">1288347</cx:pt>
          <cx:pt idx="61">375121</cx:pt>
          <cx:pt idx="62">1017745</cx:pt>
          <cx:pt idx="63">2333422</cx:pt>
          <cx:pt idx="64">575707</cx:pt>
          <cx:pt idx="65">822381</cx:pt>
          <cx:pt idx="66">713758</cx:pt>
          <cx:pt idx="67">625581</cx:pt>
          <cx:pt idx="68">1484068</cx:pt>
          <cx:pt idx="69">408650</cx:pt>
          <cx:pt idx="70">829506</cx:pt>
          <cx:pt idx="71">374731</cx:pt>
          <cx:pt idx="72">364992</cx:pt>
          <cx:pt idx="73">280979</cx:pt>
          <cx:pt idx="74">899257</cx:pt>
          <cx:pt idx="75">212705</cx:pt>
          <cx:pt idx="76">673966</cx:pt>
          <cx:pt idx="77">527094</cx:pt>
          <cx:pt idx="78">324511</cx:pt>
          <cx:pt idx="79">2193642</cx:pt>
          <cx:pt idx="80">272436</cx:pt>
          <cx:pt idx="81">0</cx:pt>
          <cx:pt idx="82">404749</cx:pt>
          <cx:pt idx="83">1640792</cx:pt>
          <cx:pt idx="84">692082</cx:pt>
          <cx:pt idx="85">91298</cx:pt>
          <cx:pt idx="86">719672</cx:pt>
          <cx:pt idx="87">1099139</cx:pt>
          <cx:pt idx="88">613006</cx:pt>
          <cx:pt idx="89">622437</cx:pt>
          <cx:pt idx="90">1042059</cx:pt>
          <cx:pt idx="91">425039</cx:pt>
          <cx:pt idx="92">168182</cx:pt>
          <cx:pt idx="93">149232</cx:pt>
          <cx:pt idx="94">500862</cx:pt>
          <cx:pt idx="95">873873</cx:pt>
          <cx:pt idx="96">3391386</cx:pt>
          <cx:pt idx="97">1410870</cx:pt>
          <cx:pt idx="98">178242</cx:pt>
          <cx:pt idx="99">770191</cx:pt>
          <cx:pt idx="100">655468</cx:pt>
          <cx:pt idx="101">990664</cx:pt>
          <cx:pt idx="102">1076772</cx:pt>
          <cx:pt idx="103">985092</cx:pt>
          <cx:pt idx="104">1006591</cx:pt>
          <cx:pt idx="105">1369299</cx:pt>
          <cx:pt idx="106">905606</cx:pt>
          <cx:pt idx="107">1383822</cx:pt>
          <cx:pt idx="108">971166</cx:pt>
          <cx:pt idx="109">811698</cx:pt>
          <cx:pt idx="110">1805742</cx:pt>
          <cx:pt idx="111">781649</cx:pt>
          <cx:pt idx="112">770586</cx:pt>
          <cx:pt idx="113">1435923</cx:pt>
          <cx:pt idx="114">715729</cx:pt>
          <cx:pt idx="115">1109129</cx:pt>
          <cx:pt idx="116">136476</cx:pt>
          <cx:pt idx="117">823173</cx:pt>
          <cx:pt idx="118">833860</cx:pt>
          <cx:pt idx="119">272436</cx:pt>
          <cx:pt idx="120">772561</cx:pt>
          <cx:pt idx="121">569822</cx:pt>
          <cx:pt idx="122">338906</cx:pt>
          <cx:pt idx="123">331902</cx:pt>
          <cx:pt idx="124">1689689</cx:pt>
          <cx:pt idx="125">1134721</cx:pt>
          <cx:pt idx="126">2750524</cx:pt>
          <cx:pt idx="127">933799</cx:pt>
          <cx:pt idx="128">666093</cx:pt>
          <cx:pt idx="129">792716</cx:pt>
          <cx:pt idx="130">1237716</cx:pt>
          <cx:pt idx="131">2004606</cx:pt>
          <cx:pt idx="132">635015</cx:pt>
          <cx:pt idx="133">0</cx:pt>
          <cx:pt idx="134">1721108</cx:pt>
          <cx:pt idx="135">332291</cx:pt>
          <cx:pt idx="136">364992</cx:pt>
          <cx:pt idx="137">698780</cx:pt>
          <cx:pt idx="138">319066</cx:pt>
          <cx:pt idx="139">65459</cx:pt>
          <cx:pt idx="140">655861</cx:pt>
          <cx:pt idx="141">1196795</cx:pt>
          <cx:pt idx="142">1527833</cx:pt>
          <cx:pt idx="143">242555</cx:pt>
          <cx:pt idx="144">364992</cx:pt>
          <cx:pt idx="145">701145</cx:pt>
          <cx:pt idx="146">208444</cx:pt>
          <cx:pt idx="147">939361</cx:pt>
          <cx:pt idx="148">329179</cx:pt>
          <cx:pt idx="149">1185972</cx:pt>
          <cx:pt idx="150">181725</cx:pt>
          <cx:pt idx="151">300016</cx:pt>
          <cx:pt idx="152">859605</cx:pt>
          <cx:pt idx="153">532579</cx:pt>
          <cx:pt idx="154">1603768</cx:pt>
          <cx:pt idx="155">1484473</cx:pt>
          <cx:pt idx="156">424649</cx:pt>
          <cx:pt idx="157">2838663</cx:pt>
          <cx:pt idx="158">475826</cx:pt>
          <cx:pt idx="159">2133943</cx:pt>
          <cx:pt idx="160">485603</cx:pt>
          <cx:pt idx="161">1345111</cx:pt>
          <cx:pt idx="162">3747879</cx:pt>
          <cx:pt idx="163">334237</cx:pt>
          <cx:pt idx="164">605150</cx:pt>
          <cx:pt idx="165">274766</cx:pt>
          <cx:pt idx="166">822777</cx:pt>
          <cx:pt idx="167">640520</cx:pt>
          <cx:pt idx="168">1554610</cx:pt>
          <cx:pt idx="169">422307</cx:pt>
          <cx:pt idx="170">501253</cx:pt>
          <cx:pt idx="171">1103134</cx:pt>
          <cx:pt idx="172">1045249</cx:pt>
          <cx:pt idx="173">440266</cx:pt>
          <cx:pt idx="174">567468</cx:pt>
          <cx:pt idx="175">935388</cx:pt>
          <cx:pt idx="176">1649751</cx:pt>
          <cx:pt idx="177">3031127</cx:pt>
          <cx:pt idx="178">881407</cx:pt>
          <cx:pt idx="179">426601</cx:pt>
          <cx:pt idx="180">514562</cx:pt>
          <cx:pt idx="181">629512</cx:pt>
          <cx:pt idx="182">1535945</cx:pt>
          <cx:pt idx="183">923074</cx:pt>
          <cx:pt idx="184">738607</cx:pt>
          <cx:pt idx="185">274378</cx:pt>
          <cx:pt idx="186">686961</cx:pt>
          <cx:pt idx="187">457064</cx:pt>
          <cx:pt idx="188">613006</cx:pt>
          <cx:pt idx="189">151165</cx:pt>
          <cx:pt idx="190">46961</cx:pt>
          <cx:pt idx="191">188306</cx:pt>
          <cx:pt idx="192">361876</cx:pt>
          <cx:pt idx="193">389152</cx:pt>
          <cx:pt idx="194">1337052</cx:pt>
          <cx:pt idx="195">751631</cx:pt>
          <cx:pt idx="196">137636</cx:pt>
          <cx:pt idx="197">62761</cx:pt>
          <cx:pt idx="198">1068389</cx:pt>
          <cx:pt idx="199">235962</cx:pt>
          <cx:pt idx="200">1937480</cx:pt>
          <cx:pt idx="201">240616</cx:pt>
          <cx:pt idx="202">1953115</cx:pt>
          <cx:pt idx="203">966791</cx:pt>
          <cx:pt idx="204">923074</cx:pt>
          <cx:pt idx="205">577276</cx:pt>
          <cx:pt idx="206">512213</cx:pt>
          <cx:pt idx="207">331513</cx:pt>
          <cx:pt idx="208">532579</cx:pt>
          <cx:pt idx="209">303903</cx:pt>
          <cx:pt idx="210">1327385</cx:pt>
          <cx:pt idx="211">1091548</cx:pt>
          <cx:pt idx="212">944527</cx:pt>
          <cx:pt idx="213">273989</cx:pt>
          <cx:pt idx="214">554919</cx:pt>
          <cx:pt idx="215">633443</cx:pt>
          <cx:pt idx="216">1992652</cx:pt>
          <cx:pt idx="217">255358</cx:pt>
          <cx:pt idx="218">871495</cx:pt>
          <cx:pt idx="219">896479</cx:pt>
          <cx:pt idx="220">612613</cx:pt>
          <cx:pt idx="221">460190</cx:pt>
          <cx:pt idx="222">224332</cx:pt>
          <cx:pt idx="223">524744</cx:pt>
          <cx:pt idx="224">701539</cx:pt>
          <cx:pt idx="225">597688</cx:pt>
          <cx:pt idx="226">688143</cx:pt>
          <cx:pt idx="227">1155531</cx:pt>
          <cx:pt idx="228">656648</cx:pt>
          <cx:pt idx="229">333848</cx:pt>
          <cx:pt idx="230">2134357</cx:pt>
          <cx:pt idx="231">1734175</cx:pt>
          <cx:pt idx="232">665700</cx:pt>
          <cx:pt idx="233">181725</cx:pt>
          <cx:pt idx="234">2124005</cx:pt>
          <cx:pt idx="235">679479</cx:pt>
          <cx:pt idx="236">2193642</cx:pt>
          <cx:pt idx="237">335404</cx:pt>
          <cx:pt idx="238">572568</cx:pt>
          <cx:pt idx="239">0</cx:pt>
          <cx:pt idx="240">490297</cx:pt>
          <cx:pt idx="241">242943</cx:pt>
          <cx:pt idx="242">549822</cx:pt>
          <cx:pt idx="243">2163363</cx:pt>
          <cx:pt idx="244">349805</cx:pt>
          <cx:pt idx="245">475826</cx:pt>
          <cx:pt idx="246">1339469</cx:pt>
          <cx:pt idx="247">576884</cx:pt>
          <cx:pt idx="248">718884</cx:pt>
          <cx:pt idx="249">2339261</cx:pt>
          <cx:pt idx="250">541199</cx:pt>
          <cx:pt idx="251">1090350</cx:pt>
          <cx:pt idx="252">203795</cx:pt>
          <cx:pt idx="253">3518417</cx:pt>
          <cx:pt idx="254">525136</cx:pt>
          <cx:pt idx="255">274766</cx:pt>
          <cx:pt idx="256">812490</cx:pt>
          <cx:pt idx="257">0</cx:pt>
          <cx:pt idx="258">1460997</cx:pt>
          <cx:pt idx="259">1596043</cx:pt>
          <cx:pt idx="260">1500269</cx:pt>
          <cx:pt idx="261">274378</cx:pt>
          <cx:pt idx="262">944130</cx:pt>
          <cx:pt idx="263">408650</cx:pt>
          <cx:pt idx="264">642094</cx:pt>
          <cx:pt idx="265">607113</cx:pt>
          <cx:pt idx="266">606721</cx:pt>
          <cx:pt idx="267">730716</cx:pt>
          <cx:pt idx="268">839403</cx:pt>
          <cx:pt idx="269">1548522</cx:pt>
          <cx:pt idx="270">3260175</cx:pt>
          <cx:pt idx="271">810512</cx:pt>
          <cx:pt idx="272">1406428</cx:pt>
          <cx:pt idx="273">455891</cx:pt>
          <cx:pt idx="274">348637</cx:pt>
          <cx:pt idx="275">2174558</cx:pt>
          <cx:pt idx="276">997034</cx:pt>
          <cx:pt idx="277">977134</cx:pt>
          <cx:pt idx="278">490297</cx:pt>
          <cx:pt idx="279">151165</cx:pt>
          <cx:pt idx="280">2151343</cx:pt>
          <cx:pt idx="281">2162119</cx:pt>
          <cx:pt idx="282">657435</cx:pt>
          <cx:pt idx="283">879027</cx:pt>
          <cx:pt idx="284">628332</cx:pt>
          <cx:pt idx="285">2462570</cx:pt>
          <cx:pt idx="286">395780</cx:pt>
          <cx:pt idx="287">366939</cx:pt>
          <cx:pt idx="288">2613345</cx:pt>
          <cx:pt idx="289">554135</cx:pt>
          <cx:pt idx="290">72013</cx:pt>
          <cx:pt idx="291">688143</cx:pt>
          <cx:pt idx="292">1179160</cx:pt>
          <cx:pt idx="293">873477</cx:pt>
          <cx:pt idx="294">1322553</cx:pt>
          <cx:pt idx="295">692476</cx:pt>
          <cx:pt idx="296">202633</cx:pt>
          <cx:pt idx="297">1768505</cx:pt>
          <cx:pt idx="298">1026113</cx:pt>
          <cx:pt idx="299">361876</cx:pt>
          <cx:pt idx="300">716518</cx:pt>
          <cx:pt idx="301">456673</cx:pt>
          <cx:pt idx="302">484821</cx:pt>
          <cx:pt idx="303">727560</cx:pt>
          <cx:pt idx="304">3123557</cx:pt>
          <cx:pt idx="305">789554</cx:pt>
          <cx:pt idx="306">636588</cx:pt>
          <cx:pt idx="307">779673</cx:pt>
          <cx:pt idx="308">1372526</cx:pt>
          <cx:pt idx="309">1651787</cx:pt>
          <cx:pt idx="310">672391</cx:pt>
          <cx:pt idx="311">1254182</cx:pt>
          <cx:pt idx="312">780068</cx:pt>
          <cx:pt idx="313">1599295</cx:pt>
          <cx:pt idx="314">701933</cx:pt>
          <cx:pt idx="315">1287543</cx:pt>
          <cx:pt idx="316">653894</cx:pt>
          <cx:pt idx="317">1046047</cx:pt>
          <cx:pt idx="318">540415</cx:pt>
          <cx:pt idx="319">904416</cx:pt>
          <cx:pt idx="320">1281913</cx:pt>
          <cx:pt idx="321">737028</cx:pt>
          <cx:pt idx="322">1159935</cx:pt>
          <cx:pt idx="323">508690</cx:pt>
          <cx:pt idx="324">501253</cx:pt>
          <cx:pt idx="325">1447244</cx:pt>
          <cx:pt idx="326">1892268</cx:pt>
          <cx:pt idx="327">919501</cx:pt>
          <cx:pt idx="328">1100737</cx:pt>
          <cx:pt idx="329">258850</cx:pt>
          <cx:pt idx="330">638161</cx:pt>
          <cx:pt idx="331">46961</cx:pt>
          <cx:pt idx="332">746499</cx:pt>
          <cx:pt idx="333">488341</cx:pt>
          <cx:pt idx="334">1159935</cx:pt>
          <cx:pt idx="335">377849</cx:pt>
          <cx:pt idx="336">540023</cx:pt>
          <cx:pt idx="337">199147</cx:pt>
          <cx:pt idx="338">917912</cx:pt>
          <cx:pt idx="339">705480</cx:pt>
          <cx:pt idx="340">382915</cx:pt>
          <cx:pt idx="341">436361</cx:pt>
          <cx:pt idx="342">846531</cx:pt>
          <cx:pt idx="343">830297</cx:pt>
          <cx:pt idx="344">1549334</cx:pt>
          <cx:pt idx="345">101332</cx:pt>
          <cx:pt idx="346">948104</cx:pt>
          <cx:pt idx="347">249538</cx:pt>
          <cx:pt idx="348">2107864</cx:pt>
          <cx:pt idx="349">599651</cx:pt>
          <cx:pt idx="350">2959015</cx:pt>
          <cx:pt idx="351">221618</cx:pt>
          <cx:pt idx="352">1078769</cx:pt>
          <cx:pt idx="353">757948</cx:pt>
          <cx:pt idx="354">801415</cx:pt>
          <cx:pt idx="355">1440370</cx:pt>
          <cx:pt idx="356">1333024</cx:pt>
          <cx:pt idx="357">795879</cx:pt>
          <cx:pt idx="358">940156</cx:pt>
          <cx:pt idx="359">3857142</cx:pt>
          <cx:pt idx="360">757158</cx:pt>
          <cx:pt idx="361">1393912</cx:pt>
          <cx:pt idx="362">301571</cx:pt>
          <cx:pt idx="363">300016</cx:pt>
          <cx:pt idx="364">827131</cx:pt>
          <cx:pt idx="365">249926</cx:pt>
          <cx:pt idx="366">1729275</cx:pt>
          <cx:pt idx="367">1237716</cx:pt>
          <cx:pt idx="368">735056</cx:pt>
          <cx:pt idx="369">1418141</cx:pt>
          <cx:pt idx="370">1982350</cx:pt>
          <cx:pt idx="371">574922</cx:pt>
          <cx:pt idx="372">1055221</cx:pt>
          <cx:pt idx="373">563154</cx:pt>
          <cx:pt idx="374">0</cx:pt>
          <cx:pt idx="375">1784867</cx:pt>
          <cx:pt idx="376">59292</cx:pt>
          <cx:pt idx="377">514562</cx:pt>
          <cx:pt idx="378">329179</cx:pt>
          <cx:pt idx="379">1234906</cx:pt>
          <cx:pt idx="380">319066</cx:pt>
          <cx:pt idx="381">590228</cx:pt>
          <cx:pt idx="382">1023722</cx:pt>
          <cx:pt idx="383">560801</cx:pt>
          <cx:pt idx="384">1723966</cx:pt>
          <cx:pt idx="385">867531</cx:pt>
          <cx:pt idx="386">236738</cx:pt>
          <cx:pt idx="387">542767</cx:pt>
          <cx:pt idx="388">2316329</cx:pt>
          <cx:pt idx="389">954862</cx:pt>
          <cx:pt idx="390">1655453</cx:pt>
          <cx:pt idx="391">1845488</cx:pt>
          <cx:pt idx="392">1412890</cx:pt>
          <cx:pt idx="393">501644</cx:pt>
          <cx:pt idx="394">651140</cx:pt>
          <cx:pt idx="395">2245564</cx:pt>
          <cx:pt idx="396">972360</cx:pt>
          <cx:pt idx="397">969973</cx:pt>
          <cx:pt idx="398">482474</cx:pt>
          <cx:pt idx="399">798647</cx:pt>
          <cx:pt idx="400">189080</cx:pt>
          <cx:pt idx="401">272048</cx:pt>
          <cx:pt idx="402">547862</cx:pt>
          <cx:pt idx="403">514171</cx:pt>
          <cx:pt idx="404">1122322</cx:pt>
          <cx:pt idx="405">1658304</cx:pt>
          <cx:pt idx="406">1581007</cx:pt>
          <cx:pt idx="407">546686</cx:pt>
          <cx:pt idx="408">463316</cx:pt>
          <cx:pt idx="409">1279500</cx:pt>
          <cx:pt idx="410">2067756</cx:pt>
          <cx:pt idx="411">788368</cx:pt>
          <cx:pt idx="412">826735</cx:pt>
          <cx:pt idx="413">451203</cx:pt>
          <cx:pt idx="414">905209</cx:pt>
          <cx:pt idx="415">970768</cx:pt>
          <cx:pt idx="416">501253</cx:pt>
          <cx:pt idx="417">196049</cx:pt>
          <cx:pt idx="418">1998422</cx:pt>
          <cx:pt idx="419">357203</cx:pt>
          <cx:pt idx="420">235962</cx:pt>
          <cx:pt idx="421">46576</cx:pt>
          <cx:pt idx="422">0</cx:pt>
          <cx:pt idx="423">182112</cx:pt>
          <cx:pt idx="424">270107</cx:pt>
          <cx:pt idx="425">1143923</cx:pt>
          <cx:pt idx="426">733083</cx:pt>
          <cx:pt idx="427">1882003</cx:pt>
          <cx:pt idx="428">698780</cx:pt>
          <cx:pt idx="429">810512</cx:pt>
          <cx:pt idx="430">401239</cx:pt>
          <cx:pt idx="431">896083</cx:pt>
          <cx:pt idx="432">1501890</cx:pt>
          <cx:pt idx="433">1468280</cx:pt>
          <cx:pt idx="434">725588</cx:pt>
          <cx:pt idx="435">2187418</cx:pt>
          <cx:pt idx="436">874666</cx:pt>
          <cx:pt idx="437">407480</cx:pt>
          <cx:pt idx="438">1574913</cx:pt>
          <cx:pt idx="439">670817</cx:pt>
          <cx:pt idx="440">806161</cx:pt>
          <cx:pt idx="441">699569</cx:pt>
          <cx:pt idx="442">911560</cx:pt>
          <cx:pt idx="443">2452100</cx:pt>
          <cx:pt idx="444">2053297</cx:pt>
          <cx:pt idx="445">804974</cx:pt>
          <cx:pt idx="446">425820</cx:pt>
          <cx:pt idx="447">640127</cx:pt>
          <cx:pt idx="448">602793</cx:pt>
          <cx:pt idx="449">529053</cx:pt>
          <cx:pt idx="450">1918154</cx:pt>
          <cx:pt idx="451">486385</cx:pt>
          <cx:pt idx="452">211930</cx:pt>
          <cx:pt idx="453">1096342</cx:pt>
          <cx:pt idx="454">804183</cx:pt>
          <cx:pt idx="455">434799</cx:pt>
          <cx:pt idx="456">1582226</cx:pt>
          <cx:pt idx="457">3200379</cx:pt>
          <cx:pt idx="458">605542</cx:pt>
          <cx:pt idx="459">349026</cx:pt>
          <cx:pt idx="460">548254</cx:pt>
          <cx:pt idx="461">1018542</cx:pt>
          <cx:pt idx="462">1276686</cx:pt>
          <cx:pt idx="463">208831</cx:pt>
          <cx:pt idx="464">343576</cx:pt>
          <cx:pt idx="465">395390</cx:pt>
          <cx:pt idx="466">1039268</cx:pt>
          <cx:pt idx="467">468398</cx:pt>
          <cx:pt idx="468">666093</cx:pt>
          <cx:pt idx="469">46576</cx:pt>
          <cx:pt idx="470">239840</cx:pt>
          <cx:pt idx="471">557271</cx:pt>
          <cx:pt idx="472">636588</cx:pt>
          <cx:pt idx="473">587088</cx:pt>
          <cx:pt idx="474">1707639</cx:pt>
          <cx:pt idx="475">67386</cx:pt>
          <cx:pt idx="476">224719</cx:pt>
          <cx:pt idx="477">249538</cx:pt>
          <cx:pt idx="478">640914</cx:pt>
          <cx:pt idx="479">1476780</cx:pt>
          <cx:pt idx="480">649567</cx:pt>
          <cx:pt idx="481">896083</cx:pt>
          <cx:pt idx="482">450031</cx:pt>
          <cx:pt idx="483">242943</cx:pt>
          <cx:pt idx="484">583163</cx:pt>
          <cx:pt idx="485">127203</cx:pt>
          <cx:pt idx="486">410991</cx:pt>
          <cx:pt idx="487">1459783</cx:pt>
          <cx:pt idx="488">2855643</cx:pt>
          <cx:pt idx="489">2344266</cx:pt>
          <cx:pt idx="490">573353</cx:pt>
          <cx:pt idx="491">1776685</cx:pt>
          <cx:pt idx="492">289525</cx:pt>
          <cx:pt idx="493">370445</cx:pt>
          <cx:pt idx="494">0</cx:pt>
          <cx:pt idx="495">805370</cx:pt>
          <cx:pt idx="496">2498617</cx:pt>
          <cx:pt idx="497">991460</cx:pt>
          <cx:pt idx="498">460581</cx:pt>
          <cx:pt idx="499">1916509</cx:pt>
          <cx:pt idx="500">522786</cx:pt>
          <cx:pt idx="501">1482448</cx:pt>
          <cx:pt idx="502">642094</cx:pt>
          <cx:pt idx="503">457064</cx:pt>
          <cx:pt idx="504">1131921</cx:pt>
          <cx:pt idx="505">998228</cx:pt>
          <cx:pt idx="506">1678680</cx:pt>
          <cx:pt idx="507">1063600</cx:pt>
          <cx:pt idx="508">1130721</cx:pt>
          <cx:pt idx="509">1534322</cx:pt>
          <cx:pt idx="510">265448</cx:pt>
          <cx:pt idx="511">1120323</cx:pt>
          <cx:pt idx="512">301182</cx:pt>
          <cx:pt idx="513">1455738</cx:pt>
          <cx:pt idx="514">529445</cx:pt>
          <cx:pt idx="515">475826</cx:pt>
          <cx:pt idx="516">864756</cx:pt>
          <cx:pt idx="517">1069986</cx:pt>
          <cx:pt idx="518">678297</cx:pt>
          <cx:pt idx="519">516520</cx:pt>
          <cx:pt idx="520">330735</cx:pt>
          <cx:pt idx="521">2962425</cx:pt>
          <cx:pt idx="522">456673</cx:pt>
          <cx:pt idx="523">627939</cx:pt>
          <cx:pt idx="524">501644</cx:pt>
          <cx:pt idx="525">767426</cx:pt>
          <cx:pt idx="526">526311</cx:pt>
          <cx:pt idx="527">697598</cx:pt>
          <cx:pt idx="528">2841633</cx:pt>
          <cx:pt idx="529">375510</cx:pt>
          <cx:pt idx="530">1064398</cx:pt>
          <cx:pt idx="531">0</cx:pt>
          <cx:pt idx="532">158125</cx:pt>
          <cx:pt idx="533">2697686</cx:pt>
          <cx:pt idx="534">823964</cx:pt>
          <cx:pt idx="535">565899</cx:pt>
          <cx:pt idx="536">3865936</cx:pt>
          <cx:pt idx="537">888545</cx:pt>
          <cx:pt idx="538">1119523</cx:pt>
          <cx:pt idx="539">1043255</cx:pt>
          <cx:pt idx="540">457064</cx:pt>
          <cx:pt idx="541">790740</cx:pt>
          <cx:pt idx="542">800229</cx:pt>
          <cx:pt idx="543">857227</cx:pt>
          <cx:pt idx="544">627939</cx:pt>
          <cx:pt idx="545">1622478</cx:pt>
          <cx:pt idx="546">425039</cx:pt>
          <cx:pt idx="547">331902</cx:pt>
          <cx:pt idx="548">227433</cx:pt>
          <cx:pt idx="549">1626547</cx:pt>
          <cx:pt idx="550">394610</cx:pt>
          <cx:pt idx="551">853662</cx:pt>
          <cx:pt idx="552">538456</cx:pt>
          <cx:pt idx="553">1213638</cx:pt>
          <cx:pt idx="554">396560</cx:pt>
          <cx:pt idx="555">2064037</cx:pt>
          <cx:pt idx="556">579238</cx:pt>
          <cx:pt idx="557">370056</cx:pt>
          <cx:pt idx="558">1117524</cx:pt>
          <cx:pt idx="559">1780367</cx:pt>
          <cx:pt idx="560">798647</cx:pt>
          <cx:pt idx="561">991460</cx:pt>
          <cx:pt idx="562">636588</cx:pt>
          <cx:pt idx="563">2100003</cx:pt>
          <cx:pt idx="564">920692</cx:pt>
          <cx:pt idx="565">686174</cx:pt>
          <cx:pt idx="566">2038846</cx:pt>
          <cx:pt idx="567">928237</cx:pt>
          <cx:pt idx="568">283310</cx:pt>
          <cx:pt idx="569">704298</cx:pt>
          <cx:pt idx="570">2109933</cx:pt>
          <cx:pt idx="571">1120323</cx:pt>
          <cx:pt idx="572">578846</cx:pt>
          <cx:pt idx="573">420356</cx:pt>
          <cx:pt idx="574">1560700</cx:pt>
          <cx:pt idx="575">960030</cx:pt>
          <cx:pt idx="576">1362040</cx:pt>
          <cx:pt idx="577">926252</cx:pt>
          <cx:pt idx="578">0</cx:pt>
          <cx:pt idx="579">150005</cx:pt>
          <cx:pt idx="580">1536756</cx:pt>
          <cx:pt idx="581">2294665</cx:pt>
          <cx:pt idx="582">1660749</cx:pt>
          <cx:pt idx="583">1879129</cx:pt>
          <cx:pt idx="584">672785</cx:pt>
          <cx:pt idx="585">953669</cx:pt>
          <cx:pt idx="586">618114</cx:pt>
          <cx:pt idx="587">965598</cx:pt>
          <cx:pt idx="588">893702</cx:pt>
          <cx:pt idx="589">772956</cx:pt>
          <cx:pt idx="590">457845</cx:pt>
          <cx:pt idx="591">1153129</cx:pt>
          <cx:pt idx="592">821194</cx:pt>
          <cx:pt idx="593">269719</cx:pt>
          <cx:pt idx="594">944527</cx:pt>
          <cx:pt idx="595">0</cx:pt>
          <cx:pt idx="596">698780</cx:pt>
          <cx:pt idx="597">1094744</cx:pt>
          <cx:pt idx="598">1404005</cx:pt>
          <cx:pt idx="599">1455738</cx:pt>
          <cx:pt idx="600">1737443</cx:pt>
          <cx:pt idx="601">848116</cx:pt>
          <cx:pt idx="602">1115125</cx:pt>
          <cx:pt idx="603">1096741</cx:pt>
          <cx:pt idx="604">46961</cx:pt>
          <cx:pt idx="605">242555</cx:pt>
          <cx:pt idx="606">50429</cx:pt>
          <cx:pt idx="607">1790596</cx:pt>
          <cx:pt idx="608">574137</cx:pt>
          <cx:pt idx="609">884183</cx:pt>
          <cx:pt idx="610">527486</cx:pt>
          <cx:pt idx="611">967984</cx:pt>
          <cx:pt idx="612">49658</cx:pt>
          <cx:pt idx="613">1866817</cx:pt>
          <cx:pt idx="614">189080</cx:pt>
          <cx:pt idx="615">668848</cx:pt>
          <cx:pt idx="616">1232899</cx:pt>
          <cx:pt idx="617">681448</cx:pt>
          <cx:pt idx="618">780859</cx:pt>
          <cx:pt idx="619">1161937</cx:pt>
          <cx:pt idx="620">482083</cx:pt>
          <cx:pt idx="621">87440</cx:pt>
          <cx:pt idx="622">682629</cx:pt>
          <cx:pt idx="623">105192</cx:pt>
          <cx:pt idx="624">1412486</cx:pt>
          <cx:pt idx="625">245658</cx:pt>
          <cx:pt idx="626">950886</cx:pt>
          <cx:pt idx="627">1424606</cx:pt>
          <cx:pt idx="628">2917707</cx:pt>
          <cx:pt idx="629">2239329</cx:pt>
          <cx:pt idx="630">722039</cx:pt>
          <cx:pt idx="631">1061206</cx:pt>
          <cx:pt idx="632">839403</cx:pt>
          <cx:pt idx="633">482083</cx:pt>
          <cx:pt idx="634">825547</cx:pt>
          <cx:pt idx="635">0</cx:pt>
          <cx:pt idx="636">2787357</cx:pt>
          <cx:pt idx="637">56209</cx:pt>
          <cx:pt idx="638">927046</cx:pt>
          <cx:pt idx="639">531795</cx:pt>
          <cx:pt idx="640">317121</cx:pt>
          <cx:pt idx="641">1046845</cx:pt>
          <cx:pt idx="642">735056</cx:pt>
          <cx:pt idx="643">1193988</cx:pt>
          <cx:pt idx="644">278261</cx:pt>
          <cx:pt idx="645">1543247</cx:pt>
          <cx:pt idx="646">851681</cx:pt>
          <cx:pt idx="647">150005</cx:pt>
          <cx:pt idx="648">1269049</cx:pt>
          <cx:pt idx="649">532579</cx:pt>
          <cx:pt idx="650">2197792</cx:pt>
          <cx:pt idx="651">1751744</cx:pt>
          <cx:pt idx="652">1088752</cx:pt>
          <cx:pt idx="653">1270656</cx:pt>
          <cx:pt idx="654">389541</cx:pt>
          <cx:pt idx="655">261567</cx:pt>
          <cx:pt idx="656">823569</cx:pt>
          <cx:pt idx="657">85511</cx:pt>
          <cx:pt idx="658">1229688</cx:pt>
          <cx:pt idx="659">911957</cx:pt>
          <cx:pt idx="660">1872972</cx:pt>
          <cx:pt idx="661">236738</cx:pt>
          <cx:pt idx="662">1915687</cx:pt>
          <cx:pt idx="663">1510400</cx:pt>
          <cx:pt idx="664">412942</cx:pt>
          <cx:pt idx="665">630691</cx:pt>
          <cx:pt idx="666">685386</cx:pt>
          <cx:pt idx="667">487168</cx:pt>
          <cx:pt idx="668">414893</cx:pt>
          <cx:pt idx="669">779673</cx:pt>
          <cx:pt idx="670">473089</cx:pt>
          <cx:pt idx="671">492644</cx:pt>
          <cx:pt idx="672">685386</cx:pt>
          <cx:pt idx="673">329179</cx:pt>
          <cx:pt idx="674">1137921</cx:pt>
          <cx:pt idx="675">861982</cx:pt>
          <cx:pt idx="676">527878</cx:pt>
          <cx:pt idx="677">116775</cx:pt>
          <cx:pt idx="678">242943</cx:pt>
          <cx:pt idx="679">645633</cx:pt>
          <cx:pt idx="680">846928</cx:pt>
          <cx:pt idx="681">1202809</cx:pt>
          <cx:pt idx="682">465662</cx:pt>
          <cx:pt idx="683">602793</cx:pt>
          <cx:pt idx="684">59677</cx:pt>
          <cx:pt idx="685">927840</cx:pt>
          <cx:pt idx="686">623616</cx:pt>
          <cx:pt idx="687">1056817</cx:pt>
          <cx:pt idx="688">1976583</cx:pt>
          <cx:pt idx="689">51585</cx:pt>
          <cx:pt idx="690">396949</cx:pt>
          <cx:pt idx="691">1093545</cx:pt>
          <cx:pt idx="692">326067</cx:pt>
          <cx:pt idx="693">381356</cx:pt>
          <cx:pt idx="694">806556</cx:pt>
          <cx:pt idx="695">742553</cx:pt>
          <cx:pt idx="696">14619</cx:pt>
          <cx:pt idx="697">137636</cx:pt>
          <cx:pt idx="698">2627245</cx:pt>
          <cx:pt idx="699">1191984</cx:pt>
          <cx:pt idx="700">56979</cx:pt>
          <cx:pt idx="701">2159632</cx:pt>
          <cx:pt idx="702">3646010</cx:pt>
          <cx:pt idx="703">0</cx:pt>
          <cx:pt idx="704">1417737</cx:pt>
          <cx:pt idx="705">82040</cx:pt>
          <cx:pt idx="706">2783545</cx:pt>
          <cx:pt idx="707">1220859</cx:pt>
          <cx:pt idx="708">696416</cx:pt>
          <cx:pt idx="709">1740303</cx:pt>
          <cx:pt idx="710">1358815</cx:pt>
          <cx:pt idx="711">1456142</cx:pt>
          <cx:pt idx="712">1618409</cx:pt>
          <cx:pt idx="713">3279560</cx:pt>
          <cx:pt idx="714">15004</cx:pt>
          <cx:pt idx="715">1587102</cx:pt>
          <cx:pt idx="716">1179961</cx:pt>
          <cx:pt idx="717">790344</cx:pt>
          <cx:pt idx="718">691295</cx:pt>
          <cx:pt idx="719">351751</cx:pt>
          <cx:pt idx="720">1102735</cx:pt>
          <cx:pt idx="721">820007</cx:pt>
          <cx:pt idx="722">302737</cx:pt>
          <cx:pt idx="723">302737</cx:pt>
          <cx:pt idx="724">1750518</cx:pt>
          <cx:pt idx="725">616149</cx:pt>
          <cx:pt idx="726">372393</cx:pt>
          <cx:pt idx="727">1855740</cx:pt>
          <cx:pt idx="728">1544059</cx:pt>
          <cx:pt idx="729">1324566</cx:pt>
          <cx:pt idx="730">2509944</cx:pt>
          <cx:pt idx="731">837819</cx:pt>
          <cx:pt idx="732">441828</cx:pt>
          <cx:pt idx="733">511822</cx:pt>
          <cx:pt idx="734">254582</cx:pt>
          <cx:pt idx="735">482083</cx:pt>
          <cx:pt idx="736">3920961</cx:pt>
          <cx:pt idx="737">1079966</cx:pt>
          <cx:pt idx="738">651927</cx:pt>
          <cx:pt idx="739">1336649</cx:pt>
          <cx:pt idx="740">432066</cx:pt>
          <cx:pt idx="741">744921</cx:pt>
          <cx:pt idx="742">1306853</cx:pt>
          <cx:pt idx="743">641700</cx:pt>
          <cx:pt idx="744">432456</cx:pt>
          <cx:pt idx="745">1636721</cx:pt>
          <cx:pt idx="746">308179</cx:pt>
          <cx:pt idx="747">186370</cx:pt>
          <cx:pt idx="748">721250</cx:pt>
          <cx:pt idx="749">1737443</cx:pt>
          <cx:pt idx="750">963212</cx:pt>
          <cx:pt idx="751">314399</cx:pt>
          <cx:pt idx="752">1935423</cx:pt>
          <cx:pt idx="753">1384629</cx:pt>
          <cx:pt idx="754">65073</cx:pt>
          <cx:pt idx="755">1180362</cx:pt>
          <cx:pt idx="756">478954</cx:pt>
          <cx:pt idx="757">1275078</cx:pt>
          <cx:pt idx="758">876648</cx:pt>
          <cx:pt idx="759">759922</cx:pt>
          <cx:pt idx="760">991062</cx:pt>
          <cx:pt idx="761">1475566</cx:pt>
          <cx:pt idx="762">252254</cx:pt>
          <cx:pt idx="763">1245345</cx:pt>
          <cx:pt idx="764">985092</cx:pt>
          <cx:pt idx="765">1375349</cx:pt>
          <cx:pt idx="766">1790596</cx:pt>
          <cx:pt idx="767">1460997</cx:pt>
          <cx:pt idx="768">1049238</cx:pt>
          <cx:pt idx="769">561977</cx:pt>
          <cx:pt idx="770">330735</cx:pt>
          <cx:pt idx="771">1026511</cx:pt>
          <cx:pt idx="772">4391387</cx:pt>
          <cx:pt idx="773">1170347</cx:pt>
          <cx:pt idx="774">347469</cx:pt>
          <cx:pt idx="775">79725</cx:pt>
          <cx:pt idx="776">3429913</cx:pt>
          <cx:pt idx="777">859209</cx:pt>
          <cx:pt idx="778">84740</cx:pt>
          <cx:pt idx="779">1427435</cx:pt>
          <cx:pt idx="780">234024</cx:pt>
          <cx:pt idx="781">3092286</cx:pt>
          <cx:pt idx="782">1448457</cx:pt>
          <cx:pt idx="783">767031</cx:pt>
          <cx:pt idx="784">2087183</cx:pt>
          <cx:pt idx="785">1248157</cx:pt>
          <cx:pt idx="786">455110</cx:pt>
          <cx:pt idx="787">848908</cx:pt>
          <cx:pt idx="788">1722741</cx:pt>
          <cx:pt idx="789">59677</cx:pt>
          <cx:pt idx="790">339684</cx:pt>
          <cx:pt idx="791">1432285</cx:pt>
          <cx:pt idx="792">625581</cx:pt>
          <cx:pt idx="793">77411</cx:pt>
          <cx:pt idx="794">303126</cx:pt>
          <cx:pt idx="795">454328</cx:pt>
          <cx:pt idx="796">1970817</cx:pt>
          <cx:pt idx="797">1013761</cx:pt>
          <cx:pt idx="798">347858</cx:pt>
          <cx:pt idx="799">1120323</cx:pt>
          <cx:pt idx="800">716912</cx:pt>
          <cx:pt idx="801">3106418</cx:pt>
          <cx:pt idx="802">3202098</cx:pt>
          <cx:pt idx="803">743342</cx:pt>
          <cx:pt idx="804">2378078</cx:pt>
          <cx:pt idx="805">1125121</cx:pt>
          <cx:pt idx="806">1237716</cx:pt>
          <cx:pt idx="807">1870920</cx:pt>
          <cx:pt idx="808">819611</cx:pt>
          <cx:pt idx="809">642094</cx:pt>
          <cx:pt idx="810">1373333</cx:pt>
          <cx:pt idx="811">2758141</cx:pt>
          <cx:pt idx="812">204570</cx:pt>
          <cx:pt idx="813">956452</cx:pt>
          <cx:pt idx="814">510647</cx:pt>
          <cx:pt idx="815">771771</cx:pt>
          <cx:pt idx="816">627153</cx:pt>
          <cx:pt idx="817">1050035</cx:pt>
          <cx:pt idx="818">1489737</cx:pt>
          <cx:pt idx="819">1071583</cx:pt>
          <cx:pt idx="820">942937</cx:pt>
          <cx:pt idx="821">307401</cx:pt>
          <cx:pt idx="822">686568</cx:pt>
          <cx:pt idx="823">197986</cx:pt>
          <cx:pt idx="824">791530</cx:pt>
          <cx:pt idx="825">519261</cx:pt>
          <cx:pt idx="826">1058812</cx:pt>
          <cx:pt idx="827">657042</cx:pt>
          <cx:pt idx="828">1689689</cx:pt>
          <cx:pt idx="829">87054</cx:pt>
          <cx:pt idx="830">273213</cx:pt>
          <cx:pt idx="831">239840</cx:pt>
          <cx:pt idx="832">1135121</cx:pt>
          <cx:pt idx="833">464098</cx:pt>
          <cx:pt idx="834">1410063</cx:pt>
          <cx:pt idx="835">1856560</cx:pt>
          <cx:pt idx="836">88597</cx:pt>
          <cx:pt idx="837">1950646</cx:pt>
          <cx:pt idx="838">171277</cx:pt>
          <cx:pt idx="839">68157</cx:pt>
          <cx:pt idx="840">1742754</cx:pt>
          <cx:pt idx="841">2832722</cx:pt>
          <cx:pt idx="842">686568</cx:pt>
          <cx:pt idx="843">275154</cx:pt>
          <cx:pt idx="844">315177</cx:pt>
          <cx:pt idx="845">975940</cx:pt>
          <cx:pt idx="846">1241731</cx:pt>
          <cx:pt idx="847">426210</cx:pt>
          <cx:pt idx="848">2031830</cx:pt>
          <cx:pt idx="849">462926</cx:pt>
          <cx:pt idx="850">663338</cx:pt>
          <cx:pt idx="851">1054024</cx:pt>
          <cx:pt idx="852">618507</cx:pt>
          <cx:pt idx="853">618114</cx:pt>
          <cx:pt idx="854">990664</cx:pt>
          <cx:pt idx="855">1677457</cx:pt>
          <cx:pt idx="856">663338</cx:pt>
          <cx:pt idx="857">2461313</cx:pt>
          <cx:pt idx="858">1424606</cx:pt>
          <cx:pt idx="859">1159534</cx:pt>
          <cx:pt idx="860">477390</cx:pt>
          <cx:pt idx="861">627153</cx:pt>
          <cx:pt idx="862">14619</cx:pt>
          <cx:pt idx="863">377069</cx:pt>
          <cx:pt idx="864">277873</cx:pt>
          <cx:pt idx="865">80883</cx:pt>
          <cx:pt idx="866">576492</cx:pt>
          <cx:pt idx="867">526311</cx:pt>
          <cx:pt idx="868">267778</cx:pt>
          <cx:pt idx="869">839403</cx:pt>
          <cx:pt idx="870">2757718</cx:pt>
          <cx:pt idx="871">599259</cx:pt>
          <cx:pt idx="872">242168</cx:pt>
          <cx:pt idx="873">694052</cx:pt>
          <cx:pt idx="874">518478</cx:pt>
          <cx:pt idx="875">842967</cx:pt>
          <cx:pt idx="876">400459</cx:pt>
          <cx:pt idx="877">33096</cx:pt>
          <cx:pt idx="878">742158</cx:pt>
          <cx:pt idx="879">481301</cx:pt>
          <cx:pt idx="880">1563542</cx:pt>
          <cx:pt idx="881">1145524</cx:pt>
          <cx:pt idx="882">340074</cx:pt>
          <cx:pt idx="883">111755</cx:pt>
          <cx:pt idx="884">562762</cx:pt>
          <cx:pt idx="885">139568</cx:pt>
          <cx:pt idx="886">881407</cx:pt>
          <cx:pt idx="887">341241</cx:pt>
          <cx:pt idx="888">490297</cx:pt>
          <cx:pt idx="889">1463829</cx:pt>
          <cx:pt idx="890">1141923</cx:pt>
          <cx:pt idx="891">956452</cx:pt>
          <cx:pt idx="892">453547</cx:pt>
          <cx:pt idx="893">1854510</cx:pt>
          <cx:pt idx="894">1570445</cx:pt>
          <cx:pt idx="895">1114326</cx:pt>
          <cx:pt idx="896">3432513</cx:pt>
          <cx:pt idx="897">1065596</cx:pt>
          <cx:pt idx="898">308179</cx:pt>
          <cx:pt idx="899">1064398</cx:pt>
          <cx:pt idx="900">921089</cx:pt>
          <cx:pt idx="901">233248</cx:pt>
          <cx:pt idx="902">748078</cx:pt>
          <cx:pt idx="903">1218853</cx:pt>
          <cx:pt idx="904">75098</cx:pt>
          <cx:pt idx="905">2375572</cx:pt>
          <cx:pt idx="906">1538379</cx:pt>
          <cx:pt idx="907">872288</cx:pt>
          <cx:pt idx="908">1971229</cx:pt>
          <cx:pt idx="909">825943</cx:pt>
          <cx:pt idx="910">405530</cx:pt>
          <cx:pt idx="911">446906</cx:pt>
          <cx:pt idx="912">479736</cx:pt>
          <cx:pt idx="913">343576</cx:pt>
          <cx:pt idx="914">1039268</cx:pt>
          <cx:pt idx="915">745710</cx:pt>
          <cx:pt idx="916">431675</cx:pt>
          <cx:pt idx="917">1351962</cx:pt>
          <cx:pt idx="918">1109529</cx:pt>
          <cx:pt idx="919">334237</cx:pt>
          <cx:pt idx="920">610649</cx:pt>
          <cx:pt idx="921">469571</cx:pt>
          <cx:pt idx="922">450031</cx:pt>
          <cx:pt idx="923">1264226</cx:pt>
          <cx:pt idx="924">1307256</cx:pt>
          <cx:pt idx="925">1131121</cx:pt>
          <cx:pt idx="926">0</cx:pt>
          <cx:pt idx="927">544726</cx:pt>
          <cx:pt idx="960">828318</cx:pt>
          <cx:pt idx="961">2364715</cx:pt>
          <cx:pt idx="962">571783</cx:pt>
          <cx:pt idx="963">134930</cx:pt>
          <cx:pt idx="964">134930</cx:pt>
          <cx:pt idx="965">0</cx:pt>
          <cx:pt idx="966">1002608</cx:pt>
          <cx:pt idx="967">856039</cx:pt>
          <cx:pt idx="968">521611</cx:pt>
          <cx:pt idx="969">718095</cx:pt>
          <cx:pt idx="970">900447</cx:pt>
          <cx:pt idx="971">480127</cx:pt>
          <cx:pt idx="972">1809428</cx:pt>
          <cx:pt idx="973">1239724</cx:pt>
          <cx:pt idx="974">0</cx:pt>
          <cx:pt idx="975">589051</cx:pt>
          <cx:pt idx="976">540023</cx:pt>
          <cx:pt idx="977">0</cx:pt>
          <cx:pt idx="978">1773413</cx:pt>
          <cx:pt idx="979">1927198</cx:pt>
          <cx:pt idx="980">445343</cx:pt>
          <cx:pt idx="981">823173</cx:pt>
          <cx:pt idx="982">1267441</cx:pt>
          <cx:pt idx="983">31556</cx:pt>
          <cx:pt idx="984">418795</cx:pt>
          <cx:pt idx="985">1022925</cx:pt>
          <cx:pt idx="986">1699070</cx:pt>
          <cx:pt idx="987">1341484</cx:pt>
          <cx:pt idx="988">1602954</cx:pt>
          <cx:pt idx="989">1827452</cx:pt>
          <cx:pt idx="990">996238</cx:pt>
          <cx:pt idx="991">840987</cx:pt>
          <cx:pt idx="992">1746431</cx:pt>
          <cx:pt idx="993">735056</cx:pt>
          <cx:pt idx="994">1711720</cx:pt>
          <cx:pt idx="995">423478</cx:pt>
          <cx:pt idx="996">221231</cx:pt>
          <cx:pt idx="997">618114</cx:pt>
          <cx:pt idx="998">172824</cx:pt>
          <cx:pt idx="999">340074</cx:pt>
          <cx:pt idx="1000">1879129</cx:pt>
          <cx:pt idx="1001">272048</cx:pt>
          <cx:pt idx="1002">1077970</cx:pt>
          <cx:pt idx="1003">476217</cx:pt>
          <cx:pt idx="1004">271660</cx:pt>
          <cx:pt idx="1005">67386</cx:pt>
          <cx:pt idx="1006">2835692</cx:pt>
          <cx:pt idx="1007">137636</cx:pt>
          <cx:pt idx="1008">679085</cx:pt>
          <cx:pt idx="1009">733872</cx:pt>
          <cx:pt idx="1010">299628</cx:pt>
          <cx:pt idx="1011">525919</cx:pt>
          <cx:pt idx="1012">1263824</cx:pt>
          <cx:pt idx="1013">1611088</cx:pt>
          <cx:pt idx="1014">416453</cx:pt>
          <cx:pt idx="1015">476217</cx:pt>
          <cx:pt idx="1016">340074</cx:pt>
          <cx:pt idx="1017">528269</cx:pt>
          <cx:pt idx="1018">2011203</cx:pt>
          <cx:pt idx="1019">1392701</cx:pt>
          <cx:pt idx="1020">439485</cx:pt>
          <cx:pt idx="1021">221231</cx:pt>
          <cx:pt idx="1022">132612</cx:pt>
          <cx:pt idx="1023">662551</cx:pt>
          <cx:pt idx="1024">1401986</cx:pt>
          <cx:pt idx="1025">785206</cx:pt>
          <cx:pt idx="1026">558840</cx:pt>
          <cx:pt idx="1027">602793</cx:pt>
          <cx:pt idx="1028">1240928</cx:pt>
          <cx:pt idx="1029">0</cx:pt>
          <cx:pt idx="1030">535321</cx:pt>
          <cx:pt idx="1031">539240</cx:pt>
          <cx:pt idx="1032">695234</cx:pt>
          <cx:pt idx="1033">887752</cx:pt>
          <cx:pt idx="1034">1518507</cx:pt>
          <cx:pt idx="1035">874270</cx:pt>
          <cx:pt idx="1036">222006</cx:pt>
          <cx:pt idx="1037">820403</cx:pt>
          <cx:pt idx="1038">1309268</cx:pt>
          <cx:pt idx="1039">630691</cx:pt>
          <cx:pt idx="1040">221618</cx:pt>
          <cx:pt idx="1041">2297164</cx:pt>
          <cx:pt idx="1042">405920</cx:pt>
          <cx:pt idx="1043">725194</cx:pt>
          <cx:pt idx="1044">632263</cx:pt>
          <cx:pt idx="1045">1163539</cx:pt>
          <cx:pt idx="1046">1006591</cx:pt>
          <cx:pt idx="1047">1297196</cx:pt>
          <cx:pt idx="1048">486385</cx:pt>
          <cx:pt idx="1049">1101536</cx:pt>
          <cx:pt idx="1050">0</cx:pt>
          <cx:pt idx="1051">334626</cx:pt>
          <cx:pt idx="1052">439485</cx:pt>
          <cx:pt idx="1053">445734</cx:pt>
          <cx:pt idx="1054">2200283</cx:pt>
          <cx:pt idx="1055">977929</cx:pt>
          <cx:pt idx="1056">1024120</cx:pt>
          <cx:pt idx="1057">3121414</cx:pt>
          <cx:pt idx="1058">418795</cx:pt>
          <cx:pt idx="1059">395780</cx:pt>
          <cx:pt idx="1060">137636</cx:pt>
          <cx:pt idx="1061">624402</cx:pt>
          <cx:pt idx="1062">224332</cx:pt>
          <cx:pt idx="1063">908782</cx:pt>
          <cx:pt idx="1064">411381</cx:pt>
          <cx:pt idx="1065">2038434</cx:pt>
          <cx:pt idx="1066">277873</cx:pt>
          <cx:pt idx="1067">237514</cx:pt>
          <cx:pt idx="1068">0</cx:pt>
          <cx:pt idx="1069">191790</cx:pt>
          <cx:pt idx="1070">333069</cx:pt>
          <cx:pt idx="1071">942143</cx:pt>
          <cx:pt idx="1072">464098</cx:pt>
          <cx:pt idx="1073">2685441</cx:pt>
          <cx:pt idx="1074">304292</cx:pt>
          <cx:pt idx="1075">541199</cx:pt>
          <cx:pt idx="1076">133771</cx:pt>
          <cx:pt idx="1077">390711</cx:pt>
          <cx:pt idx="1078">673966</cx:pt>
          <cx:pt idx="1079">336571</cx:pt>
          <cx:pt idx="1080">976338</cx:pt>
          <cx:pt idx="1081">1505942</cx:pt>
          <cx:pt idx="1082">837423</cx:pt>
          <cx:pt idx="1083">571391</cx:pt>
          <cx:pt idx="1084">665700</cx:pt>
          <cx:pt idx="1085">940156</cx:pt>
          <cx:pt idx="1086">303903</cx:pt>
          <cx:pt idx="1087">118705</cx:pt>
          <cx:pt idx="1088">176307</cx:pt>
          <cx:pt idx="1089">1020534</cx:pt>
          <cx:pt idx="1090">0</cx:pt>
          <cx:pt idx="1091">951284</cx:pt>
          <cx:pt idx="1092">565507</cx:pt>
          <cx:pt idx="1093">65073</cx:pt>
          <cx:pt idx="1094">823569</cx:pt>
          <cx:pt idx="1095">363434</cx:pt>
          <cx:pt idx="1096">564330</cx:pt>
          <cx:pt idx="1097">626760</cx:pt>
          <cx:pt idx="1098">1217649</cx:pt>
          <cx:pt idx="1099">791926</cx:pt>
          <cx:pt idx="1100">1026113</cx:pt>
          <cx:pt idx="1101">924266</cx:pt>
          <cx:pt idx="1102">471134</cx:pt>
          <cx:pt idx="1103">543159</cx:pt>
          <cx:pt idx="1104">477781</cx:pt>
          <cx:pt idx="1105">63146</cx:pt>
          <cx:pt idx="1106">407870</cx:pt>
          <cx:pt idx="1107">1513642</cx:pt>
          <cx:pt idx="1108">390321</cx:pt>
          <cx:pt idx="1109">473871</cx:pt>
          <cx:pt idx="1110">3487150</cx:pt>
          <cx:pt idx="1111">425429</cx:pt>
          <cx:pt idx="1112">1578975</cx:pt>
          <cx:pt idx="1113">94771</cx:pt>
          <cx:pt idx="1114">1351559</cx:pt>
          <cx:pt idx="1115">1524183</cx:pt>
          <cx:pt idx="1116">635802</cx:pt>
          <cx:pt idx="1117">135317</cx:pt>
          <cx:pt idx="1118">334237</cx:pt>
          <cx:pt idx="1119">577669</cx:pt>
          <cx:pt idx="1120">765056</cx:pt>
          <cx:pt idx="1121">566684</cx:pt>
          <cx:pt idx="1122">1346722</cx:pt>
          <cx:pt idx="1123">244107</cx:pt>
          <cx:pt idx="1124">403579</cx:pt>
          <cx:pt idx="1125">1598076</cx:pt>
          <cx:pt idx="1126">1311280</cx:pt>
          <cx:pt idx="1127">0</cx:pt>
          <cx:pt idx="1128">66230</cx:pt>
          <cx:pt idx="1129">129907</cx:pt>
          <cx:pt idx="1130">68543</cx:pt>
          <cx:pt idx="1131">396560</cx:pt>
          <cx:pt idx="1132">0</cx:pt>
          <cx:pt idx="1133">0</cx:pt>
          <cx:pt idx="1134">2232263</cx:pt>
          <cx:pt idx="1135">0</cx:pt>
          <cx:pt idx="1136">1341484</cx:pt>
          <cx:pt idx="1137">63917</cx:pt>
          <cx:pt idx="1138">182112</cx:pt>
          <cx:pt idx="1139">1431476</cx:pt>
          <cx:pt idx="1140">516128</cx:pt>
          <cx:pt idx="1141">0</cx:pt>
          <cx:pt idx="1142">251866</cx:pt>
          <cx:pt idx="1143">629512</cx:pt>
          <cx:pt idx="1144">411381</cx:pt>
          <cx:pt idx="1145">337739</cx:pt>
          <cx:pt idx="1146">673966</cx:pt>
          <cx:pt idx="1147">1503916</cx:pt>
          <cx:pt idx="1148">976338</cx:pt>
          <cx:pt idx="1149">623616</cx:pt>
          <cx:pt idx="1150">612613</cx:pt>
          <cx:pt idx="1151">871891</cx:pt>
          <cx:pt idx="1152">384084</cx:pt>
          <cx:pt idx="1153">2528411</cx:pt>
          <cx:pt idx="1154">718489</cx:pt>
          <cx:pt idx="1155">835444</cx:pt>
          <cx:pt idx="1156">446515</cx:pt>
          <cx:pt idx="1157">707057</cx:pt>
          <cx:pt idx="1158">609470</cx:pt>
          <cx:pt idx="1159">190241</cx:pt>
          <cx:pt idx="1160">1741528</cx:pt>
          <cx:pt idx="1161">2180780</cx:pt>
          <cx:pt idx="1162">1938303</cx:pt>
          <cx:pt idx="1163">2188248</cx:pt>
          <cx:pt idx="1164">831485</cx:pt>
          <cx:pt idx="1165">759133</cx:pt>
          <cx:pt idx="1166">1644457</cx:pt>
          <cx:pt idx="1167">925060</cx:pt>
          <cx:pt idx="1168">508690</cx:pt>
          <cx:pt idx="1169">412942</cx:pt>
          <cx:pt idx="1170">1018143</cx:pt>
          <cx:pt idx="1171">529836</cx:pt>
          <cx:pt idx="1172">991858</cx:pt>
          <cx:pt idx="1173">253418</cx:pt>
          <cx:pt idx="1174">536105</cx:pt>
          <cx:pt idx="1175">126431</cx:pt>
          <cx:pt idx="1176">661764</cx:pt>
          <cx:pt idx="1177">94385</cx:pt>
          <cx:pt idx="1178">1431476</cx:pt>
          <cx:pt idx="1179">1052828</cx:pt>
          <cx:pt idx="1180">57365</cx:pt>
          <cx:pt idx="1181">347858</cx:pt>
          <cx:pt idx="1182">272048</cx:pt>
          <cx:pt idx="1183">1562730</cx:pt>
          <cx:pt idx="1184">1167543</cx:pt>
          <cx:pt idx="1185">771376</cx:pt>
          <cx:pt idx="1186">2717119</cx:pt>
          <cx:pt idx="1187">840195</cx:pt>
          <cx:pt idx="1188">384474</cx:pt>
          <cx:pt idx="1189">867531</cx:pt>
          <cx:pt idx="1190">906400</cx:pt>
          <cx:pt idx="1191">197211</cx:pt>
          <cx:pt idx="1192">252642</cx:pt>
          <cx:pt idx="1193">1655453</cx:pt>
          <cx:pt idx="1194">302737</cx:pt>
          <cx:pt idx="1195">1905824</cx:pt>
          <cx:pt idx="1196">199922</cx:pt>
          <cx:pt idx="1197">635802</cx:pt>
          <cx:pt idx="1198">612220</cx:pt>
          <cx:pt idx="1199">275931</cx:pt>
          <cx:pt idx="1200">441047</cx:pt>
          <cx:pt idx="1201">974349</cx:pt>
          <cx:pt idx="1202">1240928</cx:pt>
          <cx:pt idx="1203">1315306</cx:pt>
          <cx:pt idx="1204">2430752</cx:pt>
          <cx:pt idx="1205">0</cx:pt>
          <cx:pt idx="1206">201471</cx:pt>
          <cx:pt idx="1207">0</cx:pt>
          <cx:pt idx="1208">0</cx:pt>
          <cx:pt idx="1209">0</cx:pt>
          <cx:pt idx="1210">3341248</cx:pt>
          <cx:pt idx="1211">1393912</cx:pt>
          <cx:pt idx="1212">840591</cx:pt>
          <cx:pt idx="1213">138795</cx:pt>
          <cx:pt idx="1214">197598</cx:pt>
          <cx:pt idx="1215">336571</cx:pt>
          <cx:pt idx="1216">403579</cx:pt>
          <cx:pt idx="1217">264284</cx:pt>
          <cx:pt idx="1218">695628</cx:pt>
          <cx:pt idx="1219">746499</cx:pt>
          <cx:pt idx="1220">1314098</cx:pt>
          <cx:pt idx="1221">245271</cx:pt>
          <cx:pt idx="1222">526311</cx:pt>
          <cx:pt idx="1223">172437</cx:pt>
          <cx:pt idx="1224">1297196</cx:pt>
          <cx:pt idx="1225">0</cx:pt>
          <cx:pt idx="1226">745315</cx:pt>
          <cx:pt idx="1227">1069587</cx:pt>
          <cx:pt idx="1228">2141813</cx:pt>
          <cx:pt idx="1229">331124</cx:pt>
          <cx:pt idx="1230">960826</cx:pt>
          <cx:pt idx="1231">1973700</cx:pt>
          <cx:pt idx="1232">767821</cx:pt>
          <cx:pt idx="1233">803392</cx:pt>
          <cx:pt idx="1234">815259</cx:pt>
          <cx:pt idx="1235">608292</cx:pt>
          <cx:pt idx="1236">284475</cx:pt>
          <cx:pt idx="1237">871098</cx:pt>
          <cx:pt idx="1238">1640385</cx:pt>
          <cx:pt idx="1239">1367283</cx:pt>
          <cx:pt idx="1240">1447244</cx:pt>
          <cx:pt idx="1241">854850</cx:pt>
          <cx:pt idx="1242">893702</cx:pt>
          <cx:pt idx="1243">534146</cx:pt>
          <cx:pt idx="1244">317510</cx:pt>
          <cx:pt idx="1245">1017745</cx:pt>
          <cx:pt idx="1246">758343</cx:pt>
          <cx:pt idx="1247">818424</cx:pt>
          <cx:pt idx="1248">1902127</cx:pt>
          <cx:pt idx="1249">843759</cx:pt>
          <cx:pt idx="1250">1168745</cx:pt>
          <cx:pt idx="1251">344744</cx:pt>
          <cx:pt idx="1252">139181</cx:pt>
          <cx:pt idx="1253">2501553</cx:pt>
          <cx:pt idx="1254">854454</cx:pt>
          <cx:pt idx="1255">1137121</cx:pt>
          <cx:pt idx="1256">1271862</cx:pt>
          <cx:pt idx="1257">220456</cx:pt>
          <cx:pt idx="1258">627153</cx:pt>
          <cx:pt idx="1259">632657</cx:pt>
          <cx:pt idx="1260">977929</cx:pt>
          <cx:pt idx="1261">613006</cx:pt>
          <cx:pt idx="1262">534929</cx:pt>
          <cx:pt idx="1263">304292</cx:pt>
          <cx:pt idx="1264">554919</cx:pt>
          <cx:pt idx="1265">419965</cx:pt>
          <cx:pt idx="1266">332291</cx:pt>
          <cx:pt idx="1267">45420</cx:pt>
          <cx:pt idx="1268">522002</cx:pt>
          <cx:pt idx="1269">216968</cx:pt>
          <cx:pt idx="1270">1568415</cx:pt>
          <cx:pt idx="1271">180177</cx:pt>
          <cx:pt idx="1272">129907</cx:pt>
          <cx:pt idx="1273">273601</cx:pt>
          <cx:pt idx="1274">2666029</cx:pt>
          <cx:pt idx="1275">479736</cx:pt>
          <cx:pt idx="1276">409040</cx:pt>
          <cx:pt idx="1277">0</cx:pt>
          <cx:pt idx="1278">0</cx:pt>
          <cx:pt idx="1279">155031</cx:pt>
          <cx:pt idx="1280">68157</cx:pt>
          <cx:pt idx="1281">0</cx:pt>
          <cx:pt idx="1282">170116</cx:pt>
          <cx:pt idx="1283">206507</cx:pt>
          <cx:pt idx="1284">180564</cx:pt>
          <cx:pt idx="1285">576492</cx:pt>
          <cx:pt idx="1286">2557815</cx:pt>
          <cx:pt idx="1287">539240</cx:pt>
          <cx:pt idx="1288">433628</cx:pt>
          <cx:pt idx="1289">366160</cx:pt>
          <cx:pt idx="1290">0</cx:pt>
          <cx:pt idx="1291">1511211</cx:pt>
          <cx:pt idx="1292">964802</cx:pt>
          <cx:pt idx="1293">359539</cx:pt>
          <cx:pt idx="1294">1537567</cx:pt>
          <cx:pt idx="1295">717307</cx:pt>
          <cx:pt idx="1296">1473947</cx:pt>
          <cx:pt idx="1297">2580099</cx:pt>
          <cx:pt idx="1298">567861</cx:pt>
          <cx:pt idx="1299">221618</cx:pt>
          <cx:pt idx="1300">1642421</cx:pt>
          <cx:pt idx="1301">575315</cx:pt>
          <cx:pt idx="1302">904019</cx:pt>
          <cx:pt idx="1303">566684</cx:pt>
          <cx:pt idx="1304">126817</cx:pt>
          <cx:pt idx="1305">612220</cx:pt>
          <cx:pt idx="1306">820798</cx:pt>
          <cx:pt idx="1307">1555828</cx:pt>
          <cx:pt idx="1308">349415</cx:pt>
          <cx:pt idx="1309">1728049</cx:pt>
          <cx:pt idx="1310">294187</cx:pt>
          <cx:pt idx="1311">575707</cx:pt>
          <cx:pt idx="1312">1668490</cx:pt>
          <cx:pt idx="1313">356813</cx:pt>
          <cx:pt idx="1314">979919</cx:pt>
          <cx:pt idx="1315">1161136</cx:pt>
          <cx:pt idx="1316">447296</cx:pt>
          <cx:pt idx="1317">574530</cx:pt>
          <cx:pt idx="1318">824360</cx:pt>
          <cx:pt idx="1319">268166</cx:pt>
          <cx:pt idx="1320">541199</cx:pt>
          <cx:pt idx="1321">272436</cx:pt>
          <cx:pt idx="1322">338128</cx:pt>
          <cx:pt idx="1323">686961</cx:pt>
          <cx:pt idx="1324">457064</cx:pt>
          <cx:pt idx="1325">3534498</cx:pt>
          <cx:pt idx="1326">123727</cx:pt>
          <cx:pt idx="1327">277873</cx:pt>
          <cx:pt idx="1328">0</cx:pt>
          <cx:pt idx="1329">1127521</cx:pt>
          <cx:pt idx="1330">1446839</cx:pt>
          <cx:pt idx="1331">266613</cx:pt>
          <cx:pt idx="1332">66230</cx:pt>
          <cx:pt idx="1333">434018</cx:pt>
          <cx:pt idx="1334">814072</cx:pt>
          <cx:pt idx="1335">830297</cx:pt>
          <cx:pt idx="1336">1065995</cx:pt>
          <cx:pt idx="1337">338906</cx:pt>
          <cx:pt idx="1338">46576</cx:pt>
          <cx:pt idx="1339">344744</cx:pt>
          <cx:pt idx="1340">1219656</cx:pt>
          <cx:pt idx="1341">929429</cx:pt>
          <cx:pt idx="1342">640914</cx:pt>
          <cx:pt idx="1343">559624</cx:pt>
          <cx:pt idx="1344">484038</cx:pt>
          <cx:pt idx="1345">242168</cx:pt>
          <cx:pt idx="1346">2297580</cx:pt>
          <cx:pt idx="1347">63146</cx:pt>
          <cx:pt idx="1348">187531</cx:pt>
          <cx:pt idx="1349">393440</cx:pt>
          <cx:pt idx="1350">63917</cx:pt>
          <cx:pt idx="1351">1036876</cx:pt>
          <cx:pt idx="1352">190241</cx:pt>
          <cx:pt idx="1353">1563948</cx:pt>
          <cx:pt idx="1354">808138</cx:pt>
          <cx:pt idx="1355">224332</cx:pt>
          <cx:pt idx="1356">221618</cx:pt>
          <cx:pt idx="1357">631870</cx:pt>
          <cx:pt idx="1358">562762</cx:pt>
          <cx:pt idx="1359">660583</cx:pt>
          <cx:pt idx="1360">1896786</cx:pt>
          <cx:pt idx="1361">2032243</cx:pt>
          <cx:pt idx="1362">476999</cx:pt>
          <cx:pt idx="1363">2070648</cx:pt>
          <cx:pt idx="1364">286029</cx:pt>
          <cx:pt idx="1365">343966</cx:pt>
          <cx:pt idx="1366">1210028</cx:pt>
          <cx:pt idx="1367">571391</cx:pt>
          <cx:pt idx="1368">94385</cx:pt>
          <cx:pt idx="1369">3043947</cx:pt>
          <cx:pt idx="1370">944924</cx:pt>
          <cx:pt idx="1371">571391</cx:pt>
          <cx:pt idx="1372">2455031</cx:pt>
          <cx:pt idx="1373">543943</cx:pt>
          <cx:pt idx="1374">700357</cx:pt>
          <cx:pt idx="1375">2522534</cx:pt>
          <cx:pt idx="1376">303514</cx:pt>
          <cx:pt idx="1377">181338</cx:pt>
          <cx:pt idx="1378">187144</cx:pt>
          <cx:pt idx="1379">328790</cx:pt>
          <cx:pt idx="1380">120637</cx:pt>
          <cx:pt idx="1381">303903</cx:pt>
          <cx:pt idx="1382">531795</cx:pt>
          <cx:pt idx="1383">1289554</cx:pt>
          <cx:pt idx="1384">160832</cx:pt>
          <cx:pt idx="1385">1581007</cx:pt>
          <cx:pt idx="1386">552566</cx:pt>
          <cx:pt idx="1387">927443</cx:pt>
          <cx:pt idx="1388">1803286</cx:pt>
          <cx:pt idx="1389">1565978</cx:pt>
          <cx:pt idx="1390">454719</cx:pt>
          <cx:pt idx="1391">1134721</cx:pt>
          <cx:pt idx="1392">169342</cx:pt>
          <cx:pt idx="1393">273989</cx:pt>
          <cx:pt idx="1394">3500608</cx:pt>
          <cx:pt idx="1395">567468</cx:pt>
          <cx:pt idx="1396">150778</cx:pt>
          <cx:pt idx="1397">42724</cx:pt>
          <cx:pt idx="1398">844551</cx:pt>
          <cx:pt idx="1399">662157</cx:pt>
          <cx:pt idx="1400">221618</cx:pt>
          <cx:pt idx="1401">706662</cx:pt>
          <cx:pt idx="1402">0</cx:pt>
          <cx:pt idx="1403">888545</cx:pt>
          <cx:pt idx="1404">508690</cx:pt>
          <cx:pt idx="1405">0</cx:pt>
          <cx:pt idx="1406">1346722</cx:pt>
          <cx:pt idx="1407">1396737</cx:pt>
          <cx:pt idx="1408">759133</cx:pt>
          <cx:pt idx="1409">381356</cx:pt>
          <cx:pt idx="1410">1169145</cx:pt>
          <cx:pt idx="1411">1574913</cx:pt>
          <cx:pt idx="1412">386423</cx:pt>
          <cx:pt idx="1413">2591878</cx:pt>
          <cx:pt idx="1414">981908</cx:pt>
          <cx:pt idx="1415">215030</cx:pt>
          <cx:pt idx="1416">267389</cx:pt>
          <cx:pt idx="1417">976338</cx:pt>
          <cx:pt idx="1418">614970</cx:pt>
          <cx:pt idx="1419">2750524</cx:pt>
          <cx:pt idx="1420">1164339</cx:pt>
          <cx:pt idx="1421">2049994</cx:pt>
          <cx:pt idx="1422">486385</cx:pt>
          <cx:pt idx="1423">2855219</cx:pt>
          <cx:pt idx="1424">364213</cx:pt>
          <cx:pt idx="1425">571391</cx:pt>
          <cx:pt idx="1426">755184</cx:pt>
          <cx:pt idx="1427">1189579</cx:pt>
          <cx:pt idx="1428">316344</cx:pt>
          <cx:pt idx="1429">1268245</cx:pt>
          <cx:pt idx="1430">389931</cx:pt>
          <cx:pt idx="1431">346690</cx:pt>
          <cx:pt idx="1432">415283</cx:pt>
          <cx:pt idx="1433">566684</cx:pt>
          <cx:pt idx="1434">977929</cx:pt>
          <cx:pt idx="1435">491080</cx:pt>
          <cx:pt idx="1436">846928</cx:pt>
          <cx:pt idx="1437">1648936</cx:pt>
          <cx:pt idx="1438">1620443</cx:pt>
          <cx:pt idx="1439">629512</cx:pt>
          <cx:pt idx="1440">357203</cx:pt>
          <cx:pt idx="1441">556095</cx:pt>
          <cx:pt idx="1442">1261011</cx:pt>
          <cx:pt idx="1443">1061206</cx:pt>
          <cx:pt idx="1444">0</cx:pt>
          <cx:pt idx="1445">1173151</cx:pt>
          <cx:pt idx="1446">1410870</cx:pt>
          <cx:pt idx="1447">1307658</cx:pt>
          <cx:pt idx="1448">386423</cx:pt>
          <cx:pt idx="1449">345523</cx:pt>
          <cx:pt idx="1450">206119</cx:pt>
          <cx:pt idx="1451">1347931</cx:pt>
          <cx:pt idx="1452">1156331</cx:pt>
          <cx:pt idx="1453">727166</cx:pt>
          <cx:pt idx="1454">3448979</cx:pt>
          <cx:pt idx="1455">1647307</cx:pt>
          <cx:pt idx="1456">1892268</cx:pt>
          <cx:pt idx="1457">1796736</cx:pt>
          <cx:pt idx="1458">899654</cx:pt>
          <cx:pt idx="1459">675541</cx:pt>
          <cx:pt idx="1460">628332</cx:pt>
          <cx:pt idx="1461">1911988</cx:pt>
          <cx:pt idx="1462">1134721</cx:pt>
          <cx:pt idx="1463">210768</cx:pt>
          <cx:pt idx="1464">2095040</cx:pt>
          <cx:pt idx="1465">1353574</cx:pt>
          <cx:pt idx="1466">395390</cx:pt>
          <cx:pt idx="1467">1163539</cx:pt>
          <cx:pt idx="1468">512213</cx:pt>
          <cx:pt idx="1469">1634686</cx:pt>
          <cx:pt idx="1470">319455</cx:pt>
          <cx:pt idx="1471">1439965</cx:pt>
          <cx:pt idx="1472">268554</cx:pt>
          <cx:pt idx="1473">748078</cx:pt>
          <cx:pt idx="1474">1492168</cx:pt>
          <cx:pt idx="1475">292245</cx:pt>
          <cx:pt idx="1476">1412486</cx:pt>
          <cx:pt idx="1477">475435</cx:pt>
          <cx:pt idx="1478">764266</cx:pt>
          <cx:pt idx="1479">469961</cx:pt>
          <cx:pt idx="1480">367329</cx:pt>
          <cx:pt idx="1481">199147</cx:pt>
          <cx:pt idx="1482">131453</cx:pt>
          <cx:pt idx="1483">60833</cx:pt>
          <cx:pt idx="1484">0</cx:pt>
          <cx:pt idx="1485">119092</cx:pt>
          <cx:pt idx="1486">616935</cx:pt>
          <cx:pt idx="1487">971564</cx:pt>
          <cx:pt idx="1488">917118</cx:pt>
          <cx:pt idx="1489">1639978</cx:pt>
          <cx:pt idx="1490">279426</cx:pt>
          <cx:pt idx="1491">368108</cx:pt>
          <cx:pt idx="1492">255746</cx:pt>
          <cx:pt idx="1493">756763</cx:pt>
          <cx:pt idx="1494">657435</cx:pt>
          <cx:pt idx="1495">2470949</cx:pt>
          <cx:pt idx="1496">524352</cx:pt>
          <cx:pt idx="1497">531795</cx:pt>
          <cx:pt idx="1498">940156</cx:pt>
          <cx:pt idx="1499">789554</cx:pt>
          <cx:pt idx="1500">598473</cx:pt>
          <cx:pt idx="1501">261567</cx:pt>
          <cx:pt idx="1502">671998</cx:pt>
          <cx:pt idx="1503">679479</cx:pt>
          <cx:pt idx="1504">770981</cx:pt>
          <cx:pt idx="1505">88212</cx:pt>
          <cx:pt idx="1506">258850</cx:pt>
          <cx:pt idx="1507">355645</cx:pt>
          <cx:pt idx="1508">475826</cx:pt>
          <cx:pt idx="1509">1021331</cx:pt>
          <cx:pt idx="1510">619293</cx:pt>
          <cx:pt idx="1511">554919</cx:pt>
          <cx:pt idx="1512">518478</cx:pt>
          <cx:pt idx="1513">592191</cx:pt>
          <cx:pt idx="1514">136476</cx:pt>
          <cx:pt idx="1515">90527</cx:pt>
          <cx:pt idx="1516">0</cx:pt>
          <cx:pt idx="1517">491862</cx:pt>
          <cx:pt idx="1518">151165</cx:pt>
          <cx:pt idx="1519">1210429</cx:pt>
          <cx:pt idx="1520">2662233</cx:pt>
          <cx:pt idx="1521">1102335</cx:pt>
          <cx:pt idx="1522">1166742</cx:pt>
          <cx:pt idx="1523">994645</cx:pt>
          <cx:pt idx="1524">2959015</cx:pt>
          <cx:pt idx="1525">423478</cx:pt>
          <cx:pt idx="1526">1973288</cx:pt>
          <cx:pt idx="1527">534538</cx:pt>
          <cx:pt idx="1528">2768300</cx:pt>
          <cx:pt idx="1529">415673</cx:pt>
          <cx:pt idx="1530">632263</cx:pt>
          <cx:pt idx="1531">400459</cx:pt>
          <cx:pt idx="1532">973951</cx:pt>
          <cx:pt idx="1533">630691</cx:pt>
          <cx:pt idx="1534">470743</cx:pt>
          <cx:pt idx="1535">873873</cx:pt>
          <cx:pt idx="1536">581985</cx:pt>
          <cx:pt idx="1537">503210</cx:pt>
          <cx:pt idx="1538">2225615</cx:pt>
          <cx:pt idx="1539">115230</cx:pt>
          <cx:pt idx="1540">727560</cx:pt>
          <cx:pt idx="1541">1252173</cx:pt>
          <cx:pt idx="1542">565899</cx:pt>
          <cx:pt idx="1543">502819</cx:pt>
          <cx:pt idx="1544">1037673</cx:pt>
          <cx:pt idx="1545">958838</cx:pt>
          <cx:pt idx="1546">1049238</cx:pt>
          <cx:pt idx="1547">958042</cx:pt>
          <cx:pt idx="1548">1128321</cx:pt>
          <cx:pt idx="1549">681448</cx:pt>
          <cx:pt idx="1550">1392701</cx:pt>
          <cx:pt idx="1551">3031982</cx:pt>
          <cx:pt idx="1552">2032243</cx:pt>
          <cx:pt idx="1553">848512</cx:pt>
          <cx:pt idx="1554">372783</cx:pt>
          <cx:pt idx="1555">435580</cx:pt>
          <cx:pt idx="1556">715335</cx:pt>
          <cx:pt idx="1557">774142</cx:pt>
          <cx:pt idx="1558">435580</cx:pt>
          <cx:pt idx="1559">0</cx:pt>
          <cx:pt idx="1560">366160</cx:pt>
          <cx:pt idx="1561">669636</cx:pt>
          <cx:pt idx="1562">59292</cx:pt>
          <cx:pt idx="1563">673966</cx:pt>
          <cx:pt idx="1564">952874</cx:pt>
          <cx:pt idx="1565">1648936</cx:pt>
          <cx:pt idx="1566">923074</cx:pt>
          <cx:pt idx="1567">247598</cx:pt>
          <cx:pt idx="1568">1326580</cx:pt>
          <cx:pt idx="1569">126431</cx:pt>
          <cx:pt idx="1570">1965876</cx:pt>
          <cx:pt idx="1571">425429</cx:pt>
          <cx:pt idx="1572">1245747</cx:pt>
          <cx:pt idx="1573">471525</cx:pt>
          <cx:pt idx="1574">1131521</cx:pt>
          <cx:pt idx="1575">2536389</cx:pt>
          <cx:pt idx="1576">158512</cx:pt>
          <cx:pt idx="1577">627153</cx:pt>
          <cx:pt idx="1578">813281</cx:pt>
          <cx:pt idx="1579">1784867</cx:pt>
          <cx:pt idx="1580">425820</cx:pt>
          <cx:pt idx="1581">2906645</cx:pt>
          <cx:pt idx="1582">733872</cx:pt>
          <cx:pt idx="1583">412942</cx:pt>
          <cx:pt idx="1584">702721</cx:pt>
          <cx:pt idx="1585">599651</cx:pt>
          <cx:pt idx="1586">3323980</cx:pt>
          <cx:pt idx="1587">31556</cx:pt>
          <cx:pt idx="1588">694446</cx:pt>
          <cx:pt idx="1589">312844</cx:pt>
          <cx:pt idx="1590">3240373</cx:pt>
          <cx:pt idx="1591">1660341</cx:pt>
          <cx:pt idx="1592">455891</cx:pt>
          <cx:pt idx="1593">179403</cx:pt>
          <cx:pt idx="1594">1263422</cx:pt>
          <cx:pt idx="1595">1407236</cx:pt>
          <cx:pt idx="1596">435580</cx:pt>
          <cx:pt idx="1597">138022</cx:pt>
          <cx:pt idx="1598">1678680</cx:pt>
          <cx:pt idx="1599">2042975</cx:pt>
          <cx:pt idx="1600">840195</cx:pt>
          <cx:pt idx="1601">1728049</cx:pt>
          <cx:pt idx="1602">205345</cx:pt>
          <cx:pt idx="1603">275931</cx:pt>
          <cx:pt idx="1604">3327001</cx:pt>
          <cx:pt idx="1605">1813114</cx:pt>
          <cx:pt idx="1606">244883</cx:pt>
          <cx:pt idx="1607">1234505</cx:pt>
          <cx:pt idx="1608">1120323</cx:pt>
          <cx:pt idx="1609">1452502</cx:pt>
          <cx:pt idx="1610">407090</cx:pt>
          <cx:pt idx="1611">199922</cx:pt>
          <cx:pt idx="1612">0</cx:pt>
          <cx:pt idx="1613">1317721</cx:pt>
          <cx:pt idx="1614">135317</cx:pt>
          <cx:pt idx="1615">2480588</cx:pt>
          <cx:pt idx="1616">1927198</cx:pt>
          <cx:pt idx="1617">756369</cx:pt>
          <cx:pt idx="1618">476217</cx:pt>
          <cx:pt idx="1619">135317</cx:pt>
          <cx:pt idx="1620">257298</cx:pt>
          <cx:pt idx="1621">249538</cx:pt>
          <cx:pt idx="1622">1559482</cx:pt>
          <cx:pt idx="1623">206119</cx:pt>
          <cx:pt idx="1624">994645</cx:pt>
          <cx:pt idx="1625">3186201</cx:pt>
          <cx:pt idx="1626">1417737</cx:pt>
          <cx:pt idx="1627">2725995</cx:pt>
          <cx:pt idx="1628">439094</cx:pt>
          <cx:pt idx="1629">635015</cx:pt>
          <cx:pt idx="1630">1062802</cx:pt>
          <cx:pt idx="1631">1081564</cx:pt>
          <cx:pt idx="1632">790740</cx:pt>
          <cx:pt idx="1633">1597263</cx:pt>
          <cx:pt idx="1634">1832780</cx:pt>
          <cx:pt idx="1635">531795</cx:pt>
          <cx:pt idx="1636">1180763</cx:pt>
          <cx:pt idx="1637">72398</cx:pt>
          <cx:pt idx="1638">1320942</cx:pt>
          <cx:pt idx="1639">919898</cx:pt>
          <cx:pt idx="1640">407870</cx:pt>
          <cx:pt idx="1641">2106622</cx:pt>
          <cx:pt idx="1642">716124</cx:pt>
          <cx:pt idx="1643">638554</cx:pt>
          <cx:pt idx="1644">874270</cx:pt>
          <cx:pt idx="1645">0</cx:pt>
          <cx:pt idx="1646">632657</cx:pt>
          <cx:pt idx="1647">578846</cx:pt>
          <cx:pt idx="1648">0</cx:pt>
          <cx:pt idx="1649">692870</cx:pt>
          <cx:pt idx="1650">1784458</cx:pt>
          <cx:pt idx="1651">264284</cx:pt>
          <cx:pt idx="1652">1666860</cx:pt>
          <cx:pt idx="1653">0</cx:pt>
          <cx:pt idx="1654">627153</cx:pt>
          <cx:pt idx="1655">155805</cx:pt>
          <cx:pt idx="1656">3988454</cx:pt>
          <cx:pt idx="1657">1014956</cx:pt>
          <cx:pt idx="1658">1555828</cx:pt>
          <cx:pt idx="1659">612220</cx:pt>
          <cx:pt idx="1660">172051</cx:pt>
          <cx:pt idx="1661">1810656</cx:pt>
          <cx:pt idx="1662">503601</cx:pt>
          <cx:pt idx="1663">95543</cx:pt>
          <cx:pt idx="1664">191016</cx:pt>
          <cx:pt idx="1665">585910</cx:pt>
          <cx:pt idx="1666">2070648</cx:pt>
          <cx:pt idx="1667">2042975</cx:pt>
          <cx:pt idx="1668">1443200</cx:pt>
          <cx:pt idx="1669">536889</cx:pt>
          <cx:pt idx="1670">2204849</cx:pt>
          <cx:pt idx="1671">603971</cx:pt>
          <cx:pt idx="1672">1010574</cx:pt>
          <cx:pt idx="1673">1008582</cx:pt>
          <cx:pt idx="1674">131067</cx:pt>
          <cx:pt idx="1675">449640</cx:pt>
          <cx:pt idx="1676">1292369</cx:pt>
          <cx:pt idx="1677">946912</cx:pt>
          <cx:pt idx="1678">72013</cx:pt>
          <cx:pt idx="1679">336571</cx:pt>
          <cx:pt idx="1680">728744</cx:pt>
          <cx:pt idx="1681">189467</cx:pt>
          <cx:pt idx="1682">1975760</cx:pt>
          <cx:pt idx="1683">1121922</cx:pt>
          <cx:pt idx="1684">1811066</cx:pt>
          <cx:pt idx="1685">735056</cx:pt>
        </cx:lvl>
      </cx:numDim>
    </cx:data>
  </cx:chartData>
  <cx:chart>
    <cx:plotArea>
      <cx:plotAreaRegion>
        <cx:series layoutId="boxWhisker" uniqueId="{93719A2D-A18E-4A5C-BBDF-1558C4CDD03C}"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CCDFFA01-AEBF-4AEE-ADEE-E4DF4031D62A}">
          <cx:dataId val="1"/>
          <cx:layoutPr>
            <cx:visibility meanLine="0" meanMarker="1" nonoutliers="0" outliers="1"/>
            <cx:statistics quartileMethod="exclusive"/>
          </cx:layoutPr>
        </cx:series>
      </cx:plotAreaRegion>
      <cx:axis id="0" hidden="1">
        <cx:catScaling gapWidth="1"/>
        <cx:tickLabels/>
      </cx:axis>
      <cx:axis id="1">
        <cx:valScaling/>
        <cx:units unit="millions"/>
        <cx:majorTickMarks type="out"/>
        <cx:tickLabels/>
        <cx:numFmt formatCode="G/通用格式" sourceLinked="0"/>
        <cx:spPr>
          <a:ln>
            <a:solidFill>
              <a:schemeClr val="tx1"/>
            </a:solidFill>
          </a:ln>
        </cx:spPr>
        <cx:txPr>
          <a:bodyPr rot="-60000000" spcFirstLastPara="1" vertOverflow="ellipsis" vert="horz" wrap="square" lIns="0" tIns="0" rIns="0" bIns="0" anchor="ctr" anchorCtr="1"/>
          <a:lstStyle/>
          <a:p>
            <a:pPr>
              <a:defRPr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zh-CN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998</cdr:x>
      <cdr:y>0.85659</cdr:y>
    </cdr:from>
    <cdr:to>
      <cdr:x>0.9776</cdr:x>
      <cdr:y>0.85659</cdr:y>
    </cdr:to>
    <cdr:cxnSp macro="">
      <cdr:nvCxnSpPr>
        <cdr:cNvPr id="4" name="直接连接符 3">
          <a:extLst xmlns:a="http://schemas.openxmlformats.org/drawingml/2006/main">
            <a:ext uri="{FF2B5EF4-FFF2-40B4-BE49-F238E27FC236}">
              <a16:creationId xmlns:a16="http://schemas.microsoft.com/office/drawing/2014/main" id="{28EE9CCF-23A2-4449-9BDA-52D950523503}"/>
            </a:ext>
          </a:extLst>
        </cdr:cNvPr>
        <cdr:cNvCxnSpPr/>
      </cdr:nvCxnSpPr>
      <cdr:spPr>
        <a:xfrm xmlns:a="http://schemas.openxmlformats.org/drawingml/2006/main">
          <a:off x="399250" y="2579875"/>
          <a:ext cx="6108331" cy="0"/>
        </a:xfrm>
        <a:prstGeom xmlns:a="http://schemas.openxmlformats.org/drawingml/2006/main" prst="line">
          <a:avLst/>
        </a:prstGeom>
        <a:ln xmlns:a="http://schemas.openxmlformats.org/drawingml/2006/main" w="952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93E42B-2C78-4C56-928D-6DB8B65274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3E296C7-9B5C-4374-92AA-2192D8FB54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959173-60F7-4D4F-AC9B-F39A4B66D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6FF130-4CBE-4AC7-B85D-A2DAE1B4E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B6533D-BB8D-4F71-8015-E0337AED3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1857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9BB906-5188-418F-8311-37775E374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50685B9-5ECA-4E8E-9734-2C1A0929BF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BAAED8-8E1D-4E2E-A329-E6D35C8FE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E82021-3EC2-44CB-B626-3E2F6F381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697753-062A-4EAB-9F11-6874968BE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4487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E788DFE-DD16-4920-AD73-A74DD16BD7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F3B36E1-F35F-4E29-A312-0DB0F46ADC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D1F715-C497-45E8-8E19-1DE74D186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F94287-36D0-489F-82F6-A2A4080DD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E66B01-3F49-4BE8-B3F6-DBC51CE42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8003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B5C857-400F-40F1-92FE-3E9A6590F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4DFB1EC-B8CE-4B83-88D4-E8E24681C1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62B7C4-91B5-494A-A6C1-31C79D26B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D00807-7DA6-4FC6-949A-9E2094C56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29CA44-381A-4248-937E-E6BC4052C6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8071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6E29F8-87C2-433A-B3B7-F82467CDC4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CE5FF11-0B72-4999-87FD-F3915E880F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418A3D-E653-4EEF-B7AE-9FF192F92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DAD19BB-6A2D-4B4F-BCC1-D3DE60E89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746780-0212-4A4E-943B-13E1BAF5B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7067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CDE6F4-7512-4FA2-9731-6894FD981D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81D6765-FCE5-4F93-B5A3-4E426AC849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4142252-4DC7-4216-A559-E9E3D271EB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6406C1-7945-4C07-A20F-C8E1F259D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51A926-F8D9-4B0B-BF88-85A589589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04951F-5A3A-4503-85D6-312E6D59A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5418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293B87-4733-4449-A27F-8982EEA73D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8F73B9-A962-4F17-B4CD-524A7823E4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4B1986A-74B3-4038-9344-540ED423C8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D80872C-D4F9-4AA0-A472-A5BF8F2285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C6749E3-E5F7-4239-ABA8-F67997488F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A1F6652-09CB-4B11-90B7-1E370B2A9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6A3159B-507B-4462-89A1-2FF9888A5F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A30B03C-4C04-44A2-93CA-BB03BC250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7077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C11E6D-5551-4565-AD83-4600E280F0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6795346-7C69-45A4-8A2B-8F97C938C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D4D1756-4594-4717-AD28-F92FA32EF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F62B80E-1A7A-4BB2-90D5-9EEA5F7F08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384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DDBAE12-4DB8-467E-AE2C-F9AE13F4A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2612C9C-225C-42BC-A19E-D04AC665E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CFE1D0E-0E58-4F80-AA5B-EB7AC421F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7189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74BFFD-9837-4643-9A9F-F415D9DA4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08206EF-F10C-4AC2-BAE0-4E6D062F6B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0E15240-13B9-4CE2-BDDD-3F5E162D44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0914E78-8932-4996-98E9-D6CE437CB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C41B561-8E80-4F41-9F7F-B45EED33A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4E2D747-3FC3-4267-8F33-46B7A908F9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1890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C80FD6-8214-462C-AFB1-319A0C446E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91ADF00-038D-4036-B49E-81A1D64229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3F90402-AB62-4075-92D8-A80E028845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D9A9565-B800-4E35-8DF1-6EFA6EFBF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868209E-4FB0-42AD-847C-7EEE71215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9E4B3E9-252D-4A5C-8AF1-1B3920140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100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69D881B-A2F2-4B3D-94CB-049F80343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E9746D-04CE-44D6-8161-E002B9E4F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75E2814-56FA-402E-A298-C102B890B8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053251-E7B1-4176-A6A1-308675AE167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36469C5-5A2E-4AED-B094-4C28DBE29F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231B1E-A58F-41D4-85D2-7961E1185F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2E97C3-D849-464D-9783-C2F8F581BB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657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14/relationships/chartEx" Target="../charts/chartEx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1EA15421-A12F-41A5-A8F6-5BC748B1E1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2425468"/>
              </p:ext>
            </p:extLst>
          </p:nvPr>
        </p:nvGraphicFramePr>
        <p:xfrm>
          <a:off x="3133890" y="-51459"/>
          <a:ext cx="6656689" cy="30118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761BEB49-CEA5-401B-B735-E40A8C955305}"/>
              </a:ext>
            </a:extLst>
          </p:cNvPr>
          <p:cNvSpPr/>
          <p:nvPr/>
        </p:nvSpPr>
        <p:spPr>
          <a:xfrm>
            <a:off x="5465253" y="2804185"/>
            <a:ext cx="23620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nsertion tim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TR-RT (MYA)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B6E74267-66AC-4AEA-A796-CADB9863A001}"/>
              </a:ext>
            </a:extLst>
          </p:cNvPr>
          <p:cNvSpPr/>
          <p:nvPr/>
        </p:nvSpPr>
        <p:spPr>
          <a:xfrm rot="16200000">
            <a:off x="2377684" y="1103134"/>
            <a:ext cx="1132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TR-RT cou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5750031-D816-4170-96F2-3AB35727B94E}"/>
              </a:ext>
            </a:extLst>
          </p:cNvPr>
          <p:cNvSpPr txBox="1"/>
          <p:nvPr/>
        </p:nvSpPr>
        <p:spPr>
          <a:xfrm>
            <a:off x="2547931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18FDF95D-04D1-4BDB-B732-C87307CF97E2}"/>
              </a:ext>
            </a:extLst>
          </p:cNvPr>
          <p:cNvGrpSpPr/>
          <p:nvPr/>
        </p:nvGrpSpPr>
        <p:grpSpPr>
          <a:xfrm>
            <a:off x="2547931" y="3266273"/>
            <a:ext cx="5358575" cy="3281279"/>
            <a:chOff x="6023832" y="899586"/>
            <a:chExt cx="5358575" cy="3281279"/>
          </a:xfrm>
        </p:grpSpPr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E5CFE039-1AD0-4923-9F42-C76243553B85}"/>
                </a:ext>
              </a:extLst>
            </p:cNvPr>
            <p:cNvGrpSpPr/>
            <p:nvPr/>
          </p:nvGrpSpPr>
          <p:grpSpPr>
            <a:xfrm>
              <a:off x="6332792" y="899586"/>
              <a:ext cx="5049615" cy="3281279"/>
              <a:chOff x="1643240" y="1734518"/>
              <a:chExt cx="5049615" cy="3281279"/>
            </a:xfrm>
          </p:grpSpPr>
          <p:grpSp>
            <p:nvGrpSpPr>
              <p:cNvPr id="11" name="组合 10">
                <a:extLst>
                  <a:ext uri="{FF2B5EF4-FFF2-40B4-BE49-F238E27FC236}">
                    <a16:creationId xmlns:a16="http://schemas.microsoft.com/office/drawing/2014/main" id="{9D0D728B-7FA4-481B-B7D7-9A281121286F}"/>
                  </a:ext>
                </a:extLst>
              </p:cNvPr>
              <p:cNvGrpSpPr/>
              <p:nvPr/>
            </p:nvGrpSpPr>
            <p:grpSpPr>
              <a:xfrm>
                <a:off x="2120855" y="2060803"/>
                <a:ext cx="4572000" cy="2954994"/>
                <a:chOff x="3798826" y="2060230"/>
                <a:chExt cx="4572000" cy="2954994"/>
              </a:xfrm>
            </p:grpSpPr>
            <mc:AlternateContent xmlns:mc="http://schemas.openxmlformats.org/markup-compatibility/2006">
              <mc:Choice xmlns:cx1="http://schemas.microsoft.com/office/drawing/2015/9/8/chartex" Requires="cx1">
                <p:graphicFrame>
                  <p:nvGraphicFramePr>
                    <p:cNvPr id="13" name="图表 12">
                      <a:extLst>
                        <a:ext uri="{FF2B5EF4-FFF2-40B4-BE49-F238E27FC236}">
                          <a16:creationId xmlns:a16="http://schemas.microsoft.com/office/drawing/2014/main" id="{BFA9E43A-A4D0-46EA-8916-700AB235E791}"/>
                        </a:ext>
                      </a:extLst>
                    </p:cNvPr>
                    <p:cNvGraphicFramePr/>
                    <p:nvPr>
                      <p:extLst>
                        <p:ext uri="{D42A27DB-BD31-4B8C-83A1-F6EECF244321}">
                          <p14:modId xmlns:p14="http://schemas.microsoft.com/office/powerpoint/2010/main" val="3749174215"/>
                        </p:ext>
                      </p:extLst>
                    </p:nvPr>
                  </p:nvGraphicFramePr>
                  <p:xfrm>
                    <a:off x="3798826" y="2060230"/>
                    <a:ext cx="4572000" cy="2743200"/>
                  </p:xfrm>
                  <a:graphic>
                    <a:graphicData uri="http://schemas.microsoft.com/office/drawing/2014/chartex">
                      <cx:chart xmlns:cx="http://schemas.microsoft.com/office/drawing/2014/chartex" xmlns:r="http://schemas.openxmlformats.org/officeDocument/2006/relationships" r:id="rId3"/>
                    </a:graphicData>
                  </a:graphic>
                </p:graphicFrame>
              </mc:Choice>
              <mc:Fallback>
                <p:pic>
                  <p:nvPicPr>
                    <p:cNvPr id="13" name="图表 12">
                      <a:extLst>
                        <a:ext uri="{FF2B5EF4-FFF2-40B4-BE49-F238E27FC236}">
                          <a16:creationId xmlns:a16="http://schemas.microsoft.com/office/drawing/2014/main" id="{BFA9E43A-A4D0-46EA-8916-700AB235E791}"/>
                        </a:ext>
                      </a:extLst>
                    </p:cNvPr>
                    <p:cNvPicPr>
                      <a:picLocks noGrp="1" noRot="1" noChangeAspect="1" noMove="1" noResize="1" noEditPoints="1" noAdjustHandles="1" noChangeArrowheads="1" noChangeShapeType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3334506" y="3592558"/>
                      <a:ext cx="4572000" cy="2743200"/>
                    </a:xfrm>
                    <a:prstGeom prst="rect">
                      <a:avLst/>
                    </a:prstGeom>
                  </p:spPr>
                </p:pic>
              </mc:Fallback>
            </mc:AlternateContent>
            <p:cxnSp>
              <p:nvCxnSpPr>
                <p:cNvPr id="14" name="直接连接符 13">
                  <a:extLst>
                    <a:ext uri="{FF2B5EF4-FFF2-40B4-BE49-F238E27FC236}">
                      <a16:creationId xmlns:a16="http://schemas.microsoft.com/office/drawing/2014/main" id="{1F5F6E67-A4EA-46D8-8BC3-953B1DE86F38}"/>
                    </a:ext>
                  </a:extLst>
                </p:cNvPr>
                <p:cNvCxnSpPr/>
                <p:nvPr/>
              </p:nvCxnSpPr>
              <p:spPr>
                <a:xfrm>
                  <a:off x="4006070" y="4656841"/>
                  <a:ext cx="345021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457A9FE2-BD4C-4EF7-8E57-7CB2B90BF4BA}"/>
                    </a:ext>
                  </a:extLst>
                </p:cNvPr>
                <p:cNvSpPr txBox="1"/>
                <p:nvPr/>
              </p:nvSpPr>
              <p:spPr>
                <a:xfrm>
                  <a:off x="5065820" y="4738225"/>
                  <a:ext cx="11737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r>
                    <a:rPr lang="en-US" altLang="zh-CN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. baicalensis </a:t>
                  </a:r>
                  <a:endParaRPr lang="zh-CN" altLang="en-US" b="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8E3FCE53-89CF-4888-BA97-0E58927893BB}"/>
                    </a:ext>
                  </a:extLst>
                </p:cNvPr>
                <p:cNvSpPr txBox="1"/>
                <p:nvPr/>
              </p:nvSpPr>
              <p:spPr>
                <a:xfrm>
                  <a:off x="6223360" y="4738225"/>
                  <a:ext cx="9364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r>
                    <a:rPr lang="en-US" altLang="zh-CN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. </a:t>
                  </a:r>
                  <a:r>
                    <a:rPr lang="en-US" altLang="zh-CN" b="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arbata</a:t>
                  </a:r>
                  <a:r>
                    <a:rPr lang="en-US" altLang="zh-CN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endParaRPr lang="zh-CN" altLang="en-US" b="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C1ACDE5F-BFFB-4C48-AFC5-829502B6D31E}"/>
                  </a:ext>
                </a:extLst>
              </p:cNvPr>
              <p:cNvSpPr txBox="1"/>
              <p:nvPr/>
            </p:nvSpPr>
            <p:spPr>
              <a:xfrm rot="16200000">
                <a:off x="230418" y="3147340"/>
                <a:ext cx="31026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2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Insertion time distribution of LTR-RT (MYA)</a:t>
                </a:r>
              </a:p>
            </p:txBody>
          </p:sp>
        </p:grp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81180B5B-7E7E-4DB6-B676-21E981457A8E}"/>
                </a:ext>
              </a:extLst>
            </p:cNvPr>
            <p:cNvSpPr txBox="1"/>
            <p:nvPr/>
          </p:nvSpPr>
          <p:spPr>
            <a:xfrm>
              <a:off x="6023832" y="899586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3699ACD2-8A70-4DE7-B924-A655EEE01867}"/>
              </a:ext>
            </a:extLst>
          </p:cNvPr>
          <p:cNvGrpSpPr/>
          <p:nvPr/>
        </p:nvGrpSpPr>
        <p:grpSpPr>
          <a:xfrm>
            <a:off x="3535946" y="2522668"/>
            <a:ext cx="6103239" cy="35971"/>
            <a:chOff x="3535946" y="2009213"/>
            <a:chExt cx="6103239" cy="35971"/>
          </a:xfrm>
        </p:grpSpPr>
        <p:cxnSp>
          <p:nvCxnSpPr>
            <p:cNvPr id="3" name="直接连接符 2">
              <a:extLst>
                <a:ext uri="{FF2B5EF4-FFF2-40B4-BE49-F238E27FC236}">
                  <a16:creationId xmlns:a16="http://schemas.microsoft.com/office/drawing/2014/main" id="{CA48731A-8607-4E46-99B8-E9E2DEA8FB6B}"/>
                </a:ext>
              </a:extLst>
            </p:cNvPr>
            <p:cNvCxnSpPr>
              <a:cxnSpLocks/>
            </p:cNvCxnSpPr>
            <p:nvPr/>
          </p:nvCxnSpPr>
          <p:spPr>
            <a:xfrm>
              <a:off x="3535946" y="2009213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C06A1713-DAE0-4A4A-A3DA-C6F98FE35570}"/>
                </a:ext>
              </a:extLst>
            </p:cNvPr>
            <p:cNvCxnSpPr/>
            <p:nvPr/>
          </p:nvCxnSpPr>
          <p:spPr>
            <a:xfrm>
              <a:off x="377026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9E43F055-F78A-4E34-8DC2-371F6E88F1F6}"/>
                </a:ext>
              </a:extLst>
            </p:cNvPr>
            <p:cNvCxnSpPr/>
            <p:nvPr/>
          </p:nvCxnSpPr>
          <p:spPr>
            <a:xfrm>
              <a:off x="402553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37A714BB-E56D-48CA-8A29-2D54035B58E2}"/>
                </a:ext>
              </a:extLst>
            </p:cNvPr>
            <p:cNvCxnSpPr/>
            <p:nvPr/>
          </p:nvCxnSpPr>
          <p:spPr>
            <a:xfrm>
              <a:off x="428080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EC71A0A0-A514-47D6-BF14-1AF0AA56EB59}"/>
                </a:ext>
              </a:extLst>
            </p:cNvPr>
            <p:cNvCxnSpPr/>
            <p:nvPr/>
          </p:nvCxnSpPr>
          <p:spPr>
            <a:xfrm>
              <a:off x="453607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B5A626F8-9A0D-4D52-930E-4667F1C7E2E3}"/>
                </a:ext>
              </a:extLst>
            </p:cNvPr>
            <p:cNvCxnSpPr/>
            <p:nvPr/>
          </p:nvCxnSpPr>
          <p:spPr>
            <a:xfrm>
              <a:off x="479134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08446633-F809-4269-B1D5-3505C3A75E5B}"/>
                </a:ext>
              </a:extLst>
            </p:cNvPr>
            <p:cNvCxnSpPr/>
            <p:nvPr/>
          </p:nvCxnSpPr>
          <p:spPr>
            <a:xfrm>
              <a:off x="504661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B491996B-8C4F-46A5-8D76-9C7033BB4A4D}"/>
                </a:ext>
              </a:extLst>
            </p:cNvPr>
            <p:cNvCxnSpPr/>
            <p:nvPr/>
          </p:nvCxnSpPr>
          <p:spPr>
            <a:xfrm>
              <a:off x="530188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DFC95483-0534-47E8-9D67-FEC76E4B62DB}"/>
                </a:ext>
              </a:extLst>
            </p:cNvPr>
            <p:cNvCxnSpPr/>
            <p:nvPr/>
          </p:nvCxnSpPr>
          <p:spPr>
            <a:xfrm>
              <a:off x="555715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80051EF7-2997-48E8-841E-1A06A88B3CA6}"/>
                </a:ext>
              </a:extLst>
            </p:cNvPr>
            <p:cNvCxnSpPr/>
            <p:nvPr/>
          </p:nvCxnSpPr>
          <p:spPr>
            <a:xfrm>
              <a:off x="581242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57CCC5DE-B3C7-40CF-B223-899440BA53EC}"/>
                </a:ext>
              </a:extLst>
            </p:cNvPr>
            <p:cNvCxnSpPr/>
            <p:nvPr/>
          </p:nvCxnSpPr>
          <p:spPr>
            <a:xfrm>
              <a:off x="606769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E3CADBAB-C12E-490B-9F2E-8D88A32BCF1E}"/>
                </a:ext>
              </a:extLst>
            </p:cNvPr>
            <p:cNvCxnSpPr/>
            <p:nvPr/>
          </p:nvCxnSpPr>
          <p:spPr>
            <a:xfrm>
              <a:off x="632296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3D35BB02-8575-4A78-8948-D03B35B57B76}"/>
                </a:ext>
              </a:extLst>
            </p:cNvPr>
            <p:cNvCxnSpPr/>
            <p:nvPr/>
          </p:nvCxnSpPr>
          <p:spPr>
            <a:xfrm>
              <a:off x="657823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EE9B8FFC-3A24-44F6-9E0F-3423FFF6116B}"/>
                </a:ext>
              </a:extLst>
            </p:cNvPr>
            <p:cNvCxnSpPr/>
            <p:nvPr/>
          </p:nvCxnSpPr>
          <p:spPr>
            <a:xfrm>
              <a:off x="683350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29F48345-94A7-429C-9C5D-FEBA2AFCBDAE}"/>
                </a:ext>
              </a:extLst>
            </p:cNvPr>
            <p:cNvCxnSpPr/>
            <p:nvPr/>
          </p:nvCxnSpPr>
          <p:spPr>
            <a:xfrm>
              <a:off x="708877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35D684AE-7354-4079-9834-B69DF79CDF17}"/>
                </a:ext>
              </a:extLst>
            </p:cNvPr>
            <p:cNvCxnSpPr/>
            <p:nvPr/>
          </p:nvCxnSpPr>
          <p:spPr>
            <a:xfrm>
              <a:off x="734404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D299975B-A9D4-4781-92A4-A1D893F1957C}"/>
                </a:ext>
              </a:extLst>
            </p:cNvPr>
            <p:cNvCxnSpPr/>
            <p:nvPr/>
          </p:nvCxnSpPr>
          <p:spPr>
            <a:xfrm>
              <a:off x="759931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D8BE7C1C-1BE9-4440-9A9E-884CF9701A05}"/>
                </a:ext>
              </a:extLst>
            </p:cNvPr>
            <p:cNvCxnSpPr/>
            <p:nvPr/>
          </p:nvCxnSpPr>
          <p:spPr>
            <a:xfrm>
              <a:off x="785458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B6EBF26B-FF49-4A7E-A639-522B0C50848B}"/>
                </a:ext>
              </a:extLst>
            </p:cNvPr>
            <p:cNvCxnSpPr/>
            <p:nvPr/>
          </p:nvCxnSpPr>
          <p:spPr>
            <a:xfrm>
              <a:off x="810985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6AD0F12B-11D5-4800-A08F-1BEDE1DD8B1E}"/>
                </a:ext>
              </a:extLst>
            </p:cNvPr>
            <p:cNvCxnSpPr/>
            <p:nvPr/>
          </p:nvCxnSpPr>
          <p:spPr>
            <a:xfrm>
              <a:off x="836512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8583A424-FC63-453F-84DE-81C4EE837000}"/>
                </a:ext>
              </a:extLst>
            </p:cNvPr>
            <p:cNvCxnSpPr/>
            <p:nvPr/>
          </p:nvCxnSpPr>
          <p:spPr>
            <a:xfrm>
              <a:off x="862039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CA3316ED-75AA-426C-B735-389FAAB81B83}"/>
                </a:ext>
              </a:extLst>
            </p:cNvPr>
            <p:cNvCxnSpPr/>
            <p:nvPr/>
          </p:nvCxnSpPr>
          <p:spPr>
            <a:xfrm>
              <a:off x="887566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3B910761-2C39-494A-883F-7CECADA9FF15}"/>
                </a:ext>
              </a:extLst>
            </p:cNvPr>
            <p:cNvCxnSpPr/>
            <p:nvPr/>
          </p:nvCxnSpPr>
          <p:spPr>
            <a:xfrm>
              <a:off x="913093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7E0AB8BF-ECA5-4226-8BD9-11E097192145}"/>
                </a:ext>
              </a:extLst>
            </p:cNvPr>
            <p:cNvCxnSpPr/>
            <p:nvPr/>
          </p:nvCxnSpPr>
          <p:spPr>
            <a:xfrm>
              <a:off x="9386201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29B10A0C-7A5C-46A4-994D-D6B9214DA55D}"/>
                </a:ext>
              </a:extLst>
            </p:cNvPr>
            <p:cNvCxnSpPr>
              <a:cxnSpLocks/>
            </p:cNvCxnSpPr>
            <p:nvPr/>
          </p:nvCxnSpPr>
          <p:spPr>
            <a:xfrm>
              <a:off x="9639185" y="2010894"/>
              <a:ext cx="0" cy="342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文本框 46">
            <a:extLst>
              <a:ext uri="{FF2B5EF4-FFF2-40B4-BE49-F238E27FC236}">
                <a16:creationId xmlns:a16="http://schemas.microsoft.com/office/drawing/2014/main" id="{45F5E28B-7C82-4A62-B91B-F91C2B2D51C0}"/>
              </a:ext>
            </a:extLst>
          </p:cNvPr>
          <p:cNvSpPr txBox="1"/>
          <p:nvPr/>
        </p:nvSpPr>
        <p:spPr>
          <a:xfrm rot="18480000">
            <a:off x="3413813" y="255012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.2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8AF0D36-34C1-4084-8FCE-A3BD30B4EBD0}"/>
              </a:ext>
            </a:extLst>
          </p:cNvPr>
          <p:cNvSpPr txBox="1"/>
          <p:nvPr/>
        </p:nvSpPr>
        <p:spPr>
          <a:xfrm rot="18451659">
            <a:off x="3647527" y="255040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.4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CA22446B-9353-423F-8163-B5D73E555E1E}"/>
              </a:ext>
            </a:extLst>
          </p:cNvPr>
          <p:cNvSpPr txBox="1"/>
          <p:nvPr/>
        </p:nvSpPr>
        <p:spPr>
          <a:xfrm rot="18480000">
            <a:off x="3905767" y="255331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.7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8371588D-FE01-4C95-8533-8027A7AD00C7}"/>
              </a:ext>
            </a:extLst>
          </p:cNvPr>
          <p:cNvSpPr txBox="1"/>
          <p:nvPr/>
        </p:nvSpPr>
        <p:spPr>
          <a:xfrm rot="18480000">
            <a:off x="4173614" y="255012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.96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4DCE2FCC-7541-4297-9F6B-F697C47FC279}"/>
              </a:ext>
            </a:extLst>
          </p:cNvPr>
          <p:cNvSpPr txBox="1"/>
          <p:nvPr/>
        </p:nvSpPr>
        <p:spPr>
          <a:xfrm rot="18480000">
            <a:off x="4438235" y="255817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.2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C3E74E8-9D1A-4EEF-AC61-059B2BA11139}"/>
              </a:ext>
            </a:extLst>
          </p:cNvPr>
          <p:cNvSpPr txBox="1"/>
          <p:nvPr/>
        </p:nvSpPr>
        <p:spPr>
          <a:xfrm rot="18480000">
            <a:off x="4706082" y="25581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.4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E5108460-DB95-4D70-BE4E-491299441B62}"/>
              </a:ext>
            </a:extLst>
          </p:cNvPr>
          <p:cNvSpPr txBox="1"/>
          <p:nvPr/>
        </p:nvSpPr>
        <p:spPr>
          <a:xfrm rot="18480000">
            <a:off x="4961494" y="255817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.6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84724F37-614A-46EA-9104-F4619026029F}"/>
              </a:ext>
            </a:extLst>
          </p:cNvPr>
          <p:cNvSpPr txBox="1"/>
          <p:nvPr/>
        </p:nvSpPr>
        <p:spPr>
          <a:xfrm rot="18480000">
            <a:off x="5220240" y="255817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.9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CFAADD75-12E8-4537-85BE-56E18ED71AA8}"/>
              </a:ext>
            </a:extLst>
          </p:cNvPr>
          <p:cNvSpPr txBox="1"/>
          <p:nvPr/>
        </p:nvSpPr>
        <p:spPr>
          <a:xfrm rot="18480000">
            <a:off x="5478220" y="25355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.16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2E8CAEE5-729C-453A-A595-8FE73181F7EC}"/>
              </a:ext>
            </a:extLst>
          </p:cNvPr>
          <p:cNvSpPr txBox="1"/>
          <p:nvPr/>
        </p:nvSpPr>
        <p:spPr>
          <a:xfrm rot="18480000">
            <a:off x="5729755" y="253341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.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0DB226BA-6FDA-4A20-A90C-FFBC33AC669B}"/>
              </a:ext>
            </a:extLst>
          </p:cNvPr>
          <p:cNvSpPr txBox="1"/>
          <p:nvPr/>
        </p:nvSpPr>
        <p:spPr>
          <a:xfrm rot="18480000">
            <a:off x="5989124" y="253557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.6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1A63C97F-32B9-4D12-9D9E-0A03B9401D94}"/>
              </a:ext>
            </a:extLst>
          </p:cNvPr>
          <p:cNvSpPr txBox="1"/>
          <p:nvPr/>
        </p:nvSpPr>
        <p:spPr>
          <a:xfrm rot="18480000">
            <a:off x="6239688" y="253557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.8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B0DFDF95-6BE2-443F-8D47-6409DEB8F7B6}"/>
              </a:ext>
            </a:extLst>
          </p:cNvPr>
          <p:cNvSpPr txBox="1"/>
          <p:nvPr/>
        </p:nvSpPr>
        <p:spPr>
          <a:xfrm rot="18480000">
            <a:off x="6501476" y="254758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.1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D448C8A7-142D-49BB-A5B1-47F865393570}"/>
              </a:ext>
            </a:extLst>
          </p:cNvPr>
          <p:cNvSpPr txBox="1"/>
          <p:nvPr/>
        </p:nvSpPr>
        <p:spPr>
          <a:xfrm rot="18480000">
            <a:off x="6746877" y="254758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.36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6C876292-D485-451C-A928-7D7B605DEFFC}"/>
              </a:ext>
            </a:extLst>
          </p:cNvPr>
          <p:cNvSpPr txBox="1"/>
          <p:nvPr/>
        </p:nvSpPr>
        <p:spPr>
          <a:xfrm rot="18480000">
            <a:off x="7516586" y="254758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.0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9832D36F-4613-426E-9C8D-CC194FD4FF23}"/>
              </a:ext>
            </a:extLst>
          </p:cNvPr>
          <p:cNvSpPr txBox="1"/>
          <p:nvPr/>
        </p:nvSpPr>
        <p:spPr>
          <a:xfrm rot="18480000">
            <a:off x="7009612" y="254758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.6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59F5C3AA-B6C7-4AC6-91AC-EBB5ADD30134}"/>
              </a:ext>
            </a:extLst>
          </p:cNvPr>
          <p:cNvSpPr txBox="1"/>
          <p:nvPr/>
        </p:nvSpPr>
        <p:spPr>
          <a:xfrm rot="18480000">
            <a:off x="7267089" y="254758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.8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85C715F-DFCD-42EC-83BD-18CCC24419F2}"/>
              </a:ext>
            </a:extLst>
          </p:cNvPr>
          <p:cNvSpPr txBox="1"/>
          <p:nvPr/>
        </p:nvSpPr>
        <p:spPr>
          <a:xfrm rot="18480000">
            <a:off x="7766082" y="254758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.3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070C8588-D7E9-4CF4-9530-CE11351DAA6D}"/>
              </a:ext>
            </a:extLst>
          </p:cNvPr>
          <p:cNvSpPr txBox="1"/>
          <p:nvPr/>
        </p:nvSpPr>
        <p:spPr>
          <a:xfrm rot="18480000">
            <a:off x="8033515" y="254757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.56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42B027B4-2790-4A40-9995-F4B52B4FE36D}"/>
              </a:ext>
            </a:extLst>
          </p:cNvPr>
          <p:cNvSpPr txBox="1"/>
          <p:nvPr/>
        </p:nvSpPr>
        <p:spPr>
          <a:xfrm rot="18480000">
            <a:off x="8283613" y="254757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.8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60A4AB7-91DA-4D61-887C-9991540015F5}"/>
              </a:ext>
            </a:extLst>
          </p:cNvPr>
          <p:cNvSpPr txBox="1"/>
          <p:nvPr/>
        </p:nvSpPr>
        <p:spPr>
          <a:xfrm rot="18480000">
            <a:off x="8541200" y="25475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.0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31FBB91D-D66E-407D-AB37-4CCE77678A45}"/>
              </a:ext>
            </a:extLst>
          </p:cNvPr>
          <p:cNvSpPr txBox="1"/>
          <p:nvPr/>
        </p:nvSpPr>
        <p:spPr>
          <a:xfrm rot="18480000">
            <a:off x="8775782" y="254618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.2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7489F1A0-D4FC-4E65-B8F6-7BD69BAC790A}"/>
              </a:ext>
            </a:extLst>
          </p:cNvPr>
          <p:cNvSpPr txBox="1"/>
          <p:nvPr/>
        </p:nvSpPr>
        <p:spPr>
          <a:xfrm rot="18480000">
            <a:off x="9052906" y="25461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.5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D15D5ED9-6E77-4F82-8D01-D8031CBC2325}"/>
              </a:ext>
            </a:extLst>
          </p:cNvPr>
          <p:cNvSpPr txBox="1"/>
          <p:nvPr/>
        </p:nvSpPr>
        <p:spPr>
          <a:xfrm rot="18480000">
            <a:off x="9290843" y="254618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6.96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0045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49</Words>
  <Application>Microsoft Office PowerPoint</Application>
  <PresentationFormat>宽屏</PresentationFormat>
  <Paragraphs>3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20</cp:revision>
  <dcterms:created xsi:type="dcterms:W3CDTF">2020-02-20T13:07:01Z</dcterms:created>
  <dcterms:modified xsi:type="dcterms:W3CDTF">2020-10-23T06:01:08Z</dcterms:modified>
</cp:coreProperties>
</file>